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71" r:id="rId4"/>
    <p:sldId id="272" r:id="rId5"/>
    <p:sldId id="259" r:id="rId6"/>
    <p:sldId id="274" r:id="rId7"/>
    <p:sldId id="273" r:id="rId8"/>
    <p:sldId id="261" r:id="rId9"/>
    <p:sldId id="263" r:id="rId10"/>
    <p:sldId id="262" r:id="rId11"/>
    <p:sldId id="270" r:id="rId12"/>
    <p:sldId id="266" r:id="rId13"/>
    <p:sldId id="267" r:id="rId14"/>
    <p:sldId id="269" r:id="rId1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C81A2F4-3328-4D83-BD5F-FDA5D32D2C04}" v="40" dt="2022-07-14T00:52:58.460"/>
    <p1510:client id="{6050F4F3-FB9F-4BD8-A8A6-6AFA578451A9}" v="79" dt="2022-07-12T15:14:24.778"/>
    <p1510:client id="{8770E374-448F-42BE-B43A-6A4C4B03F662}" v="15" dt="2022-04-20T23:25:33.305"/>
    <p1510:client id="{AEFDD03A-3A01-4AF9-A2AF-A974CB6FDD81}" v="132" dt="2022-07-12T15:26:52.199"/>
    <p1510:client id="{B8D7DB5C-8C34-4607-84DF-E243E9FEC488}" v="22" dt="2022-07-15T19:57:50.976"/>
    <p1510:client id="{DEEDF2A9-24B5-4628-9F6C-CC0094D5F0C7}" v="1" dt="2022-07-15T19:21:31.530"/>
    <p1510:client id="{FCA4DE52-9AD1-4DA1-81B3-84F5CB901EC3}" v="44" dt="2022-07-12T15:31:08.43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8" autoAdjust="0"/>
    <p:restoredTop sz="94660"/>
  </p:normalViewPr>
  <p:slideViewPr>
    <p:cSldViewPr snapToGrid="0">
      <p:cViewPr varScale="1">
        <p:scale>
          <a:sx n="77" d="100"/>
          <a:sy n="77" d="100"/>
        </p:scale>
        <p:origin x="283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2" d="100"/>
        <a:sy n="102" d="100"/>
      </p:scale>
      <p:origin x="0" y="-211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orinne Linardic, M.D." userId="I32qLDVSfbowGounXRZTIrhDVT44J/lN53XBFKiLJBg=" providerId="None" clId="Web-{FCA4DE52-9AD1-4DA1-81B3-84F5CB901EC3}"/>
    <pc:docChg chg="modSld">
      <pc:chgData name="Corinne Linardic, M.D." userId="I32qLDVSfbowGounXRZTIrhDVT44J/lN53XBFKiLJBg=" providerId="None" clId="Web-{FCA4DE52-9AD1-4DA1-81B3-84F5CB901EC3}" dt="2022-07-12T15:31:08.434" v="30" actId="1076"/>
      <pc:docMkLst>
        <pc:docMk/>
      </pc:docMkLst>
      <pc:sldChg chg="addSp delSp modSp">
        <pc:chgData name="Corinne Linardic, M.D." userId="I32qLDVSfbowGounXRZTIrhDVT44J/lN53XBFKiLJBg=" providerId="None" clId="Web-{FCA4DE52-9AD1-4DA1-81B3-84F5CB901EC3}" dt="2022-07-12T15:31:08.434" v="30" actId="1076"/>
        <pc:sldMkLst>
          <pc:docMk/>
          <pc:sldMk cId="3911920316" sldId="261"/>
        </pc:sldMkLst>
        <pc:spChg chg="mod">
          <ac:chgData name="Corinne Linardic, M.D." userId="I32qLDVSfbowGounXRZTIrhDVT44J/lN53XBFKiLJBg=" providerId="None" clId="Web-{FCA4DE52-9AD1-4DA1-81B3-84F5CB901EC3}" dt="2022-07-12T15:30:30.136" v="22" actId="1076"/>
          <ac:spMkLst>
            <pc:docMk/>
            <pc:sldMk cId="3911920316" sldId="261"/>
            <ac:spMk id="2" creationId="{E61B7DBD-2429-16AF-C9B3-794305787B69}"/>
          </ac:spMkLst>
        </pc:spChg>
        <pc:spChg chg="del">
          <ac:chgData name="Corinne Linardic, M.D." userId="I32qLDVSfbowGounXRZTIrhDVT44J/lN53XBFKiLJBg=" providerId="None" clId="Web-{FCA4DE52-9AD1-4DA1-81B3-84F5CB901EC3}" dt="2022-07-12T15:29:19.992" v="10"/>
          <ac:spMkLst>
            <pc:docMk/>
            <pc:sldMk cId="3911920316" sldId="261"/>
            <ac:spMk id="5" creationId="{2F496BB4-EC6F-B92B-95C3-F51710627935}"/>
          </ac:spMkLst>
        </pc:spChg>
        <pc:spChg chg="del">
          <ac:chgData name="Corinne Linardic, M.D." userId="I32qLDVSfbowGounXRZTIrhDVT44J/lN53XBFKiLJBg=" providerId="None" clId="Web-{FCA4DE52-9AD1-4DA1-81B3-84F5CB901EC3}" dt="2022-07-12T15:29:21.602" v="11"/>
          <ac:spMkLst>
            <pc:docMk/>
            <pc:sldMk cId="3911920316" sldId="261"/>
            <ac:spMk id="10" creationId="{25806CE4-3194-AD61-F757-0AF0430A9F09}"/>
          </ac:spMkLst>
        </pc:spChg>
        <pc:spChg chg="del">
          <ac:chgData name="Corinne Linardic, M.D." userId="I32qLDVSfbowGounXRZTIrhDVT44J/lN53XBFKiLJBg=" providerId="None" clId="Web-{FCA4DE52-9AD1-4DA1-81B3-84F5CB901EC3}" dt="2022-07-12T15:29:25.919" v="13"/>
          <ac:spMkLst>
            <pc:docMk/>
            <pc:sldMk cId="3911920316" sldId="261"/>
            <ac:spMk id="21" creationId="{1658287A-74BD-3B48-ED22-CC8E6284C25E}"/>
          </ac:spMkLst>
        </pc:spChg>
        <pc:spChg chg="del">
          <ac:chgData name="Corinne Linardic, M.D." userId="I32qLDVSfbowGounXRZTIrhDVT44J/lN53XBFKiLJBg=" providerId="None" clId="Web-{FCA4DE52-9AD1-4DA1-81B3-84F5CB901EC3}" dt="2022-07-12T15:29:23.086" v="12"/>
          <ac:spMkLst>
            <pc:docMk/>
            <pc:sldMk cId="3911920316" sldId="261"/>
            <ac:spMk id="24" creationId="{7A55670A-E218-DF5C-DC1F-4F8AFC76D039}"/>
          </ac:spMkLst>
        </pc:spChg>
        <pc:spChg chg="add del mod">
          <ac:chgData name="Corinne Linardic, M.D." userId="I32qLDVSfbowGounXRZTIrhDVT44J/lN53XBFKiLJBg=" providerId="None" clId="Web-{FCA4DE52-9AD1-4DA1-81B3-84F5CB901EC3}" dt="2022-07-12T15:29:50.353" v="17"/>
          <ac:spMkLst>
            <pc:docMk/>
            <pc:sldMk cId="3911920316" sldId="261"/>
            <ac:spMk id="26" creationId="{AAA39F9A-9B9A-7552-2F45-9687061100B7}"/>
          </ac:spMkLst>
        </pc:spChg>
        <pc:spChg chg="add mod">
          <ac:chgData name="Corinne Linardic, M.D." userId="I32qLDVSfbowGounXRZTIrhDVT44J/lN53XBFKiLJBg=" providerId="None" clId="Web-{FCA4DE52-9AD1-4DA1-81B3-84F5CB901EC3}" dt="2022-07-12T15:30:02.650" v="19" actId="1076"/>
          <ac:spMkLst>
            <pc:docMk/>
            <pc:sldMk cId="3911920316" sldId="261"/>
            <ac:spMk id="36" creationId="{AE07C4AA-A682-EA41-045D-9431212A7ABC}"/>
          </ac:spMkLst>
        </pc:spChg>
        <pc:spChg chg="add mod">
          <ac:chgData name="Corinne Linardic, M.D." userId="I32qLDVSfbowGounXRZTIrhDVT44J/lN53XBFKiLJBg=" providerId="None" clId="Web-{FCA4DE52-9AD1-4DA1-81B3-84F5CB901EC3}" dt="2022-07-12T15:30:42.902" v="24" actId="1076"/>
          <ac:spMkLst>
            <pc:docMk/>
            <pc:sldMk cId="3911920316" sldId="261"/>
            <ac:spMk id="37" creationId="{721D09AB-94CE-F817-AD74-0631138DD7DF}"/>
          </ac:spMkLst>
        </pc:spChg>
        <pc:spChg chg="add mod">
          <ac:chgData name="Corinne Linardic, M.D." userId="I32qLDVSfbowGounXRZTIrhDVT44J/lN53XBFKiLJBg=" providerId="None" clId="Web-{FCA4DE52-9AD1-4DA1-81B3-84F5CB901EC3}" dt="2022-07-12T15:31:04.481" v="29" actId="1076"/>
          <ac:spMkLst>
            <pc:docMk/>
            <pc:sldMk cId="3911920316" sldId="261"/>
            <ac:spMk id="38" creationId="{5FF3E56F-E74D-B098-A465-003E1E1F59AD}"/>
          </ac:spMkLst>
        </pc:spChg>
        <pc:spChg chg="add mod">
          <ac:chgData name="Corinne Linardic, M.D." userId="I32qLDVSfbowGounXRZTIrhDVT44J/lN53XBFKiLJBg=" providerId="None" clId="Web-{FCA4DE52-9AD1-4DA1-81B3-84F5CB901EC3}" dt="2022-07-12T15:31:08.434" v="30" actId="1076"/>
          <ac:spMkLst>
            <pc:docMk/>
            <pc:sldMk cId="3911920316" sldId="261"/>
            <ac:spMk id="39" creationId="{A172E8DB-275C-CBED-8085-76C96C4D56AF}"/>
          </ac:spMkLst>
        </pc:spChg>
      </pc:sldChg>
    </pc:docChg>
  </pc:docChgLst>
  <pc:docChgLst>
    <pc:chgData name="Alexander Kovach" userId="VTFTRXdmMIYKkRr4zfYXcJwvTM5Utlho/75jE4iTudg=" providerId="None" clId="Web-{5C81A2F4-3328-4D83-BD5F-FDA5D32D2C04}"/>
    <pc:docChg chg="modSld">
      <pc:chgData name="Alexander Kovach" userId="VTFTRXdmMIYKkRr4zfYXcJwvTM5Utlho/75jE4iTudg=" providerId="None" clId="Web-{5C81A2F4-3328-4D83-BD5F-FDA5D32D2C04}" dt="2022-07-14T00:52:58.460" v="37" actId="1076"/>
      <pc:docMkLst>
        <pc:docMk/>
      </pc:docMkLst>
      <pc:sldChg chg="addSp delSp modSp">
        <pc:chgData name="Alexander Kovach" userId="VTFTRXdmMIYKkRr4zfYXcJwvTM5Utlho/75jE4iTudg=" providerId="None" clId="Web-{5C81A2F4-3328-4D83-BD5F-FDA5D32D2C04}" dt="2022-07-14T00:52:58.460" v="37" actId="1076"/>
        <pc:sldMkLst>
          <pc:docMk/>
          <pc:sldMk cId="410240037" sldId="259"/>
        </pc:sldMkLst>
        <pc:spChg chg="add">
          <ac:chgData name="Alexander Kovach" userId="VTFTRXdmMIYKkRr4zfYXcJwvTM5Utlho/75jE4iTudg=" providerId="None" clId="Web-{5C81A2F4-3328-4D83-BD5F-FDA5D32D2C04}" dt="2022-07-14T00:49:42.050" v="17"/>
          <ac:spMkLst>
            <pc:docMk/>
            <pc:sldMk cId="410240037" sldId="259"/>
            <ac:spMk id="6" creationId="{A3208AE3-93FB-C504-4C52-C21155063065}"/>
          </ac:spMkLst>
        </pc:spChg>
        <pc:grpChg chg="del">
          <ac:chgData name="Alexander Kovach" userId="VTFTRXdmMIYKkRr4zfYXcJwvTM5Utlho/75jE4iTudg=" providerId="None" clId="Web-{5C81A2F4-3328-4D83-BD5F-FDA5D32D2C04}" dt="2022-07-14T00:40:15.326" v="4"/>
          <ac:grpSpMkLst>
            <pc:docMk/>
            <pc:sldMk cId="410240037" sldId="259"/>
            <ac:grpSpMk id="48" creationId="{00000000-0000-0000-0000-000000000000}"/>
          </ac:grpSpMkLst>
        </pc:grpChg>
        <pc:picChg chg="add mod modCrop">
          <ac:chgData name="Alexander Kovach" userId="VTFTRXdmMIYKkRr4zfYXcJwvTM5Utlho/75jE4iTudg=" providerId="None" clId="Web-{5C81A2F4-3328-4D83-BD5F-FDA5D32D2C04}" dt="2022-07-14T00:51:44.162" v="23" actId="1076"/>
          <ac:picMkLst>
            <pc:docMk/>
            <pc:sldMk cId="410240037" sldId="259"/>
            <ac:picMk id="3" creationId="{2585D276-9ED8-242D-B54D-E34F00FB1C59}"/>
          </ac:picMkLst>
        </pc:picChg>
        <pc:picChg chg="add mod modCrop">
          <ac:chgData name="Alexander Kovach" userId="VTFTRXdmMIYKkRr4zfYXcJwvTM5Utlho/75jE4iTudg=" providerId="None" clId="Web-{5C81A2F4-3328-4D83-BD5F-FDA5D32D2C04}" dt="2022-07-14T00:52:58.460" v="37" actId="1076"/>
          <ac:picMkLst>
            <pc:docMk/>
            <pc:sldMk cId="410240037" sldId="259"/>
            <ac:picMk id="5" creationId="{1CDF0F93-BA39-6CBB-490A-612B44F2A620}"/>
          </ac:picMkLst>
        </pc:picChg>
        <pc:picChg chg="del">
          <ac:chgData name="Alexander Kovach" userId="VTFTRXdmMIYKkRr4zfYXcJwvTM5Utlho/75jE4iTudg=" providerId="None" clId="Web-{5C81A2F4-3328-4D83-BD5F-FDA5D32D2C04}" dt="2022-07-14T00:40:15.326" v="4"/>
          <ac:picMkLst>
            <pc:docMk/>
            <pc:sldMk cId="410240037" sldId="259"/>
            <ac:picMk id="51" creationId="{00000000-0000-0000-0000-000000000000}"/>
          </ac:picMkLst>
        </pc:picChg>
        <pc:picChg chg="del">
          <ac:chgData name="Alexander Kovach" userId="VTFTRXdmMIYKkRr4zfYXcJwvTM5Utlho/75jE4iTudg=" providerId="None" clId="Web-{5C81A2F4-3328-4D83-BD5F-FDA5D32D2C04}" dt="2022-07-14T00:40:19.733" v="5"/>
          <ac:picMkLst>
            <pc:docMk/>
            <pc:sldMk cId="410240037" sldId="259"/>
            <ac:picMk id="52" creationId="{00000000-0000-0000-0000-000000000000}"/>
          </ac:picMkLst>
        </pc:picChg>
      </pc:sldChg>
    </pc:docChg>
  </pc:docChgLst>
  <pc:docChgLst>
    <pc:chgData name="Corinne Linardic, M.D." userId="I32qLDVSfbowGounXRZTIrhDVT44J/lN53XBFKiLJBg=" providerId="None" clId="Web-{B8D7DB5C-8C34-4607-84DF-E243E9FEC488}"/>
    <pc:docChg chg="modSld">
      <pc:chgData name="Corinne Linardic, M.D." userId="I32qLDVSfbowGounXRZTIrhDVT44J/lN53XBFKiLJBg=" providerId="None" clId="Web-{B8D7DB5C-8C34-4607-84DF-E243E9FEC488}" dt="2022-07-15T19:57:50.976" v="10" actId="14100"/>
      <pc:docMkLst>
        <pc:docMk/>
      </pc:docMkLst>
      <pc:sldChg chg="modSp">
        <pc:chgData name="Corinne Linardic, M.D." userId="I32qLDVSfbowGounXRZTIrhDVT44J/lN53XBFKiLJBg=" providerId="None" clId="Web-{B8D7DB5C-8C34-4607-84DF-E243E9FEC488}" dt="2022-07-15T19:56:43.646" v="2" actId="20577"/>
        <pc:sldMkLst>
          <pc:docMk/>
          <pc:sldMk cId="3035447811" sldId="257"/>
        </pc:sldMkLst>
        <pc:spChg chg="mod">
          <ac:chgData name="Corinne Linardic, M.D." userId="I32qLDVSfbowGounXRZTIrhDVT44J/lN53XBFKiLJBg=" providerId="None" clId="Web-{B8D7DB5C-8C34-4607-84DF-E243E9FEC488}" dt="2022-07-15T19:56:43.646" v="2" actId="20577"/>
          <ac:spMkLst>
            <pc:docMk/>
            <pc:sldMk cId="3035447811" sldId="257"/>
            <ac:spMk id="10" creationId="{00000000-0000-0000-0000-000000000000}"/>
          </ac:spMkLst>
        </pc:spChg>
      </pc:sldChg>
      <pc:sldChg chg="modSp">
        <pc:chgData name="Corinne Linardic, M.D." userId="I32qLDVSfbowGounXRZTIrhDVT44J/lN53XBFKiLJBg=" providerId="None" clId="Web-{B8D7DB5C-8C34-4607-84DF-E243E9FEC488}" dt="2022-07-15T19:57:50.976" v="10" actId="14100"/>
        <pc:sldMkLst>
          <pc:docMk/>
          <pc:sldMk cId="2425926250" sldId="263"/>
        </pc:sldMkLst>
        <pc:spChg chg="mod">
          <ac:chgData name="Corinne Linardic, M.D." userId="I32qLDVSfbowGounXRZTIrhDVT44J/lN53XBFKiLJBg=" providerId="None" clId="Web-{B8D7DB5C-8C34-4607-84DF-E243E9FEC488}" dt="2022-07-15T19:57:50.976" v="10" actId="14100"/>
          <ac:spMkLst>
            <pc:docMk/>
            <pc:sldMk cId="2425926250" sldId="263"/>
            <ac:spMk id="14" creationId="{00000000-0000-0000-0000-000000000000}"/>
          </ac:spMkLst>
        </pc:spChg>
      </pc:sldChg>
      <pc:sldChg chg="modSp">
        <pc:chgData name="Corinne Linardic, M.D." userId="I32qLDVSfbowGounXRZTIrhDVT44J/lN53XBFKiLJBg=" providerId="None" clId="Web-{B8D7DB5C-8C34-4607-84DF-E243E9FEC488}" dt="2022-07-15T19:57:02.787" v="7" actId="20577"/>
        <pc:sldMkLst>
          <pc:docMk/>
          <pc:sldMk cId="1634878941" sldId="271"/>
        </pc:sldMkLst>
        <pc:spChg chg="mod">
          <ac:chgData name="Corinne Linardic, M.D." userId="I32qLDVSfbowGounXRZTIrhDVT44J/lN53XBFKiLJBg=" providerId="None" clId="Web-{B8D7DB5C-8C34-4607-84DF-E243E9FEC488}" dt="2022-07-15T19:57:02.787" v="7" actId="20577"/>
          <ac:spMkLst>
            <pc:docMk/>
            <pc:sldMk cId="1634878941" sldId="271"/>
            <ac:spMk id="4" creationId="{EDC80B1A-9DE6-CF92-4BF0-A6FDED2769F8}"/>
          </ac:spMkLst>
        </pc:spChg>
      </pc:sldChg>
      <pc:sldChg chg="modSp">
        <pc:chgData name="Corinne Linardic, M.D." userId="I32qLDVSfbowGounXRZTIrhDVT44J/lN53XBFKiLJBg=" providerId="None" clId="Web-{B8D7DB5C-8C34-4607-84DF-E243E9FEC488}" dt="2022-07-15T19:57:18.600" v="8" actId="20577"/>
        <pc:sldMkLst>
          <pc:docMk/>
          <pc:sldMk cId="2243828839" sldId="272"/>
        </pc:sldMkLst>
        <pc:spChg chg="mod">
          <ac:chgData name="Corinne Linardic, M.D." userId="I32qLDVSfbowGounXRZTIrhDVT44J/lN53XBFKiLJBg=" providerId="None" clId="Web-{B8D7DB5C-8C34-4607-84DF-E243E9FEC488}" dt="2022-07-15T19:57:18.600" v="8" actId="20577"/>
          <ac:spMkLst>
            <pc:docMk/>
            <pc:sldMk cId="2243828839" sldId="272"/>
            <ac:spMk id="56" creationId="{48B1222C-A5C2-9736-8E27-FACA1B69BFC2}"/>
          </ac:spMkLst>
        </pc:spChg>
      </pc:sldChg>
    </pc:docChg>
  </pc:docChgLst>
  <pc:docChgLst>
    <pc:chgData name="Corinne Linardic, M.D." userId="I32qLDVSfbowGounXRZTIrhDVT44J/lN53XBFKiLJBg=" providerId="None" clId="Web-{6050F4F3-FB9F-4BD8-A8A6-6AFA578451A9}"/>
    <pc:docChg chg="modSld sldOrd">
      <pc:chgData name="Corinne Linardic, M.D." userId="I32qLDVSfbowGounXRZTIrhDVT44J/lN53XBFKiLJBg=" providerId="None" clId="Web-{6050F4F3-FB9F-4BD8-A8A6-6AFA578451A9}" dt="2022-07-12T15:14:24.465" v="32" actId="20577"/>
      <pc:docMkLst>
        <pc:docMk/>
      </pc:docMkLst>
      <pc:sldChg chg="modSp">
        <pc:chgData name="Corinne Linardic, M.D." userId="I32qLDVSfbowGounXRZTIrhDVT44J/lN53XBFKiLJBg=" providerId="None" clId="Web-{6050F4F3-FB9F-4BD8-A8A6-6AFA578451A9}" dt="2022-07-12T15:09:09.449" v="5" actId="20577"/>
        <pc:sldMkLst>
          <pc:docMk/>
          <pc:sldMk cId="410240037" sldId="259"/>
        </pc:sldMkLst>
        <pc:spChg chg="mod">
          <ac:chgData name="Corinne Linardic, M.D." userId="I32qLDVSfbowGounXRZTIrhDVT44J/lN53XBFKiLJBg=" providerId="None" clId="Web-{6050F4F3-FB9F-4BD8-A8A6-6AFA578451A9}" dt="2022-07-12T15:09:09.449" v="5" actId="20577"/>
          <ac:spMkLst>
            <pc:docMk/>
            <pc:sldMk cId="410240037" sldId="259"/>
            <ac:spMk id="11" creationId="{00000000-0000-0000-0000-000000000000}"/>
          </ac:spMkLst>
        </pc:spChg>
      </pc:sldChg>
      <pc:sldChg chg="modSp">
        <pc:chgData name="Corinne Linardic, M.D." userId="I32qLDVSfbowGounXRZTIrhDVT44J/lN53XBFKiLJBg=" providerId="None" clId="Web-{6050F4F3-FB9F-4BD8-A8A6-6AFA578451A9}" dt="2022-07-12T15:11:02.252" v="19" actId="20577"/>
        <pc:sldMkLst>
          <pc:docMk/>
          <pc:sldMk cId="3911920316" sldId="261"/>
        </pc:sldMkLst>
        <pc:spChg chg="mod">
          <ac:chgData name="Corinne Linardic, M.D." userId="I32qLDVSfbowGounXRZTIrhDVT44J/lN53XBFKiLJBg=" providerId="None" clId="Web-{6050F4F3-FB9F-4BD8-A8A6-6AFA578451A9}" dt="2022-07-12T15:11:02.252" v="19" actId="20577"/>
          <ac:spMkLst>
            <pc:docMk/>
            <pc:sldMk cId="3911920316" sldId="261"/>
            <ac:spMk id="4" creationId="{00000000-0000-0000-0000-000000000000}"/>
          </ac:spMkLst>
        </pc:spChg>
      </pc:sldChg>
      <pc:sldChg chg="modSp">
        <pc:chgData name="Corinne Linardic, M.D." userId="I32qLDVSfbowGounXRZTIrhDVT44J/lN53XBFKiLJBg=" providerId="None" clId="Web-{6050F4F3-FB9F-4BD8-A8A6-6AFA578451A9}" dt="2022-07-12T15:11:26.894" v="21" actId="20577"/>
        <pc:sldMkLst>
          <pc:docMk/>
          <pc:sldMk cId="3030908086" sldId="262"/>
        </pc:sldMkLst>
        <pc:spChg chg="mod">
          <ac:chgData name="Corinne Linardic, M.D." userId="I32qLDVSfbowGounXRZTIrhDVT44J/lN53XBFKiLJBg=" providerId="None" clId="Web-{6050F4F3-FB9F-4BD8-A8A6-6AFA578451A9}" dt="2022-07-12T15:11:26.894" v="21" actId="20577"/>
          <ac:spMkLst>
            <pc:docMk/>
            <pc:sldMk cId="3030908086" sldId="262"/>
            <ac:spMk id="36" creationId="{00000000-0000-0000-0000-000000000000}"/>
          </ac:spMkLst>
        </pc:spChg>
      </pc:sldChg>
      <pc:sldChg chg="modSp ord">
        <pc:chgData name="Corinne Linardic, M.D." userId="I32qLDVSfbowGounXRZTIrhDVT44J/lN53XBFKiLJBg=" providerId="None" clId="Web-{6050F4F3-FB9F-4BD8-A8A6-6AFA578451A9}" dt="2022-07-12T15:11:35.753" v="22"/>
        <pc:sldMkLst>
          <pc:docMk/>
          <pc:sldMk cId="2425926250" sldId="263"/>
        </pc:sldMkLst>
        <pc:spChg chg="mod">
          <ac:chgData name="Corinne Linardic, M.D." userId="I32qLDVSfbowGounXRZTIrhDVT44J/lN53XBFKiLJBg=" providerId="None" clId="Web-{6050F4F3-FB9F-4BD8-A8A6-6AFA578451A9}" dt="2022-07-12T15:11:14.971" v="20" actId="20577"/>
          <ac:spMkLst>
            <pc:docMk/>
            <pc:sldMk cId="2425926250" sldId="263"/>
            <ac:spMk id="14" creationId="{00000000-0000-0000-0000-000000000000}"/>
          </ac:spMkLst>
        </pc:spChg>
      </pc:sldChg>
      <pc:sldChg chg="modSp">
        <pc:chgData name="Corinne Linardic, M.D." userId="I32qLDVSfbowGounXRZTIrhDVT44J/lN53XBFKiLJBg=" providerId="None" clId="Web-{6050F4F3-FB9F-4BD8-A8A6-6AFA578451A9}" dt="2022-07-12T15:11:55.551" v="26" actId="20577"/>
        <pc:sldMkLst>
          <pc:docMk/>
          <pc:sldMk cId="1675237186" sldId="266"/>
        </pc:sldMkLst>
        <pc:spChg chg="mod">
          <ac:chgData name="Corinne Linardic, M.D." userId="I32qLDVSfbowGounXRZTIrhDVT44J/lN53XBFKiLJBg=" providerId="None" clId="Web-{6050F4F3-FB9F-4BD8-A8A6-6AFA578451A9}" dt="2022-07-12T15:11:55.551" v="26" actId="20577"/>
          <ac:spMkLst>
            <pc:docMk/>
            <pc:sldMk cId="1675237186" sldId="266"/>
            <ac:spMk id="7" creationId="{00000000-0000-0000-0000-000000000000}"/>
          </ac:spMkLst>
        </pc:spChg>
      </pc:sldChg>
      <pc:sldChg chg="modSp">
        <pc:chgData name="Corinne Linardic, M.D." userId="I32qLDVSfbowGounXRZTIrhDVT44J/lN53XBFKiLJBg=" providerId="None" clId="Web-{6050F4F3-FB9F-4BD8-A8A6-6AFA578451A9}" dt="2022-07-12T15:12:03.708" v="28" actId="20577"/>
        <pc:sldMkLst>
          <pc:docMk/>
          <pc:sldMk cId="30704066" sldId="267"/>
        </pc:sldMkLst>
        <pc:spChg chg="mod">
          <ac:chgData name="Corinne Linardic, M.D." userId="I32qLDVSfbowGounXRZTIrhDVT44J/lN53XBFKiLJBg=" providerId="None" clId="Web-{6050F4F3-FB9F-4BD8-A8A6-6AFA578451A9}" dt="2022-07-12T15:12:03.708" v="28" actId="20577"/>
          <ac:spMkLst>
            <pc:docMk/>
            <pc:sldMk cId="30704066" sldId="267"/>
            <ac:spMk id="8" creationId="{00000000-0000-0000-0000-000000000000}"/>
          </ac:spMkLst>
        </pc:spChg>
      </pc:sldChg>
      <pc:sldChg chg="modSp">
        <pc:chgData name="Corinne Linardic, M.D." userId="I32qLDVSfbowGounXRZTIrhDVT44J/lN53XBFKiLJBg=" providerId="None" clId="Web-{6050F4F3-FB9F-4BD8-A8A6-6AFA578451A9}" dt="2022-07-12T15:12:11.146" v="30" actId="20577"/>
        <pc:sldMkLst>
          <pc:docMk/>
          <pc:sldMk cId="590186897" sldId="269"/>
        </pc:sldMkLst>
        <pc:spChg chg="mod">
          <ac:chgData name="Corinne Linardic, M.D." userId="I32qLDVSfbowGounXRZTIrhDVT44J/lN53XBFKiLJBg=" providerId="None" clId="Web-{6050F4F3-FB9F-4BD8-A8A6-6AFA578451A9}" dt="2022-07-12T15:12:11.146" v="30" actId="20577"/>
          <ac:spMkLst>
            <pc:docMk/>
            <pc:sldMk cId="590186897" sldId="269"/>
            <ac:spMk id="8" creationId="{00000000-0000-0000-0000-000000000000}"/>
          </ac:spMkLst>
        </pc:spChg>
      </pc:sldChg>
      <pc:sldChg chg="modSp">
        <pc:chgData name="Corinne Linardic, M.D." userId="I32qLDVSfbowGounXRZTIrhDVT44J/lN53XBFKiLJBg=" providerId="None" clId="Web-{6050F4F3-FB9F-4BD8-A8A6-6AFA578451A9}" dt="2022-07-12T15:11:47.613" v="24" actId="20577"/>
        <pc:sldMkLst>
          <pc:docMk/>
          <pc:sldMk cId="1535432467" sldId="270"/>
        </pc:sldMkLst>
        <pc:spChg chg="mod">
          <ac:chgData name="Corinne Linardic, M.D." userId="I32qLDVSfbowGounXRZTIrhDVT44J/lN53XBFKiLJBg=" providerId="None" clId="Web-{6050F4F3-FB9F-4BD8-A8A6-6AFA578451A9}" dt="2022-07-12T15:11:47.613" v="24" actId="20577"/>
          <ac:spMkLst>
            <pc:docMk/>
            <pc:sldMk cId="1535432467" sldId="270"/>
            <ac:spMk id="46" creationId="{00000000-0000-0000-0000-000000000000}"/>
          </ac:spMkLst>
        </pc:spChg>
      </pc:sldChg>
      <pc:sldChg chg="modSp ord">
        <pc:chgData name="Corinne Linardic, M.D." userId="I32qLDVSfbowGounXRZTIrhDVT44J/lN53XBFKiLJBg=" providerId="None" clId="Web-{6050F4F3-FB9F-4BD8-A8A6-6AFA578451A9}" dt="2022-07-12T15:08:13.665" v="1"/>
        <pc:sldMkLst>
          <pc:docMk/>
          <pc:sldMk cId="1634878941" sldId="271"/>
        </pc:sldMkLst>
        <pc:spChg chg="mod">
          <ac:chgData name="Corinne Linardic, M.D." userId="I32qLDVSfbowGounXRZTIrhDVT44J/lN53XBFKiLJBg=" providerId="None" clId="Web-{6050F4F3-FB9F-4BD8-A8A6-6AFA578451A9}" dt="2022-07-12T15:08:03.711" v="0" actId="20577"/>
          <ac:spMkLst>
            <pc:docMk/>
            <pc:sldMk cId="1634878941" sldId="271"/>
            <ac:spMk id="4" creationId="{EDC80B1A-9DE6-CF92-4BF0-A6FDED2769F8}"/>
          </ac:spMkLst>
        </pc:spChg>
      </pc:sldChg>
      <pc:sldChg chg="modSp ord">
        <pc:chgData name="Corinne Linardic, M.D." userId="I32qLDVSfbowGounXRZTIrhDVT44J/lN53XBFKiLJBg=" providerId="None" clId="Web-{6050F4F3-FB9F-4BD8-A8A6-6AFA578451A9}" dt="2022-07-12T15:08:48.354" v="4"/>
        <pc:sldMkLst>
          <pc:docMk/>
          <pc:sldMk cId="2243828839" sldId="272"/>
        </pc:sldMkLst>
        <pc:spChg chg="mod">
          <ac:chgData name="Corinne Linardic, M.D." userId="I32qLDVSfbowGounXRZTIrhDVT44J/lN53XBFKiLJBg=" providerId="None" clId="Web-{6050F4F3-FB9F-4BD8-A8A6-6AFA578451A9}" dt="2022-07-12T15:08:40.854" v="3" actId="20577"/>
          <ac:spMkLst>
            <pc:docMk/>
            <pc:sldMk cId="2243828839" sldId="272"/>
            <ac:spMk id="56" creationId="{48B1222C-A5C2-9736-8E27-FACA1B69BFC2}"/>
          </ac:spMkLst>
        </pc:spChg>
      </pc:sldChg>
      <pc:sldChg chg="modSp ord">
        <pc:chgData name="Corinne Linardic, M.D." userId="I32qLDVSfbowGounXRZTIrhDVT44J/lN53XBFKiLJBg=" providerId="None" clId="Web-{6050F4F3-FB9F-4BD8-A8A6-6AFA578451A9}" dt="2022-07-12T15:10:47.282" v="18"/>
        <pc:sldMkLst>
          <pc:docMk/>
          <pc:sldMk cId="1284014268" sldId="273"/>
        </pc:sldMkLst>
        <pc:spChg chg="mod">
          <ac:chgData name="Corinne Linardic, M.D." userId="I32qLDVSfbowGounXRZTIrhDVT44J/lN53XBFKiLJBg=" providerId="None" clId="Web-{6050F4F3-FB9F-4BD8-A8A6-6AFA578451A9}" dt="2022-07-12T15:10:25.984" v="13" actId="20577"/>
          <ac:spMkLst>
            <pc:docMk/>
            <pc:sldMk cId="1284014268" sldId="273"/>
            <ac:spMk id="4" creationId="{CE88B667-89CD-D012-2EB9-7A3C35015829}"/>
          </ac:spMkLst>
        </pc:spChg>
      </pc:sldChg>
      <pc:sldChg chg="modSp ord">
        <pc:chgData name="Corinne Linardic, M.D." userId="I32qLDVSfbowGounXRZTIrhDVT44J/lN53XBFKiLJBg=" providerId="None" clId="Web-{6050F4F3-FB9F-4BD8-A8A6-6AFA578451A9}" dt="2022-07-12T15:14:24.465" v="32" actId="20577"/>
        <pc:sldMkLst>
          <pc:docMk/>
          <pc:sldMk cId="3040143614" sldId="274"/>
        </pc:sldMkLst>
        <pc:spChg chg="mod">
          <ac:chgData name="Corinne Linardic, M.D." userId="I32qLDVSfbowGounXRZTIrhDVT44J/lN53XBFKiLJBg=" providerId="None" clId="Web-{6050F4F3-FB9F-4BD8-A8A6-6AFA578451A9}" dt="2022-07-12T15:14:24.465" v="32" actId="20577"/>
          <ac:spMkLst>
            <pc:docMk/>
            <pc:sldMk cId="3040143614" sldId="274"/>
            <ac:spMk id="39" creationId="{0BEE768D-0DF5-11B6-4208-9B9E0D4E4E91}"/>
          </ac:spMkLst>
        </pc:spChg>
      </pc:sldChg>
    </pc:docChg>
  </pc:docChgLst>
  <pc:docChgLst>
    <pc:chgData name="Corinne Linardic, M.D." userId="I32qLDVSfbowGounXRZTIrhDVT44J/lN53XBFKiLJBg=" providerId="None" clId="Web-{DEEDF2A9-24B5-4628-9F6C-CC0094D5F0C7}"/>
    <pc:docChg chg="modSld">
      <pc:chgData name="Corinne Linardic, M.D." userId="I32qLDVSfbowGounXRZTIrhDVT44J/lN53XBFKiLJBg=" providerId="None" clId="Web-{DEEDF2A9-24B5-4628-9F6C-CC0094D5F0C7}" dt="2022-07-15T19:21:31.530" v="0"/>
      <pc:docMkLst>
        <pc:docMk/>
      </pc:docMkLst>
      <pc:sldChg chg="delSp">
        <pc:chgData name="Corinne Linardic, M.D." userId="I32qLDVSfbowGounXRZTIrhDVT44J/lN53XBFKiLJBg=" providerId="None" clId="Web-{DEEDF2A9-24B5-4628-9F6C-CC0094D5F0C7}" dt="2022-07-15T19:21:31.530" v="0"/>
        <pc:sldMkLst>
          <pc:docMk/>
          <pc:sldMk cId="410240037" sldId="259"/>
        </pc:sldMkLst>
        <pc:spChg chg="del">
          <ac:chgData name="Corinne Linardic, M.D." userId="I32qLDVSfbowGounXRZTIrhDVT44J/lN53XBFKiLJBg=" providerId="None" clId="Web-{DEEDF2A9-24B5-4628-9F6C-CC0094D5F0C7}" dt="2022-07-15T19:21:31.530" v="0"/>
          <ac:spMkLst>
            <pc:docMk/>
            <pc:sldMk cId="410240037" sldId="259"/>
            <ac:spMk id="6" creationId="{A3208AE3-93FB-C504-4C52-C21155063065}"/>
          </ac:spMkLst>
        </pc:spChg>
      </pc:sldChg>
    </pc:docChg>
  </pc:docChgLst>
  <pc:docChgLst>
    <pc:chgData name="Alexander Kovach" userId="VTFTRXdmMIYKkRr4zfYXcJwvTM5Utlho/75jE4iTudg=" providerId="None" clId="Web-{8770E374-448F-42BE-B43A-6A4C4B03F662}"/>
    <pc:docChg chg="modSld">
      <pc:chgData name="Alexander Kovach" userId="VTFTRXdmMIYKkRr4zfYXcJwvTM5Utlho/75jE4iTudg=" providerId="None" clId="Web-{8770E374-448F-42BE-B43A-6A4C4B03F662}" dt="2022-04-20T23:25:33.305" v="14" actId="1076"/>
      <pc:docMkLst>
        <pc:docMk/>
      </pc:docMkLst>
      <pc:sldChg chg="addSp delSp modSp">
        <pc:chgData name="Alexander Kovach" userId="VTFTRXdmMIYKkRr4zfYXcJwvTM5Utlho/75jE4iTudg=" providerId="None" clId="Web-{8770E374-448F-42BE-B43A-6A4C4B03F662}" dt="2022-04-20T23:25:33.305" v="14" actId="1076"/>
        <pc:sldMkLst>
          <pc:docMk/>
          <pc:sldMk cId="410240037" sldId="259"/>
        </pc:sldMkLst>
        <pc:spChg chg="add del">
          <ac:chgData name="Alexander Kovach" userId="VTFTRXdmMIYKkRr4zfYXcJwvTM5Utlho/75jE4iTudg=" providerId="None" clId="Web-{8770E374-448F-42BE-B43A-6A4C4B03F662}" dt="2022-04-20T23:24:40.709" v="1"/>
          <ac:spMkLst>
            <pc:docMk/>
            <pc:sldMk cId="410240037" sldId="259"/>
            <ac:spMk id="79" creationId="{B50AA11B-41BF-7BF3-5405-073564F47064}"/>
          </ac:spMkLst>
        </pc:spChg>
        <pc:spChg chg="add mod">
          <ac:chgData name="Alexander Kovach" userId="VTFTRXdmMIYKkRr4zfYXcJwvTM5Utlho/75jE4iTudg=" providerId="None" clId="Web-{8770E374-448F-42BE-B43A-6A4C4B03F662}" dt="2022-04-20T23:25:17.601" v="6" actId="1076"/>
          <ac:spMkLst>
            <pc:docMk/>
            <pc:sldMk cId="410240037" sldId="259"/>
            <ac:spMk id="81" creationId="{A0A3E0CE-E7BA-2026-58D9-54CB732620F2}"/>
          </ac:spMkLst>
        </pc:spChg>
        <pc:spChg chg="add mod">
          <ac:chgData name="Alexander Kovach" userId="VTFTRXdmMIYKkRr4zfYXcJwvTM5Utlho/75jE4iTudg=" providerId="None" clId="Web-{8770E374-448F-42BE-B43A-6A4C4B03F662}" dt="2022-04-20T23:25:26.601" v="10" actId="1076"/>
          <ac:spMkLst>
            <pc:docMk/>
            <pc:sldMk cId="410240037" sldId="259"/>
            <ac:spMk id="83" creationId="{4376C3AF-B250-C987-A757-9C2679507F5A}"/>
          </ac:spMkLst>
        </pc:spChg>
        <pc:spChg chg="add mod">
          <ac:chgData name="Alexander Kovach" userId="VTFTRXdmMIYKkRr4zfYXcJwvTM5Utlho/75jE4iTudg=" providerId="None" clId="Web-{8770E374-448F-42BE-B43A-6A4C4B03F662}" dt="2022-04-20T23:25:33.305" v="14" actId="1076"/>
          <ac:spMkLst>
            <pc:docMk/>
            <pc:sldMk cId="410240037" sldId="259"/>
            <ac:spMk id="85" creationId="{25D7925A-A4E0-8CEB-22A5-096D6027DC70}"/>
          </ac:spMkLst>
        </pc:spChg>
        <pc:cxnChg chg="add mod">
          <ac:chgData name="Alexander Kovach" userId="VTFTRXdmMIYKkRr4zfYXcJwvTM5Utlho/75jE4iTudg=" providerId="None" clId="Web-{8770E374-448F-42BE-B43A-6A4C4B03F662}" dt="2022-04-20T23:25:17.585" v="5" actId="1076"/>
          <ac:cxnSpMkLst>
            <pc:docMk/>
            <pc:sldMk cId="410240037" sldId="259"/>
            <ac:cxnSpMk id="80" creationId="{1955C4B2-5889-6236-DC09-E0B9997F1A57}"/>
          </ac:cxnSpMkLst>
        </pc:cxnChg>
        <pc:cxnChg chg="add mod">
          <ac:chgData name="Alexander Kovach" userId="VTFTRXdmMIYKkRr4zfYXcJwvTM5Utlho/75jE4iTudg=" providerId="None" clId="Web-{8770E374-448F-42BE-B43A-6A4C4B03F662}" dt="2022-04-20T23:25:26.586" v="9" actId="1076"/>
          <ac:cxnSpMkLst>
            <pc:docMk/>
            <pc:sldMk cId="410240037" sldId="259"/>
            <ac:cxnSpMk id="82" creationId="{E1490271-4C24-C3EF-9AF9-0C4864195A93}"/>
          </ac:cxnSpMkLst>
        </pc:cxnChg>
        <pc:cxnChg chg="add mod">
          <ac:chgData name="Alexander Kovach" userId="VTFTRXdmMIYKkRr4zfYXcJwvTM5Utlho/75jE4iTudg=" providerId="None" clId="Web-{8770E374-448F-42BE-B43A-6A4C4B03F662}" dt="2022-04-20T23:25:33.289" v="13" actId="1076"/>
          <ac:cxnSpMkLst>
            <pc:docMk/>
            <pc:sldMk cId="410240037" sldId="259"/>
            <ac:cxnSpMk id="84" creationId="{681D504F-5808-A0AC-5FCB-5FFFF1971E68}"/>
          </ac:cxnSpMkLst>
        </pc:cxnChg>
      </pc:sldChg>
    </pc:docChg>
  </pc:docChgLst>
  <pc:docChgLst>
    <pc:chgData name="Corinne Linardic, M.D." userId="I32qLDVSfbowGounXRZTIrhDVT44J/lN53XBFKiLJBg=" providerId="None" clId="Web-{AEFDD03A-3A01-4AF9-A2AF-A974CB6FDD81}"/>
    <pc:docChg chg="modSld">
      <pc:chgData name="Corinne Linardic, M.D." userId="I32qLDVSfbowGounXRZTIrhDVT44J/lN53XBFKiLJBg=" providerId="None" clId="Web-{AEFDD03A-3A01-4AF9-A2AF-A974CB6FDD81}" dt="2022-07-12T15:26:51.870" v="72" actId="20577"/>
      <pc:docMkLst>
        <pc:docMk/>
      </pc:docMkLst>
      <pc:sldChg chg="addSp delSp modSp">
        <pc:chgData name="Corinne Linardic, M.D." userId="I32qLDVSfbowGounXRZTIrhDVT44J/lN53XBFKiLJBg=" providerId="None" clId="Web-{AEFDD03A-3A01-4AF9-A2AF-A974CB6FDD81}" dt="2022-07-12T15:26:51.870" v="72" actId="20577"/>
        <pc:sldMkLst>
          <pc:docMk/>
          <pc:sldMk cId="3911920316" sldId="261"/>
        </pc:sldMkLst>
        <pc:spChg chg="add mod">
          <ac:chgData name="Corinne Linardic, M.D." userId="I32qLDVSfbowGounXRZTIrhDVT44J/lN53XBFKiLJBg=" providerId="None" clId="Web-{AEFDD03A-3A01-4AF9-A2AF-A974CB6FDD81}" dt="2022-07-12T15:26:43.120" v="68" actId="20577"/>
          <ac:spMkLst>
            <pc:docMk/>
            <pc:sldMk cId="3911920316" sldId="261"/>
            <ac:spMk id="2" creationId="{E61B7DBD-2429-16AF-C9B3-794305787B69}"/>
          </ac:spMkLst>
        </pc:spChg>
        <pc:spChg chg="add mod">
          <ac:chgData name="Corinne Linardic, M.D." userId="I32qLDVSfbowGounXRZTIrhDVT44J/lN53XBFKiLJBg=" providerId="None" clId="Web-{AEFDD03A-3A01-4AF9-A2AF-A974CB6FDD81}" dt="2022-07-12T15:26:45.542" v="69" actId="20577"/>
          <ac:spMkLst>
            <pc:docMk/>
            <pc:sldMk cId="3911920316" sldId="261"/>
            <ac:spMk id="5" creationId="{2F496BB4-EC6F-B92B-95C3-F51710627935}"/>
          </ac:spMkLst>
        </pc:spChg>
        <pc:spChg chg="add mod">
          <ac:chgData name="Corinne Linardic, M.D." userId="I32qLDVSfbowGounXRZTIrhDVT44J/lN53XBFKiLJBg=" providerId="None" clId="Web-{AEFDD03A-3A01-4AF9-A2AF-A974CB6FDD81}" dt="2022-07-12T15:26:48.323" v="70" actId="20577"/>
          <ac:spMkLst>
            <pc:docMk/>
            <pc:sldMk cId="3911920316" sldId="261"/>
            <ac:spMk id="10" creationId="{25806CE4-3194-AD61-F757-0AF0430A9F09}"/>
          </ac:spMkLst>
        </pc:spChg>
        <pc:spChg chg="add mod">
          <ac:chgData name="Corinne Linardic, M.D." userId="I32qLDVSfbowGounXRZTIrhDVT44J/lN53XBFKiLJBg=" providerId="None" clId="Web-{AEFDD03A-3A01-4AF9-A2AF-A974CB6FDD81}" dt="2022-07-12T15:26:50.574" v="71" actId="20577"/>
          <ac:spMkLst>
            <pc:docMk/>
            <pc:sldMk cId="3911920316" sldId="261"/>
            <ac:spMk id="21" creationId="{1658287A-74BD-3B48-ED22-CC8E6284C25E}"/>
          </ac:spMkLst>
        </pc:spChg>
        <pc:spChg chg="add del mod">
          <ac:chgData name="Corinne Linardic, M.D." userId="I32qLDVSfbowGounXRZTIrhDVT44J/lN53XBFKiLJBg=" providerId="None" clId="Web-{AEFDD03A-3A01-4AF9-A2AF-A974CB6FDD81}" dt="2022-07-12T15:26:51.870" v="72" actId="20577"/>
          <ac:spMkLst>
            <pc:docMk/>
            <pc:sldMk cId="3911920316" sldId="261"/>
            <ac:spMk id="24" creationId="{7A55670A-E218-DF5C-DC1F-4F8AFC76D039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09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078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611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252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414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55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200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253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823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931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AB59C-93E8-41BB-A74C-64A53523ED81}" type="datetimeFigureOut">
              <a:rPr lang="en-US" smtClean="0"/>
              <a:t>7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BFD61-FEE2-400C-801D-160BA5030F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0333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tiff"/><Relationship Id="rId13" Type="http://schemas.openxmlformats.org/officeDocument/2006/relationships/image" Target="../media/image53.png"/><Relationship Id="rId3" Type="http://schemas.openxmlformats.org/officeDocument/2006/relationships/image" Target="../media/image47.png"/><Relationship Id="rId7" Type="http://schemas.openxmlformats.org/officeDocument/2006/relationships/image" Target="../media/image49.tiff"/><Relationship Id="rId12" Type="http://schemas.microsoft.com/office/2007/relationships/hdphoto" Target="../media/hdphoto6.wdp"/><Relationship Id="rId2" Type="http://schemas.openxmlformats.org/officeDocument/2006/relationships/image" Target="../media/image46.tiff"/><Relationship Id="rId16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11" Type="http://schemas.openxmlformats.org/officeDocument/2006/relationships/image" Target="../media/image52.png"/><Relationship Id="rId5" Type="http://schemas.openxmlformats.org/officeDocument/2006/relationships/image" Target="../media/image48.png"/><Relationship Id="rId15" Type="http://schemas.openxmlformats.org/officeDocument/2006/relationships/image" Target="../media/image55.png"/><Relationship Id="rId10" Type="http://schemas.microsoft.com/office/2007/relationships/hdphoto" Target="../media/hdphoto5.wdp"/><Relationship Id="rId4" Type="http://schemas.microsoft.com/office/2007/relationships/hdphoto" Target="../media/hdphoto3.wdp"/><Relationship Id="rId9" Type="http://schemas.openxmlformats.org/officeDocument/2006/relationships/image" Target="../media/image51.png"/><Relationship Id="rId14" Type="http://schemas.openxmlformats.org/officeDocument/2006/relationships/image" Target="../media/image54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57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png"/><Relationship Id="rId3" Type="http://schemas.openxmlformats.org/officeDocument/2006/relationships/image" Target="../media/image61.tiff"/><Relationship Id="rId7" Type="http://schemas.openxmlformats.org/officeDocument/2006/relationships/image" Target="../media/image65.png"/><Relationship Id="rId2" Type="http://schemas.openxmlformats.org/officeDocument/2006/relationships/image" Target="../media/image6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4.tiff"/><Relationship Id="rId5" Type="http://schemas.openxmlformats.org/officeDocument/2006/relationships/image" Target="../media/image63.tiff"/><Relationship Id="rId4" Type="http://schemas.openxmlformats.org/officeDocument/2006/relationships/image" Target="../media/image62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tiff"/><Relationship Id="rId2" Type="http://schemas.openxmlformats.org/officeDocument/2006/relationships/image" Target="../media/image6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9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13" Type="http://schemas.openxmlformats.org/officeDocument/2006/relationships/image" Target="../media/image26.tiff"/><Relationship Id="rId3" Type="http://schemas.microsoft.com/office/2007/relationships/hdphoto" Target="../media/hdphoto1.wdp"/><Relationship Id="rId7" Type="http://schemas.openxmlformats.org/officeDocument/2006/relationships/image" Target="../media/image20.png"/><Relationship Id="rId12" Type="http://schemas.openxmlformats.org/officeDocument/2006/relationships/image" Target="../media/image25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tiff"/><Relationship Id="rId11" Type="http://schemas.openxmlformats.org/officeDocument/2006/relationships/image" Target="../media/image24.tiff"/><Relationship Id="rId5" Type="http://schemas.microsoft.com/office/2007/relationships/hdphoto" Target="../media/hdphoto2.wdp"/><Relationship Id="rId10" Type="http://schemas.openxmlformats.org/officeDocument/2006/relationships/image" Target="../media/image23.tiff"/><Relationship Id="rId4" Type="http://schemas.openxmlformats.org/officeDocument/2006/relationships/image" Target="../media/image18.png"/><Relationship Id="rId9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27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tiff"/><Relationship Id="rId3" Type="http://schemas.openxmlformats.org/officeDocument/2006/relationships/image" Target="../media/image16.png"/><Relationship Id="rId7" Type="http://schemas.openxmlformats.org/officeDocument/2006/relationships/image" Target="../media/image32.tiff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tiff"/><Relationship Id="rId5" Type="http://schemas.openxmlformats.org/officeDocument/2006/relationships/image" Target="../media/image30.png"/><Relationship Id="rId4" Type="http://schemas.openxmlformats.org/officeDocument/2006/relationships/image" Target="../media/image13.png"/><Relationship Id="rId9" Type="http://schemas.openxmlformats.org/officeDocument/2006/relationships/image" Target="../media/image34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f"/><Relationship Id="rId7" Type="http://schemas.openxmlformats.org/officeDocument/2006/relationships/image" Target="../media/image40.tiff"/><Relationship Id="rId2" Type="http://schemas.openxmlformats.org/officeDocument/2006/relationships/image" Target="../media/image3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tiff"/><Relationship Id="rId5" Type="http://schemas.openxmlformats.org/officeDocument/2006/relationships/image" Target="../media/image38.tiff"/><Relationship Id="rId4" Type="http://schemas.openxmlformats.org/officeDocument/2006/relationships/image" Target="../media/image37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eg"/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tiff"/><Relationship Id="rId5" Type="http://schemas.openxmlformats.org/officeDocument/2006/relationships/image" Target="../media/image44.tiff"/><Relationship Id="rId4" Type="http://schemas.openxmlformats.org/officeDocument/2006/relationships/image" Target="../media/image4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10343" y="1240971"/>
            <a:ext cx="5796643" cy="818685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dentification and targeting of a HES1-YAP1-CDKN1C functional interaction in fusion-negative rhabdomyosarcoma</a:t>
            </a: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latin typeface="Arial" panose="020B0604020202020204" pitchFamily="34" charset="0"/>
              </a:rPr>
              <a:t>Alexander </a:t>
            </a:r>
            <a:r>
              <a:rPr lang="en-US" sz="1400" dirty="0">
                <a:latin typeface="Arial" panose="020B0604020202020204" pitchFamily="34" charset="0"/>
              </a:rPr>
              <a:t>R Kovach</a:t>
            </a:r>
            <a:r>
              <a:rPr lang="en-US" sz="1400" baseline="30000" dirty="0">
                <a:latin typeface="Arial" panose="020B0604020202020204" pitchFamily="34" charset="0"/>
              </a:rPr>
              <a:t>1*</a:t>
            </a:r>
            <a:r>
              <a:rPr lang="en-US" sz="1400" dirty="0">
                <a:latin typeface="Arial" panose="020B0604020202020204" pitchFamily="34" charset="0"/>
              </a:rPr>
              <a:t>, </a:t>
            </a:r>
            <a:r>
              <a:rPr lang="en-US" sz="1400" dirty="0" err="1">
                <a:latin typeface="Arial" panose="020B0604020202020204" pitchFamily="34" charset="0"/>
              </a:rPr>
              <a:t>Kristianne</a:t>
            </a:r>
            <a:r>
              <a:rPr lang="en-US" sz="1400" dirty="0">
                <a:latin typeface="Arial" panose="020B0604020202020204" pitchFamily="34" charset="0"/>
              </a:rPr>
              <a:t> M Oristian</a:t>
            </a:r>
            <a:r>
              <a:rPr lang="en-US" sz="1400" baseline="30000" dirty="0">
                <a:latin typeface="Arial" panose="020B0604020202020204" pitchFamily="34" charset="0"/>
              </a:rPr>
              <a:t>2,3*</a:t>
            </a:r>
            <a:r>
              <a:rPr lang="en-US" sz="1400" dirty="0">
                <a:latin typeface="Arial" panose="020B0604020202020204" pitchFamily="34" charset="0"/>
              </a:rPr>
              <a:t>, David G Kirsch</a:t>
            </a:r>
            <a:r>
              <a:rPr lang="en-US" sz="1400" baseline="30000" dirty="0">
                <a:latin typeface="Arial" panose="020B0604020202020204" pitchFamily="34" charset="0"/>
              </a:rPr>
              <a:t>2,3</a:t>
            </a:r>
            <a:r>
              <a:rPr lang="en-US" sz="1400" dirty="0">
                <a:latin typeface="Arial" panose="020B0604020202020204" pitchFamily="34" charset="0"/>
              </a:rPr>
              <a:t>, Rex C Bentley</a:t>
            </a:r>
            <a:r>
              <a:rPr lang="en-US" sz="1400" baseline="30000" dirty="0">
                <a:latin typeface="Arial" panose="020B0604020202020204" pitchFamily="34" charset="0"/>
              </a:rPr>
              <a:t>4</a:t>
            </a:r>
            <a:r>
              <a:rPr lang="en-US" sz="1400" dirty="0">
                <a:latin typeface="Arial" panose="020B0604020202020204" pitchFamily="34" charset="0"/>
              </a:rPr>
              <a:t>, Changde Cheng</a:t>
            </a:r>
            <a:r>
              <a:rPr lang="en-US" sz="1400" baseline="30000" dirty="0">
                <a:latin typeface="Arial" panose="020B0604020202020204" pitchFamily="34" charset="0"/>
              </a:rPr>
              <a:t>5</a:t>
            </a:r>
            <a:r>
              <a:rPr lang="en-US" sz="1400" dirty="0">
                <a:latin typeface="Arial" panose="020B0604020202020204" pitchFamily="34" charset="0"/>
              </a:rPr>
              <a:t>, Xiang Chen</a:t>
            </a:r>
            <a:r>
              <a:rPr lang="en-US" sz="1400" baseline="30000" dirty="0">
                <a:latin typeface="Arial" panose="020B0604020202020204" pitchFamily="34" charset="0"/>
              </a:rPr>
              <a:t>5</a:t>
            </a:r>
            <a:r>
              <a:rPr lang="en-US" sz="1400" dirty="0">
                <a:latin typeface="Arial" panose="020B0604020202020204" pitchFamily="34" charset="0"/>
              </a:rPr>
              <a:t>, Po-Han Chen</a:t>
            </a:r>
            <a:r>
              <a:rPr lang="en-US" sz="1400" baseline="30000" dirty="0">
                <a:latin typeface="Arial" panose="020B0604020202020204" pitchFamily="34" charset="0"/>
              </a:rPr>
              <a:t>6</a:t>
            </a:r>
            <a:r>
              <a:rPr lang="en-US" sz="1400" dirty="0">
                <a:latin typeface="Arial" panose="020B0604020202020204" pitchFamily="34" charset="0"/>
              </a:rPr>
              <a:t>, Jen-</a:t>
            </a:r>
            <a:r>
              <a:rPr lang="en-US" sz="1400" dirty="0" err="1">
                <a:latin typeface="Arial" panose="020B0604020202020204" pitchFamily="34" charset="0"/>
              </a:rPr>
              <a:t>Tsan</a:t>
            </a:r>
            <a:r>
              <a:rPr lang="en-US" sz="1400" dirty="0">
                <a:latin typeface="Arial" panose="020B0604020202020204" pitchFamily="34" charset="0"/>
              </a:rPr>
              <a:t> Ashley Chi</a:t>
            </a:r>
            <a:r>
              <a:rPr lang="en-US" sz="1400" baseline="30000" dirty="0">
                <a:latin typeface="Arial" panose="020B0604020202020204" pitchFamily="34" charset="0"/>
              </a:rPr>
              <a:t>6</a:t>
            </a:r>
            <a:r>
              <a:rPr lang="en-US" sz="1400" dirty="0">
                <a:latin typeface="Arial" panose="020B0604020202020204" pitchFamily="34" charset="0"/>
              </a:rPr>
              <a:t>, Corinne M Linardic</a:t>
            </a:r>
            <a:r>
              <a:rPr lang="en-US" sz="1400" baseline="30000" dirty="0">
                <a:latin typeface="Arial" panose="020B0604020202020204" pitchFamily="34" charset="0"/>
              </a:rPr>
              <a:t>1,2</a:t>
            </a:r>
          </a:p>
          <a:p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partment of Pediatrics, Duke University School of Medicine, Durham, NC, USA</a:t>
            </a: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partment of Pharmacology &amp; Cancer Biology, Duke University School of Medicine, Durham, NC, USA</a:t>
            </a: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partment of Radiation Oncology, Duke University School of Medicine, Durham, NC, USA</a:t>
            </a: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partment of Computational Biology, St. Jude Children's Research Hospital, Memphis, TN, USA.</a:t>
            </a: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partment of Pathology, Duke University, Durham, NC USA</a:t>
            </a: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partment of Molecular Genetics and Microbiology, Duke University School of Medicine, Durham, NC USA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These authors contributed equally.</a:t>
            </a: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information</a:t>
            </a: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___________________________________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unning title: HES1 in fusion-negative rhabdomyosarcoma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ey words: Rhabdomyosarcoma, HES1, YAP1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Corresponding author: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r. Corinne M. Linardic, Division of Pediatric Hematology-Oncology, Department of Pediatrics, Duke University School of Medicine, Box 102382 DUMC, Durham, NC, 27710, USA. Tel/Fax +1.919.684.3401, +1.919.681.7950, E-mail: corinne.Linardic@duke.edu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0099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150279" y="7032914"/>
            <a:ext cx="5316243" cy="1895381"/>
            <a:chOff x="791964" y="4576575"/>
            <a:chExt cx="5316243" cy="1895381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194"/>
            <a:stretch/>
          </p:blipFill>
          <p:spPr>
            <a:xfrm>
              <a:off x="791964" y="4667534"/>
              <a:ext cx="2743200" cy="1804422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2142185" y="4576575"/>
              <a:ext cx="3966022" cy="1608724"/>
              <a:chOff x="1054475" y="2606556"/>
              <a:chExt cx="3966022" cy="1608724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1054475" y="2798470"/>
                <a:ext cx="10813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C</a:t>
                </a:r>
                <a:r>
                  <a:rPr lang="en-US" sz="12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30 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" name="Group 7"/>
              <p:cNvGrpSpPr/>
              <p:nvPr/>
            </p:nvGrpSpPr>
            <p:grpSpPr>
              <a:xfrm>
                <a:off x="2452990" y="2606556"/>
                <a:ext cx="2567507" cy="1608724"/>
                <a:chOff x="3633423" y="2606556"/>
                <a:chExt cx="2567507" cy="1608724"/>
              </a:xfrm>
            </p:grpSpPr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139" t="56058" r="40986" b="6442"/>
                <a:stretch/>
              </p:blipFill>
              <p:spPr>
                <a:xfrm rot="5400000">
                  <a:off x="3552741" y="2924361"/>
                  <a:ext cx="1371600" cy="1210235"/>
                </a:xfrm>
                <a:prstGeom prst="rect">
                  <a:avLst/>
                </a:prstGeom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>
                  <a:off x="3660006" y="2606556"/>
                  <a:ext cx="109153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 </a:t>
                  </a:r>
                  <a:r>
                    <a:rPr lang="en-US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M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JI051</a:t>
                  </a:r>
                </a:p>
              </p:txBody>
            </p:sp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68125" b="62500"/>
                <a:stretch/>
              </p:blipFill>
              <p:spPr>
                <a:xfrm rot="5400000">
                  <a:off x="4858557" y="2924362"/>
                  <a:ext cx="1371600" cy="1210235"/>
                </a:xfrm>
                <a:prstGeom prst="rect">
                  <a:avLst/>
                </a:prstGeom>
              </p:spPr>
            </p:pic>
            <p:sp>
              <p:nvSpPr>
                <p:cNvPr id="12" name="TextBox 11"/>
                <p:cNvSpPr txBox="1"/>
                <p:nvPr/>
              </p:nvSpPr>
              <p:spPr>
                <a:xfrm>
                  <a:off x="4929803" y="2606556"/>
                  <a:ext cx="127112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 </a:t>
                  </a:r>
                  <a:r>
                    <a:rPr lang="en-US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M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JI051</a:t>
                  </a:r>
                </a:p>
              </p:txBody>
            </p:sp>
          </p:grpSp>
        </p:grpSp>
      </p:grpSp>
      <p:grpSp>
        <p:nvGrpSpPr>
          <p:cNvPr id="13" name="Group 12"/>
          <p:cNvGrpSpPr/>
          <p:nvPr/>
        </p:nvGrpSpPr>
        <p:grpSpPr>
          <a:xfrm>
            <a:off x="1155307" y="3218761"/>
            <a:ext cx="5347093" cy="1908519"/>
            <a:chOff x="796992" y="762422"/>
            <a:chExt cx="5347093" cy="1908519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315"/>
            <a:stretch/>
          </p:blipFill>
          <p:spPr>
            <a:xfrm>
              <a:off x="796992" y="826997"/>
              <a:ext cx="2743200" cy="1843944"/>
            </a:xfrm>
            <a:prstGeom prst="rect">
              <a:avLst/>
            </a:prstGeom>
          </p:spPr>
        </p:pic>
        <p:grpSp>
          <p:nvGrpSpPr>
            <p:cNvPr id="15" name="Group 14"/>
            <p:cNvGrpSpPr/>
            <p:nvPr/>
          </p:nvGrpSpPr>
          <p:grpSpPr>
            <a:xfrm>
              <a:off x="2058219" y="762422"/>
              <a:ext cx="4085866" cy="507363"/>
              <a:chOff x="993689" y="762422"/>
              <a:chExt cx="4085866" cy="507363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993689" y="992786"/>
                <a:ext cx="11389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C</a:t>
                </a:r>
                <a:r>
                  <a:rPr lang="en-US" sz="12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48 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" name="Group 16"/>
              <p:cNvGrpSpPr/>
              <p:nvPr/>
            </p:nvGrpSpPr>
            <p:grpSpPr>
              <a:xfrm>
                <a:off x="2493576" y="762422"/>
                <a:ext cx="2585979" cy="277000"/>
                <a:chOff x="3674009" y="762422"/>
                <a:chExt cx="2585979" cy="277000"/>
              </a:xfrm>
            </p:grpSpPr>
            <p:sp>
              <p:nvSpPr>
                <p:cNvPr id="18" name="TextBox 17"/>
                <p:cNvSpPr txBox="1"/>
                <p:nvPr/>
              </p:nvSpPr>
              <p:spPr>
                <a:xfrm>
                  <a:off x="3674009" y="762423"/>
                  <a:ext cx="11098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 </a:t>
                  </a:r>
                  <a:r>
                    <a:rPr lang="en-US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M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JI051</a:t>
                  </a: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4965681" y="762422"/>
                  <a:ext cx="129430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 </a:t>
                  </a:r>
                  <a:r>
                    <a:rPr lang="en-US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M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JI051</a:t>
                  </a:r>
                </a:p>
              </p:txBody>
            </p:sp>
          </p:grpSp>
        </p:grpSp>
      </p:grpSp>
      <p:grpSp>
        <p:nvGrpSpPr>
          <p:cNvPr id="22" name="Group 21"/>
          <p:cNvGrpSpPr/>
          <p:nvPr/>
        </p:nvGrpSpPr>
        <p:grpSpPr>
          <a:xfrm>
            <a:off x="1156138" y="5082124"/>
            <a:ext cx="5339440" cy="1892948"/>
            <a:chOff x="797823" y="2625785"/>
            <a:chExt cx="5339440" cy="1892948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621"/>
            <a:stretch/>
          </p:blipFill>
          <p:spPr>
            <a:xfrm>
              <a:off x="797823" y="2702257"/>
              <a:ext cx="2743200" cy="1816476"/>
            </a:xfrm>
            <a:prstGeom prst="rect">
              <a:avLst/>
            </a:prstGeom>
          </p:spPr>
        </p:pic>
        <p:grpSp>
          <p:nvGrpSpPr>
            <p:cNvPr id="24" name="Group 23"/>
            <p:cNvGrpSpPr/>
            <p:nvPr/>
          </p:nvGrpSpPr>
          <p:grpSpPr>
            <a:xfrm>
              <a:off x="2142185" y="2625785"/>
              <a:ext cx="3995078" cy="1613882"/>
              <a:chOff x="1064710" y="4488640"/>
              <a:chExt cx="3995078" cy="1613882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1064710" y="4742981"/>
                <a:ext cx="11287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C</a:t>
                </a:r>
                <a:r>
                  <a:rPr lang="en-US" sz="12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48 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Group 25"/>
              <p:cNvGrpSpPr/>
              <p:nvPr/>
            </p:nvGrpSpPr>
            <p:grpSpPr>
              <a:xfrm>
                <a:off x="2458408" y="4488640"/>
                <a:ext cx="2601380" cy="1613882"/>
                <a:chOff x="3638841" y="4488640"/>
                <a:chExt cx="2601380" cy="1613882"/>
              </a:xfrm>
            </p:grpSpPr>
            <p:sp>
              <p:nvSpPr>
                <p:cNvPr id="27" name="TextBox 26"/>
                <p:cNvSpPr txBox="1"/>
                <p:nvPr/>
              </p:nvSpPr>
              <p:spPr>
                <a:xfrm>
                  <a:off x="3704974" y="4488641"/>
                  <a:ext cx="102206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 </a:t>
                  </a:r>
                  <a:r>
                    <a:rPr lang="en-US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M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JI051</a:t>
                  </a: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4966467" y="4488640"/>
                  <a:ext cx="127375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 </a:t>
                  </a:r>
                  <a:r>
                    <a:rPr lang="en-US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M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JI051</a:t>
                  </a:r>
                </a:p>
              </p:txBody>
            </p:sp>
            <p:pic>
              <p:nvPicPr>
                <p:cNvPr id="29" name="Picture 28"/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837" t="56114" r="27288" b="6386"/>
                <a:stretch/>
              </p:blipFill>
              <p:spPr>
                <a:xfrm rot="5400000">
                  <a:off x="3558159" y="4811604"/>
                  <a:ext cx="1371600" cy="1210235"/>
                </a:xfrm>
                <a:prstGeom prst="rect">
                  <a:avLst/>
                </a:prstGeom>
              </p:spPr>
            </p:pic>
            <p:pic>
              <p:nvPicPr>
                <p:cNvPr id="30" name="Picture 29"/>
                <p:cNvPicPr>
                  <a:picLocks noChangeAspect="1"/>
                </p:cNvPicPr>
                <p:nvPr/>
              </p:nvPicPr>
              <p:blipFill rotWithShape="1">
                <a:blip r:embed="rId11" cstate="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68125" b="62500"/>
                <a:stretch/>
              </p:blipFill>
              <p:spPr>
                <a:xfrm rot="5400000">
                  <a:off x="4881097" y="4811603"/>
                  <a:ext cx="1371600" cy="1210235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31" name="TextBox 30"/>
          <p:cNvSpPr txBox="1"/>
          <p:nvPr/>
        </p:nvSpPr>
        <p:spPr>
          <a:xfrm rot="16200000">
            <a:off x="677138" y="3808824"/>
            <a:ext cx="655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</a:p>
        </p:txBody>
      </p:sp>
      <p:sp>
        <p:nvSpPr>
          <p:cNvPr id="32" name="TextBox 31"/>
          <p:cNvSpPr txBox="1"/>
          <p:nvPr/>
        </p:nvSpPr>
        <p:spPr>
          <a:xfrm rot="16200000">
            <a:off x="228851" y="5419268"/>
            <a:ext cx="1593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Arial" panose="020B0604020202020204" pitchFamily="34" charset="0"/>
                <a:cs typeface="Arial" panose="020B0604020202020204" pitchFamily="34" charset="0"/>
              </a:rPr>
              <a:t>SMS-CTR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463395" y="7422014"/>
            <a:ext cx="111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Arial" panose="020B0604020202020204" pitchFamily="34" charset="0"/>
                <a:cs typeface="Arial" panose="020B0604020202020204" pitchFamily="34" charset="0"/>
              </a:rPr>
              <a:t>Rh36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928322" y="3151696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488173" y="3151696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699034" y="9058592"/>
            <a:ext cx="6553536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/>
              <a:t>Fig S9. Effect of the HES1 pharmacologic inhibitor JI051 in HES1 luciferase reporter assays and cell viability </a:t>
            </a:r>
            <a:r>
              <a:rPr lang="en-US" b="1" i="1" dirty="0"/>
              <a:t>in vitro</a:t>
            </a:r>
            <a:r>
              <a:rPr lang="en-US" b="1" dirty="0"/>
              <a:t>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0358" y="381655"/>
            <a:ext cx="2792370" cy="266748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719" y="381655"/>
            <a:ext cx="2957679" cy="2191237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3660358" y="319441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22529" y="319441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88B18313-E41E-4AF4-9758-D937B38C1D44}"/>
              </a:ext>
            </a:extLst>
          </p:cNvPr>
          <p:cNvGrpSpPr/>
          <p:nvPr/>
        </p:nvGrpSpPr>
        <p:grpSpPr>
          <a:xfrm>
            <a:off x="3904827" y="3535849"/>
            <a:ext cx="1207008" cy="1371600"/>
            <a:chOff x="4562856" y="1837944"/>
            <a:chExt cx="1207008" cy="1371600"/>
          </a:xfrm>
        </p:grpSpPr>
        <p:pic>
          <p:nvPicPr>
            <p:cNvPr id="40" name="Google Shape;253;p12">
              <a:extLst>
                <a:ext uri="{FF2B5EF4-FFF2-40B4-BE49-F238E27FC236}">
                  <a16:creationId xmlns:a16="http://schemas.microsoft.com/office/drawing/2014/main" id="{DCA899D3-AEC4-7FBE-E82A-5BBE7A998235}"/>
                </a:ext>
              </a:extLst>
            </p:cNvPr>
            <p:cNvPicPr preferRelativeResize="0"/>
            <p:nvPr/>
          </p:nvPicPr>
          <p:blipFill rotWithShape="1">
            <a:blip r:embed="rId15">
              <a:alphaModFix/>
            </a:blip>
            <a:srcRect l="16522" t="49097" r="48322" b="9653"/>
            <a:stretch/>
          </p:blipFill>
          <p:spPr>
            <a:xfrm rot="5400000">
              <a:off x="4480560" y="1920240"/>
              <a:ext cx="1371600" cy="1207008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6DE43566-BC71-1434-9445-E1441E02BE75}"/>
                </a:ext>
              </a:extLst>
            </p:cNvPr>
            <p:cNvGrpSpPr/>
            <p:nvPr/>
          </p:nvGrpSpPr>
          <p:grpSpPr>
            <a:xfrm>
              <a:off x="5166360" y="3071045"/>
              <a:ext cx="557784" cy="138499"/>
              <a:chOff x="7090964" y="3245103"/>
              <a:chExt cx="557784" cy="138499"/>
            </a:xfrm>
          </p:grpSpPr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00369D88-DAF1-CADA-04A5-18696F316D69}"/>
                  </a:ext>
                </a:extLst>
              </p:cNvPr>
              <p:cNvCxnSpPr/>
              <p:nvPr/>
            </p:nvCxnSpPr>
            <p:spPr>
              <a:xfrm>
                <a:off x="7090964" y="3314353"/>
                <a:ext cx="557784" cy="0"/>
              </a:xfrm>
              <a:prstGeom prst="line">
                <a:avLst/>
              </a:prstGeom>
              <a:ln w="476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40D8AEE9-534C-984A-EF57-A16AE532E48B}"/>
                  </a:ext>
                </a:extLst>
              </p:cNvPr>
              <p:cNvSpPr txBox="1"/>
              <p:nvPr/>
            </p:nvSpPr>
            <p:spPr>
              <a:xfrm>
                <a:off x="7216853" y="3245103"/>
                <a:ext cx="306006" cy="138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00" dirty="0">
                    <a:solidFill>
                      <a:schemeClr val="bg1"/>
                    </a:solidFill>
                  </a:rPr>
                  <a:t>500</a:t>
                </a:r>
                <a:r>
                  <a:rPr lang="en-US" sz="300" dirty="0">
                    <a:solidFill>
                      <a:schemeClr val="bg1"/>
                    </a:solidFill>
                    <a:sym typeface="Symbol" pitchFamily="2" charset="2"/>
                  </a:rPr>
                  <a:t></a:t>
                </a:r>
                <a:r>
                  <a:rPr lang="en-US" sz="3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</p:grp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C286FD72-3BFF-D7AA-CC7F-6B144D2761FD}"/>
              </a:ext>
            </a:extLst>
          </p:cNvPr>
          <p:cNvGrpSpPr/>
          <p:nvPr/>
        </p:nvGrpSpPr>
        <p:grpSpPr>
          <a:xfrm>
            <a:off x="5192004" y="3526668"/>
            <a:ext cx="1207008" cy="1371600"/>
            <a:chOff x="8494776" y="4764024"/>
            <a:chExt cx="1207008" cy="1371600"/>
          </a:xfrm>
        </p:grpSpPr>
        <p:pic>
          <p:nvPicPr>
            <p:cNvPr id="45" name="Google Shape;256;p12">
              <a:extLst>
                <a:ext uri="{FF2B5EF4-FFF2-40B4-BE49-F238E27FC236}">
                  <a16:creationId xmlns:a16="http://schemas.microsoft.com/office/drawing/2014/main" id="{521AAA80-0935-E802-F387-B3985EF775B9}"/>
                </a:ext>
              </a:extLst>
            </p:cNvPr>
            <p:cNvPicPr preferRelativeResize="0"/>
            <p:nvPr/>
          </p:nvPicPr>
          <p:blipFill rotWithShape="1">
            <a:blip r:embed="rId16">
              <a:alphaModFix/>
            </a:blip>
            <a:srcRect l="11482" t="32986" r="53362" b="25764"/>
            <a:stretch/>
          </p:blipFill>
          <p:spPr>
            <a:xfrm rot="5400000">
              <a:off x="8412480" y="4846320"/>
              <a:ext cx="1371600" cy="1207008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A6025C22-0F4F-005E-EF0E-AB5CD6095943}"/>
                </a:ext>
              </a:extLst>
            </p:cNvPr>
            <p:cNvGrpSpPr/>
            <p:nvPr/>
          </p:nvGrpSpPr>
          <p:grpSpPr>
            <a:xfrm>
              <a:off x="9084425" y="5970693"/>
              <a:ext cx="557784" cy="138499"/>
              <a:chOff x="7090964" y="3245103"/>
              <a:chExt cx="557784" cy="138499"/>
            </a:xfrm>
          </p:grpSpPr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527C8AF2-9448-6243-C8D9-304AB9D98BFB}"/>
                  </a:ext>
                </a:extLst>
              </p:cNvPr>
              <p:cNvCxnSpPr/>
              <p:nvPr/>
            </p:nvCxnSpPr>
            <p:spPr>
              <a:xfrm>
                <a:off x="7090964" y="3314353"/>
                <a:ext cx="557784" cy="0"/>
              </a:xfrm>
              <a:prstGeom prst="line">
                <a:avLst/>
              </a:prstGeom>
              <a:ln w="476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56B928D3-643A-8ECC-27D5-79FA8B57FD5D}"/>
                  </a:ext>
                </a:extLst>
              </p:cNvPr>
              <p:cNvSpPr txBox="1"/>
              <p:nvPr/>
            </p:nvSpPr>
            <p:spPr>
              <a:xfrm>
                <a:off x="7216853" y="3245103"/>
                <a:ext cx="306006" cy="138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00" dirty="0">
                    <a:solidFill>
                      <a:schemeClr val="bg1"/>
                    </a:solidFill>
                  </a:rPr>
                  <a:t>500</a:t>
                </a:r>
                <a:r>
                  <a:rPr lang="en-US" sz="300" dirty="0">
                    <a:solidFill>
                      <a:schemeClr val="bg1"/>
                    </a:solidFill>
                    <a:sym typeface="Symbol" pitchFamily="2" charset="2"/>
                  </a:rPr>
                  <a:t></a:t>
                </a:r>
                <a:r>
                  <a:rPr lang="en-US" sz="3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</p:grp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12A3C8B7-D798-4E90-66DD-24296CDBD2BE}"/>
              </a:ext>
            </a:extLst>
          </p:cNvPr>
          <p:cNvGrpSpPr/>
          <p:nvPr/>
        </p:nvGrpSpPr>
        <p:grpSpPr>
          <a:xfrm>
            <a:off x="4507432" y="6559446"/>
            <a:ext cx="557784" cy="138499"/>
            <a:chOff x="4660731" y="4921350"/>
            <a:chExt cx="557784" cy="138499"/>
          </a:xfrm>
        </p:grpSpPr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416A62E8-45A9-08DA-8D49-233C64A88FD7}"/>
                </a:ext>
              </a:extLst>
            </p:cNvPr>
            <p:cNvCxnSpPr/>
            <p:nvPr/>
          </p:nvCxnSpPr>
          <p:spPr>
            <a:xfrm>
              <a:off x="4660731" y="4990600"/>
              <a:ext cx="557784" cy="0"/>
            </a:xfrm>
            <a:prstGeom prst="line">
              <a:avLst/>
            </a:prstGeom>
            <a:ln w="476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EAE84688-17C3-1DD5-7D84-C79926AAE7E7}"/>
                </a:ext>
              </a:extLst>
            </p:cNvPr>
            <p:cNvSpPr txBox="1"/>
            <p:nvPr/>
          </p:nvSpPr>
          <p:spPr>
            <a:xfrm>
              <a:off x="4786620" y="4921350"/>
              <a:ext cx="306006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solidFill>
                    <a:schemeClr val="bg1"/>
                  </a:solidFill>
                </a:rPr>
                <a:t>500</a:t>
              </a:r>
              <a:r>
                <a:rPr lang="en-US" sz="300" dirty="0">
                  <a:solidFill>
                    <a:schemeClr val="bg1"/>
                  </a:solidFill>
                  <a:sym typeface="Symbol" pitchFamily="2" charset="2"/>
                </a:rPr>
                <a:t></a:t>
              </a:r>
              <a:r>
                <a:rPr lang="en-US" sz="300" dirty="0">
                  <a:solidFill>
                    <a:schemeClr val="bg1"/>
                  </a:solidFill>
                </a:rPr>
                <a:t>m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CE64BD6B-6CC3-21FB-CF00-C2B440D80CCA}"/>
              </a:ext>
            </a:extLst>
          </p:cNvPr>
          <p:cNvGrpSpPr/>
          <p:nvPr/>
        </p:nvGrpSpPr>
        <p:grpSpPr>
          <a:xfrm>
            <a:off x="5816174" y="6559446"/>
            <a:ext cx="557784" cy="138499"/>
            <a:chOff x="4660731" y="4921350"/>
            <a:chExt cx="557784" cy="138499"/>
          </a:xfrm>
        </p:grpSpPr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5D67244C-C74A-FC54-3DBC-4FEAF9BF6A0D}"/>
                </a:ext>
              </a:extLst>
            </p:cNvPr>
            <p:cNvCxnSpPr/>
            <p:nvPr/>
          </p:nvCxnSpPr>
          <p:spPr>
            <a:xfrm>
              <a:off x="4660731" y="4990600"/>
              <a:ext cx="557784" cy="0"/>
            </a:xfrm>
            <a:prstGeom prst="line">
              <a:avLst/>
            </a:prstGeom>
            <a:ln w="476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362B7BC-1229-4A89-15AF-965D23AD6271}"/>
                </a:ext>
              </a:extLst>
            </p:cNvPr>
            <p:cNvSpPr txBox="1"/>
            <p:nvPr/>
          </p:nvSpPr>
          <p:spPr>
            <a:xfrm>
              <a:off x="4786620" y="4921350"/>
              <a:ext cx="306006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solidFill>
                    <a:schemeClr val="bg1"/>
                  </a:solidFill>
                </a:rPr>
                <a:t>500</a:t>
              </a:r>
              <a:r>
                <a:rPr lang="en-US" sz="300" dirty="0">
                  <a:solidFill>
                    <a:schemeClr val="bg1"/>
                  </a:solidFill>
                  <a:sym typeface="Symbol" pitchFamily="2" charset="2"/>
                </a:rPr>
                <a:t></a:t>
              </a:r>
              <a:r>
                <a:rPr lang="en-US" sz="300" dirty="0">
                  <a:solidFill>
                    <a:schemeClr val="bg1"/>
                  </a:solidFill>
                </a:rPr>
                <a:t>m</a:t>
              </a:r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87A39A89-98C8-8A5F-D1BB-3D032A6D2B16}"/>
              </a:ext>
            </a:extLst>
          </p:cNvPr>
          <p:cNvGrpSpPr/>
          <p:nvPr/>
        </p:nvGrpSpPr>
        <p:grpSpPr>
          <a:xfrm>
            <a:off x="5809949" y="8489342"/>
            <a:ext cx="557784" cy="138499"/>
            <a:chOff x="4660731" y="4921350"/>
            <a:chExt cx="557784" cy="138499"/>
          </a:xfrm>
        </p:grpSpPr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0B155FB7-BF01-246D-D5CB-A2D264449E80}"/>
                </a:ext>
              </a:extLst>
            </p:cNvPr>
            <p:cNvCxnSpPr/>
            <p:nvPr/>
          </p:nvCxnSpPr>
          <p:spPr>
            <a:xfrm>
              <a:off x="4660731" y="4990600"/>
              <a:ext cx="557784" cy="0"/>
            </a:xfrm>
            <a:prstGeom prst="line">
              <a:avLst/>
            </a:prstGeom>
            <a:ln w="476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1B99FE7-04CE-5A8B-BA6E-A0D958670588}"/>
                </a:ext>
              </a:extLst>
            </p:cNvPr>
            <p:cNvSpPr txBox="1"/>
            <p:nvPr/>
          </p:nvSpPr>
          <p:spPr>
            <a:xfrm>
              <a:off x="4786620" y="4921350"/>
              <a:ext cx="306006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solidFill>
                    <a:schemeClr val="bg1"/>
                  </a:solidFill>
                </a:rPr>
                <a:t>500</a:t>
              </a:r>
              <a:r>
                <a:rPr lang="en-US" sz="300" dirty="0">
                  <a:solidFill>
                    <a:schemeClr val="bg1"/>
                  </a:solidFill>
                  <a:sym typeface="Symbol" pitchFamily="2" charset="2"/>
                </a:rPr>
                <a:t></a:t>
              </a:r>
              <a:r>
                <a:rPr lang="en-US" sz="300" dirty="0">
                  <a:solidFill>
                    <a:schemeClr val="bg1"/>
                  </a:solidFill>
                </a:rPr>
                <a:t>m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B753D77E-365B-E54D-08AE-94549E357B7B}"/>
              </a:ext>
            </a:extLst>
          </p:cNvPr>
          <p:cNvGrpSpPr/>
          <p:nvPr/>
        </p:nvGrpSpPr>
        <p:grpSpPr>
          <a:xfrm>
            <a:off x="4459345" y="8489342"/>
            <a:ext cx="557784" cy="138499"/>
            <a:chOff x="4660731" y="4921350"/>
            <a:chExt cx="557784" cy="138499"/>
          </a:xfrm>
        </p:grpSpPr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21C471EC-C440-2BFE-6E66-03B056A18F00}"/>
                </a:ext>
              </a:extLst>
            </p:cNvPr>
            <p:cNvCxnSpPr/>
            <p:nvPr/>
          </p:nvCxnSpPr>
          <p:spPr>
            <a:xfrm>
              <a:off x="4660731" y="4990600"/>
              <a:ext cx="557784" cy="0"/>
            </a:xfrm>
            <a:prstGeom prst="line">
              <a:avLst/>
            </a:prstGeom>
            <a:ln w="476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2DFFB63-7021-ED6D-55BE-57243BD6033D}"/>
                </a:ext>
              </a:extLst>
            </p:cNvPr>
            <p:cNvSpPr txBox="1"/>
            <p:nvPr/>
          </p:nvSpPr>
          <p:spPr>
            <a:xfrm>
              <a:off x="4786620" y="4921350"/>
              <a:ext cx="306006" cy="13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solidFill>
                    <a:schemeClr val="bg1"/>
                  </a:solidFill>
                </a:rPr>
                <a:t>500</a:t>
              </a:r>
              <a:r>
                <a:rPr lang="en-US" sz="300" dirty="0">
                  <a:solidFill>
                    <a:schemeClr val="bg1"/>
                  </a:solidFill>
                  <a:sym typeface="Symbol" pitchFamily="2" charset="2"/>
                </a:rPr>
                <a:t></a:t>
              </a:r>
              <a:r>
                <a:rPr lang="en-US" sz="300" dirty="0">
                  <a:solidFill>
                    <a:schemeClr val="bg1"/>
                  </a:solidFill>
                </a:rPr>
                <a:t>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3090808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Object 44"/>
          <p:cNvGraphicFramePr>
            <a:graphicFrameLocks noChangeAspect="1"/>
          </p:cNvGraphicFramePr>
          <p:nvPr/>
        </p:nvGraphicFramePr>
        <p:xfrm>
          <a:off x="359227" y="1469571"/>
          <a:ext cx="5584373" cy="55843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3" name="Acrobat Document" r:id="rId3" imgW="4800600" imgH="4800600" progId="AcroExch.Document.DC">
                  <p:embed/>
                </p:oleObj>
              </mc:Choice>
              <mc:Fallback>
                <p:oleObj name="Acrobat Document" r:id="rId3" imgW="4800600" imgH="4800600" progId="AcroExch.Document.DC">
                  <p:embed/>
                  <p:pic>
                    <p:nvPicPr>
                      <p:cNvPr id="45" name="Object 4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9227" y="1469571"/>
                        <a:ext cx="5584373" cy="55843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TextBox 45"/>
          <p:cNvSpPr txBox="1"/>
          <p:nvPr/>
        </p:nvSpPr>
        <p:spPr>
          <a:xfrm>
            <a:off x="676406" y="7414321"/>
            <a:ext cx="3444657" cy="33855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Fig S10. nCounter volcano plot.</a:t>
            </a:r>
          </a:p>
        </p:txBody>
      </p:sp>
    </p:spTree>
    <p:extLst>
      <p:ext uri="{BB962C8B-B14F-4D97-AF65-F5344CB8AC3E}">
        <p14:creationId xmlns:p14="http://schemas.microsoft.com/office/powerpoint/2010/main" val="15354324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940369" y="5420961"/>
            <a:ext cx="4978569" cy="33855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Fig S11. nCounter mRNA pathway profiling.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940369" y="163774"/>
            <a:ext cx="6477187" cy="5036023"/>
            <a:chOff x="940369" y="163774"/>
            <a:chExt cx="6477187" cy="5036023"/>
          </a:xfrm>
        </p:grpSpPr>
        <p:grpSp>
          <p:nvGrpSpPr>
            <p:cNvPr id="6" name="Group 5"/>
            <p:cNvGrpSpPr/>
            <p:nvPr/>
          </p:nvGrpSpPr>
          <p:grpSpPr>
            <a:xfrm>
              <a:off x="1407694" y="163774"/>
              <a:ext cx="6009862" cy="5036023"/>
              <a:chOff x="1762536" y="1"/>
              <a:chExt cx="6009862" cy="5036023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8390" b="13430"/>
              <a:stretch/>
            </p:blipFill>
            <p:spPr>
              <a:xfrm rot="5400000">
                <a:off x="2249455" y="-486918"/>
                <a:ext cx="5036023" cy="6009862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336" t="42985" r="19217" b="42985"/>
              <a:stretch/>
            </p:blipFill>
            <p:spPr>
              <a:xfrm>
                <a:off x="6373503" y="586854"/>
                <a:ext cx="1105469" cy="641444"/>
              </a:xfrm>
              <a:prstGeom prst="rect">
                <a:avLst/>
              </a:prstGeom>
            </p:spPr>
          </p:pic>
        </p:grpSp>
        <p:cxnSp>
          <p:nvCxnSpPr>
            <p:cNvPr id="3" name="Straight Connector 2"/>
            <p:cNvCxnSpPr/>
            <p:nvPr/>
          </p:nvCxnSpPr>
          <p:spPr>
            <a:xfrm flipV="1">
              <a:off x="1161738" y="2460359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 flipV="1">
              <a:off x="1161738" y="2203290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946693" y="2093554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34320" y="1836485"/>
              <a:ext cx="1274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cxnSp>
          <p:nvCxnSpPr>
            <p:cNvPr id="12" name="Straight Connector 11"/>
            <p:cNvCxnSpPr/>
            <p:nvPr/>
          </p:nvCxnSpPr>
          <p:spPr>
            <a:xfrm flipV="1">
              <a:off x="1162130" y="1944207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946693" y="2350623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946692" y="2605678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cxnSp>
          <p:nvCxnSpPr>
            <p:cNvPr id="15" name="Straight Connector 14"/>
            <p:cNvCxnSpPr/>
            <p:nvPr/>
          </p:nvCxnSpPr>
          <p:spPr>
            <a:xfrm flipV="1">
              <a:off x="1161738" y="2715414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V="1">
              <a:off x="1163263" y="2974866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flipV="1">
              <a:off x="1161737" y="3232795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V="1">
              <a:off x="1159594" y="3491694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V="1">
              <a:off x="1159594" y="3745165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 flipV="1">
              <a:off x="1159594" y="4009848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940369" y="2868715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940369" y="3127578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940369" y="3378699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940369" y="3634323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943859" y="3903044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</p:txBody>
        </p:sp>
        <p:cxnSp>
          <p:nvCxnSpPr>
            <p:cNvPr id="26" name="Straight Connector 25"/>
            <p:cNvCxnSpPr/>
            <p:nvPr/>
          </p:nvCxnSpPr>
          <p:spPr>
            <a:xfrm flipV="1">
              <a:off x="1159594" y="4268529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 flipV="1">
              <a:off x="1159594" y="4526203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944150" y="4159800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940369" y="4420075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cxnSp>
          <p:nvCxnSpPr>
            <p:cNvPr id="30" name="Straight Connector 29"/>
            <p:cNvCxnSpPr/>
            <p:nvPr/>
          </p:nvCxnSpPr>
          <p:spPr>
            <a:xfrm flipV="1">
              <a:off x="1159594" y="4781863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 flipV="1">
              <a:off x="1159594" y="5041373"/>
              <a:ext cx="274320" cy="20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940369" y="4676831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940369" y="4929801"/>
              <a:ext cx="3026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</p:grpSp>
      <p:sp>
        <p:nvSpPr>
          <p:cNvPr id="34" name="TextBox 33"/>
          <p:cNvSpPr txBox="1"/>
          <p:nvPr/>
        </p:nvSpPr>
        <p:spPr>
          <a:xfrm>
            <a:off x="989111" y="5922877"/>
            <a:ext cx="5213388" cy="3908762"/>
          </a:xfrm>
          <a:prstGeom prst="rect">
            <a:avLst/>
          </a:prstGeom>
          <a:noFill/>
        </p:spPr>
        <p:txBody>
          <a:bodyPr wrap="square" numCol="3" rtlCol="0">
            <a:spAutoFit/>
          </a:bodyPr>
          <a:lstStyle/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fectious disease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GPCR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PTK6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WNT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nuclear receptor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VEGF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nscriptional regulation by RUNX1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the B-cell receptor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-type lectin receptor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c epsilon receptor (FCERI)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xtracellular matrix organization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nscriptional regulation by RUNX3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rvous system development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ost-translational protein modification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emostasi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racellular signaling by second messenger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isease of signal transduction by growth factor receptors and second messenger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PK family signaling cascade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yogenesi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ll-like receptor cascade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NOTCH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NTRK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leukin-4 and interleukin-13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leukin-7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Costimulation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by the CD28 family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HIPPO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omatin modifying enzyme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nscriptional regulation of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granulopoiesi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pigenetic regulation of gene expression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uscle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atio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leukin 6 gamily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etabolism of RNA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hedgeho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leukin 12 family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nscriptional regulation of pluripotent stem cell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NFR2 non-canonical NF-kB pathway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ytosolic sensors of pathogen associated DNA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TOR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Macroautophagy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ronal system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rganelle biogenesis and maintenance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omosome maintenance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nscriptional regulation by E2F6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eath receptor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leukin-10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Unfolded protein response (UPR)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FGFR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nsport of small molecule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rcadian clock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TGFβ family member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leukin-2 family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leukin-20 family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ellular responses to stres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ell cycle# mitotic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NA repair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nscriptional regulation by TP53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ogrammed cell death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sicle mediate transport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ell-cell communication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egulation of insulin like growth factor binding protein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gnaling by MET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trophil degranulation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feron signaling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lass I MHC mediated antigen processing &amp; presentation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Immunoregulatory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interactions between a lymphoid and a non-lymphoid cell</a:t>
            </a:r>
          </a:p>
        </p:txBody>
      </p:sp>
    </p:spTree>
    <p:extLst>
      <p:ext uri="{BB962C8B-B14F-4D97-AF65-F5344CB8AC3E}">
        <p14:creationId xmlns:p14="http://schemas.microsoft.com/office/powerpoint/2010/main" val="167523718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0" y="9344947"/>
            <a:ext cx="7772400" cy="58477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Fig S12. nCounter mRNA pathway analysis hierarchically clusters doxycycline treatment group as more or less differentiated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17931" y="205960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335080" y="205960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17931" y="3465479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6" name="Group 15"/>
          <p:cNvGrpSpPr/>
          <p:nvPr/>
        </p:nvGrpSpPr>
        <p:grpSpPr>
          <a:xfrm>
            <a:off x="215814" y="342151"/>
            <a:ext cx="3712411" cy="2807649"/>
            <a:chOff x="125662" y="831548"/>
            <a:chExt cx="3712411" cy="2807649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574" r="24184"/>
            <a:stretch/>
          </p:blipFill>
          <p:spPr>
            <a:xfrm>
              <a:off x="125662" y="1070810"/>
              <a:ext cx="3712411" cy="2568387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865" t="16139" b="54711"/>
            <a:stretch/>
          </p:blipFill>
          <p:spPr>
            <a:xfrm>
              <a:off x="1062785" y="1407694"/>
              <a:ext cx="1083894" cy="866274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1603106" y="831548"/>
              <a:ext cx="14678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mor Volume</a:t>
              </a: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4051422" y="342150"/>
            <a:ext cx="3585554" cy="2807650"/>
            <a:chOff x="3961270" y="831547"/>
            <a:chExt cx="3585554" cy="2807650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968" r="22454"/>
            <a:stretch/>
          </p:blipFill>
          <p:spPr>
            <a:xfrm>
              <a:off x="3961270" y="1082486"/>
              <a:ext cx="3585554" cy="2556711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509" t="13968" b="63504"/>
            <a:stretch/>
          </p:blipFill>
          <p:spPr>
            <a:xfrm>
              <a:off x="5735399" y="1082486"/>
              <a:ext cx="808764" cy="669478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5522856" y="831547"/>
              <a:ext cx="14678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mor Volume</a:t>
              </a:r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486458" y="3606864"/>
            <a:ext cx="2310799" cy="2867744"/>
            <a:chOff x="9349632" y="6912580"/>
            <a:chExt cx="2310799" cy="286774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574"/>
            <a:stretch/>
          </p:blipFill>
          <p:spPr>
            <a:xfrm>
              <a:off x="9349632" y="7118398"/>
              <a:ext cx="1869948" cy="2661926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10192578" y="6912580"/>
              <a:ext cx="14678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CDKN1C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4833857" y="3650145"/>
            <a:ext cx="2105683" cy="2859149"/>
            <a:chOff x="596807" y="4181348"/>
            <a:chExt cx="2105683" cy="2859149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871"/>
            <a:stretch/>
          </p:blipFill>
          <p:spPr>
            <a:xfrm>
              <a:off x="596807" y="4379494"/>
              <a:ext cx="1850136" cy="2661003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1234637" y="4181348"/>
              <a:ext cx="14678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mor Mass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603106" y="5478900"/>
              <a:ext cx="3282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943365" y="5472422"/>
              <a:ext cx="3282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506668" y="3657907"/>
            <a:ext cx="1927860" cy="2859148"/>
            <a:chOff x="4328923" y="4181349"/>
            <a:chExt cx="1927860" cy="285914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13"/>
            <a:stretch/>
          </p:blipFill>
          <p:spPr>
            <a:xfrm>
              <a:off x="4328923" y="4367462"/>
              <a:ext cx="1927860" cy="2673035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5360410" y="4181349"/>
              <a:ext cx="884342" cy="2800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YOG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354055" y="5626310"/>
              <a:ext cx="4259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2655528" y="3491288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600736" y="3515351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425" y="6981700"/>
            <a:ext cx="3573340" cy="2253392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5318" y="6937002"/>
            <a:ext cx="3575304" cy="2269509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279745" y="6570228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845176" y="6567670"/>
            <a:ext cx="1602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070406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2350" y="843741"/>
            <a:ext cx="1964436" cy="322326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141" y="843741"/>
            <a:ext cx="1964436" cy="322326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19" y="843741"/>
            <a:ext cx="1845564" cy="322326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859917" y="1250253"/>
            <a:ext cx="425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51770" y="4304236"/>
            <a:ext cx="5661764" cy="58477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Fig S13. </a:t>
            </a:r>
            <a:r>
              <a:rPr lang="en-US" sz="1600" b="1" i="1" dirty="0">
                <a:latin typeface="Arial"/>
                <a:cs typeface="Arial"/>
              </a:rPr>
              <a:t>YAP1</a:t>
            </a:r>
            <a:r>
              <a:rPr lang="en-US" sz="1600" b="1" dirty="0">
                <a:latin typeface="Arial"/>
                <a:cs typeface="Arial"/>
              </a:rPr>
              <a:t> overexpression reduces </a:t>
            </a:r>
            <a:r>
              <a:rPr lang="en-US" sz="1600" b="1" i="1" dirty="0">
                <a:latin typeface="Arial"/>
                <a:cs typeface="Arial"/>
              </a:rPr>
              <a:t>CDKN1C </a:t>
            </a:r>
            <a:r>
              <a:rPr lang="en-US" sz="1600" b="1" dirty="0">
                <a:latin typeface="Arial"/>
                <a:cs typeface="Arial"/>
              </a:rPr>
              <a:t>but not </a:t>
            </a:r>
            <a:r>
              <a:rPr lang="en-US" sz="1600" b="1" i="1" dirty="0">
                <a:latin typeface="Arial"/>
                <a:cs typeface="Arial"/>
              </a:rPr>
              <a:t>HES1</a:t>
            </a:r>
            <a:r>
              <a:rPr lang="en-US" sz="1600" b="1" dirty="0">
                <a:latin typeface="Arial"/>
                <a:cs typeface="Arial"/>
              </a:rPr>
              <a:t> transcript levels.</a:t>
            </a:r>
          </a:p>
        </p:txBody>
      </p:sp>
    </p:spTree>
    <p:extLst>
      <p:ext uri="{BB962C8B-B14F-4D97-AF65-F5344CB8AC3E}">
        <p14:creationId xmlns:p14="http://schemas.microsoft.com/office/powerpoint/2010/main" val="5901868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41176" y="9268347"/>
            <a:ext cx="7057333" cy="58477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Fig S1.  YAP1 promotes </a:t>
            </a:r>
            <a:r>
              <a:rPr lang="en-US" sz="1600" b="1" i="1" dirty="0">
                <a:latin typeface="Arial"/>
                <a:cs typeface="Arial"/>
              </a:rPr>
              <a:t>CDKN1C</a:t>
            </a:r>
            <a:r>
              <a:rPr lang="en-US" sz="1600" b="1" dirty="0">
                <a:latin typeface="Arial"/>
                <a:cs typeface="Arial"/>
              </a:rPr>
              <a:t> downregulation, and assessment of </a:t>
            </a:r>
            <a:r>
              <a:rPr lang="en-US" sz="1600" b="1" i="1" dirty="0">
                <a:latin typeface="Arial"/>
                <a:cs typeface="Arial"/>
              </a:rPr>
              <a:t>HES1</a:t>
            </a:r>
            <a:r>
              <a:rPr lang="en-US" sz="1600" b="1" dirty="0">
                <a:latin typeface="Arial"/>
                <a:cs typeface="Arial"/>
              </a:rPr>
              <a:t> shRNA constructs.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335868" y="4554717"/>
            <a:ext cx="655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341176" y="7047307"/>
            <a:ext cx="2273144" cy="2218393"/>
            <a:chOff x="7102941" y="3791005"/>
            <a:chExt cx="2273144" cy="2218393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293"/>
            <a:stretch/>
          </p:blipFill>
          <p:spPr>
            <a:xfrm>
              <a:off x="7327829" y="3992632"/>
              <a:ext cx="2048256" cy="1429584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 rot="18404571">
              <a:off x="7694988" y="5362984"/>
              <a:ext cx="408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8404571">
              <a:off x="7892041" y="5454672"/>
              <a:ext cx="863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YAP1sh3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8404571">
              <a:off x="8388602" y="5454055"/>
              <a:ext cx="863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YAP1sh4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6703709" y="4549003"/>
              <a:ext cx="1052380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288521" y="4493043"/>
              <a:ext cx="4539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767197" y="4011060"/>
              <a:ext cx="5618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025784" y="3791005"/>
              <a:ext cx="74141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KN1C</a:t>
              </a:r>
              <a:endParaRPr 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1354467" y="117373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49667" y="4619574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9667" y="7015553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4" name="Group 23"/>
          <p:cNvGrpSpPr/>
          <p:nvPr/>
        </p:nvGrpSpPr>
        <p:grpSpPr>
          <a:xfrm>
            <a:off x="2807427" y="4903390"/>
            <a:ext cx="2262375" cy="2041644"/>
            <a:chOff x="9114969" y="1602834"/>
            <a:chExt cx="2262375" cy="2041644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032"/>
            <a:stretch/>
          </p:blipFill>
          <p:spPr>
            <a:xfrm>
              <a:off x="9329088" y="1802561"/>
              <a:ext cx="2048256" cy="1369684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 rot="16200000">
              <a:off x="8715737" y="2330997"/>
              <a:ext cx="1052380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Fold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hange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0704673" y="2275038"/>
              <a:ext cx="4539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8404571">
              <a:off x="9699792" y="3174025"/>
              <a:ext cx="6592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 rot="18404571">
              <a:off x="10418501" y="3059375"/>
              <a:ext cx="77009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YAP1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S127A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0132199" y="1602834"/>
              <a:ext cx="74141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KN1C</a:t>
              </a:r>
              <a:endParaRPr 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246284" y="4924078"/>
            <a:ext cx="2283905" cy="2023926"/>
            <a:chOff x="6553826" y="1636048"/>
            <a:chExt cx="2283905" cy="2023926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518"/>
            <a:stretch/>
          </p:blipFill>
          <p:spPr>
            <a:xfrm>
              <a:off x="6789475" y="1814435"/>
              <a:ext cx="2048256" cy="1361858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 rot="16200000">
              <a:off x="6154594" y="2364211"/>
              <a:ext cx="1052380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8404571">
              <a:off x="7066079" y="3207239"/>
              <a:ext cx="6592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rot="18404571">
              <a:off x="7964145" y="3112870"/>
              <a:ext cx="5631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YAP1 </a:t>
              </a:r>
            </a:p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7498486" y="1636048"/>
              <a:ext cx="74141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KN1C</a:t>
              </a:r>
              <a:endParaRPr 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143530" y="2530682"/>
              <a:ext cx="4539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2864794" y="7069753"/>
            <a:ext cx="2225737" cy="2426947"/>
            <a:chOff x="7472142" y="3805139"/>
            <a:chExt cx="2225737" cy="242694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782"/>
            <a:stretch/>
          </p:blipFill>
          <p:spPr>
            <a:xfrm>
              <a:off x="7649623" y="4022860"/>
              <a:ext cx="2048256" cy="1373733"/>
            </a:xfrm>
            <a:prstGeom prst="rect">
              <a:avLst/>
            </a:prstGeom>
          </p:spPr>
        </p:pic>
        <p:sp>
          <p:nvSpPr>
            <p:cNvPr id="40" name="TextBox 39"/>
            <p:cNvSpPr txBox="1"/>
            <p:nvPr/>
          </p:nvSpPr>
          <p:spPr>
            <a:xfrm rot="18404571">
              <a:off x="8040125" y="5365086"/>
              <a:ext cx="408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8404571">
              <a:off x="8085890" y="5618591"/>
              <a:ext cx="9807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WTR1sh2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 rot="18404571">
              <a:off x="8609307" y="5613780"/>
              <a:ext cx="980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WTR1sh5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7072910" y="4563137"/>
              <a:ext cx="1052380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8394985" y="3805139"/>
              <a:ext cx="74141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KN1C</a:t>
              </a:r>
              <a:endParaRPr 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5283921" y="6095016"/>
            <a:ext cx="2167562" cy="1892044"/>
            <a:chOff x="1583056" y="1875761"/>
            <a:chExt cx="2167562" cy="1892044"/>
          </a:xfrm>
        </p:grpSpPr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036"/>
            <a:stretch/>
          </p:blipFill>
          <p:spPr>
            <a:xfrm>
              <a:off x="1583056" y="1875761"/>
              <a:ext cx="2114588" cy="1892044"/>
            </a:xfrm>
            <a:prstGeom prst="rect">
              <a:avLst/>
            </a:prstGeom>
          </p:spPr>
        </p:pic>
        <p:sp>
          <p:nvSpPr>
            <p:cNvPr id="49" name="TextBox 48"/>
            <p:cNvSpPr txBox="1"/>
            <p:nvPr/>
          </p:nvSpPr>
          <p:spPr>
            <a:xfrm>
              <a:off x="2409280" y="2652096"/>
              <a:ext cx="5394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**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211209" y="2542172"/>
              <a:ext cx="5394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**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832383" y="2445194"/>
              <a:ext cx="5394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***</a:t>
              </a:r>
            </a:p>
          </p:txBody>
        </p:sp>
      </p:grpSp>
      <p:sp>
        <p:nvSpPr>
          <p:cNvPr id="52" name="TextBox 51"/>
          <p:cNvSpPr txBox="1"/>
          <p:nvPr/>
        </p:nvSpPr>
        <p:spPr>
          <a:xfrm>
            <a:off x="6367747" y="5789000"/>
            <a:ext cx="7414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HES1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289544" y="5626430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11953" y="341773"/>
            <a:ext cx="4548495" cy="40628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54478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DC80B1A-9DE6-CF92-4BF0-A6FDED2769F8}"/>
              </a:ext>
            </a:extLst>
          </p:cNvPr>
          <p:cNvSpPr txBox="1"/>
          <p:nvPr/>
        </p:nvSpPr>
        <p:spPr>
          <a:xfrm>
            <a:off x="334681" y="9079139"/>
            <a:ext cx="6128749" cy="33855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Fig S2. Full immunoblots corresponding to Figure 1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B0A4FC48-DADD-599F-EE9A-83B4989384F1}"/>
              </a:ext>
            </a:extLst>
          </p:cNvPr>
          <p:cNvGrpSpPr/>
          <p:nvPr/>
        </p:nvGrpSpPr>
        <p:grpSpPr>
          <a:xfrm>
            <a:off x="2529621" y="305453"/>
            <a:ext cx="2218117" cy="2591864"/>
            <a:chOff x="2329205" y="305453"/>
            <a:chExt cx="2218117" cy="259186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E931489-BF88-032E-CEFD-2D3BD8BA47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29205" y="611317"/>
              <a:ext cx="1537244" cy="228600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4D31BC5-BD1F-D267-EC3A-6C0C767B4B19}"/>
                </a:ext>
              </a:extLst>
            </p:cNvPr>
            <p:cNvSpPr txBox="1"/>
            <p:nvPr/>
          </p:nvSpPr>
          <p:spPr>
            <a:xfrm>
              <a:off x="3754591" y="1067879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0D4FD7C-6F83-6520-8BC5-4065482D9894}"/>
                </a:ext>
              </a:extLst>
            </p:cNvPr>
            <p:cNvSpPr txBox="1"/>
            <p:nvPr/>
          </p:nvSpPr>
          <p:spPr>
            <a:xfrm>
              <a:off x="3754591" y="1364238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BA7D12D-6F88-63C3-BB52-BF371CCDC111}"/>
                </a:ext>
              </a:extLst>
            </p:cNvPr>
            <p:cNvSpPr txBox="1"/>
            <p:nvPr/>
          </p:nvSpPr>
          <p:spPr>
            <a:xfrm>
              <a:off x="3754591" y="1655246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kD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3B31A29-91B7-9E0B-AE89-71E0E258581D}"/>
                </a:ext>
              </a:extLst>
            </p:cNvPr>
            <p:cNvSpPr txBox="1"/>
            <p:nvPr/>
          </p:nvSpPr>
          <p:spPr>
            <a:xfrm>
              <a:off x="2559981" y="698547"/>
              <a:ext cx="9116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740003D-AC25-ED2E-427A-66ED34CDAEBC}"/>
                </a:ext>
              </a:extLst>
            </p:cNvPr>
            <p:cNvSpPr txBox="1"/>
            <p:nvPr/>
          </p:nvSpPr>
          <p:spPr>
            <a:xfrm>
              <a:off x="2458937" y="305453"/>
              <a:ext cx="15295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700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hannel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C206B77-178E-EA69-780A-1496E46B723D}"/>
              </a:ext>
            </a:extLst>
          </p:cNvPr>
          <p:cNvGrpSpPr/>
          <p:nvPr/>
        </p:nvGrpSpPr>
        <p:grpSpPr>
          <a:xfrm>
            <a:off x="377017" y="305453"/>
            <a:ext cx="2152604" cy="2591864"/>
            <a:chOff x="176601" y="305453"/>
            <a:chExt cx="2152604" cy="2591864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D2DBDAB-27EB-BE42-BA97-7C9076CD3F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601" y="611317"/>
              <a:ext cx="1579084" cy="228600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1C9B9D4-BF91-B574-E367-98F8107D7AE6}"/>
                </a:ext>
              </a:extLst>
            </p:cNvPr>
            <p:cNvSpPr txBox="1"/>
            <p:nvPr/>
          </p:nvSpPr>
          <p:spPr>
            <a:xfrm>
              <a:off x="1536474" y="1067879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E69F1BF-19EA-4545-EC51-5132D65CCF89}"/>
                </a:ext>
              </a:extLst>
            </p:cNvPr>
            <p:cNvSpPr txBox="1"/>
            <p:nvPr/>
          </p:nvSpPr>
          <p:spPr>
            <a:xfrm>
              <a:off x="1536474" y="1364238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1D97030-66E0-B339-26DC-B1C52178A526}"/>
                </a:ext>
              </a:extLst>
            </p:cNvPr>
            <p:cNvSpPr txBox="1"/>
            <p:nvPr/>
          </p:nvSpPr>
          <p:spPr>
            <a:xfrm>
              <a:off x="1536474" y="1655246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kD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866597A-BFF0-5CD0-8B85-77113DBA011D}"/>
                </a:ext>
              </a:extLst>
            </p:cNvPr>
            <p:cNvSpPr txBox="1"/>
            <p:nvPr/>
          </p:nvSpPr>
          <p:spPr>
            <a:xfrm>
              <a:off x="319032" y="305453"/>
              <a:ext cx="15295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hannel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8C34FAF-C289-F712-A61E-4143AEAB7BE5}"/>
                </a:ext>
              </a:extLst>
            </p:cNvPr>
            <p:cNvSpPr txBox="1"/>
            <p:nvPr/>
          </p:nvSpPr>
          <p:spPr>
            <a:xfrm>
              <a:off x="249013" y="795683"/>
              <a:ext cx="9116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HES1</a:t>
              </a:r>
            </a:p>
          </p:txBody>
        </p:sp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id="{A3A5D266-D755-6458-B561-F38CC548666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681" y="3522797"/>
            <a:ext cx="4049662" cy="130791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7A6CE13E-3E73-31F7-1CAD-3FECA8894570}"/>
              </a:ext>
            </a:extLst>
          </p:cNvPr>
          <p:cNvSpPr txBox="1"/>
          <p:nvPr/>
        </p:nvSpPr>
        <p:spPr>
          <a:xfrm>
            <a:off x="1029134" y="3221948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MS-CTR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DE82FB3-564B-3A96-DD26-5ABDC508DE03}"/>
              </a:ext>
            </a:extLst>
          </p:cNvPr>
          <p:cNvSpPr txBox="1"/>
          <p:nvPr/>
        </p:nvSpPr>
        <p:spPr>
          <a:xfrm>
            <a:off x="2936543" y="3204591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h36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35153B8-28B0-C343-BC46-4D545388F1C1}"/>
              </a:ext>
            </a:extLst>
          </p:cNvPr>
          <p:cNvSpPr txBox="1"/>
          <p:nvPr/>
        </p:nvSpPr>
        <p:spPr>
          <a:xfrm rot="18404571">
            <a:off x="1091321" y="4845526"/>
            <a:ext cx="4084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F074DD3-7EED-EA9E-BC8C-422A23A78FF5}"/>
              </a:ext>
            </a:extLst>
          </p:cNvPr>
          <p:cNvSpPr txBox="1"/>
          <p:nvPr/>
        </p:nvSpPr>
        <p:spPr>
          <a:xfrm rot="18404571">
            <a:off x="1122234" y="4937214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50EE440-EDA3-4ACF-947B-BCD6E76B31BD}"/>
              </a:ext>
            </a:extLst>
          </p:cNvPr>
          <p:cNvSpPr txBox="1"/>
          <p:nvPr/>
        </p:nvSpPr>
        <p:spPr>
          <a:xfrm rot="18404571">
            <a:off x="1439955" y="4936597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1FEFFCC-ACF8-12DC-FBE0-5180D452BEAC}"/>
              </a:ext>
            </a:extLst>
          </p:cNvPr>
          <p:cNvSpPr txBox="1"/>
          <p:nvPr/>
        </p:nvSpPr>
        <p:spPr>
          <a:xfrm rot="18404571">
            <a:off x="2907990" y="4823663"/>
            <a:ext cx="4084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2972080-21F3-E880-6069-16CE4F0219FA}"/>
              </a:ext>
            </a:extLst>
          </p:cNvPr>
          <p:cNvSpPr txBox="1"/>
          <p:nvPr/>
        </p:nvSpPr>
        <p:spPr>
          <a:xfrm rot="18404571">
            <a:off x="2938903" y="4915351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CCD5E04-05C8-7252-8BA5-F20F95E1ED26}"/>
              </a:ext>
            </a:extLst>
          </p:cNvPr>
          <p:cNvSpPr txBox="1"/>
          <p:nvPr/>
        </p:nvSpPr>
        <p:spPr>
          <a:xfrm rot="18404571">
            <a:off x="3256624" y="4914734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3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49498CD3-F1CB-7443-239D-5A76D5B4A46F}"/>
              </a:ext>
            </a:extLst>
          </p:cNvPr>
          <p:cNvGrpSpPr/>
          <p:nvPr/>
        </p:nvGrpSpPr>
        <p:grpSpPr>
          <a:xfrm>
            <a:off x="350684" y="5975059"/>
            <a:ext cx="4095383" cy="3073411"/>
            <a:chOff x="100164" y="5619460"/>
            <a:chExt cx="4095383" cy="3073411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17BA4F1F-F8E5-92BE-12E1-D9D42B5C23C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164" y="5989247"/>
              <a:ext cx="4050792" cy="1974609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9FD1C19-F311-D293-0866-D1480CBDFB3E}"/>
                </a:ext>
              </a:extLst>
            </p:cNvPr>
            <p:cNvSpPr txBox="1"/>
            <p:nvPr/>
          </p:nvSpPr>
          <p:spPr>
            <a:xfrm>
              <a:off x="840338" y="5636817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SMS-CTR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C272549-4CAE-DF1D-756E-492A7C2EE939}"/>
                </a:ext>
              </a:extLst>
            </p:cNvPr>
            <p:cNvSpPr txBox="1"/>
            <p:nvPr/>
          </p:nvSpPr>
          <p:spPr>
            <a:xfrm>
              <a:off x="2747747" y="5619460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Rh36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ECC644A-6EAC-86C4-C010-C060A75CF07B}"/>
                </a:ext>
              </a:extLst>
            </p:cNvPr>
            <p:cNvSpPr txBox="1"/>
            <p:nvPr/>
          </p:nvSpPr>
          <p:spPr>
            <a:xfrm rot="18404571">
              <a:off x="598828" y="8042610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C5FADC8-872E-B81D-3593-6823D57E536E}"/>
                </a:ext>
              </a:extLst>
            </p:cNvPr>
            <p:cNvSpPr txBox="1"/>
            <p:nvPr/>
          </p:nvSpPr>
          <p:spPr>
            <a:xfrm rot="18404571">
              <a:off x="629741" y="8134298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343F6D0-CDD5-A6BE-A0C9-3DAB077A7299}"/>
                </a:ext>
              </a:extLst>
            </p:cNvPr>
            <p:cNvSpPr txBox="1"/>
            <p:nvPr/>
          </p:nvSpPr>
          <p:spPr>
            <a:xfrm rot="18404571">
              <a:off x="947462" y="8133681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D7159D2-5920-2A63-5F5A-8B0D7E011F13}"/>
                </a:ext>
              </a:extLst>
            </p:cNvPr>
            <p:cNvSpPr txBox="1"/>
            <p:nvPr/>
          </p:nvSpPr>
          <p:spPr>
            <a:xfrm rot="18404571">
              <a:off x="2415497" y="8020747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709C3ED-3E07-65E7-6135-BA8489AB22F9}"/>
                </a:ext>
              </a:extLst>
            </p:cNvPr>
            <p:cNvSpPr txBox="1"/>
            <p:nvPr/>
          </p:nvSpPr>
          <p:spPr>
            <a:xfrm rot="18404571">
              <a:off x="2446410" y="8112435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F74292C-2AE3-B599-53AC-7DE517C64DFD}"/>
                </a:ext>
              </a:extLst>
            </p:cNvPr>
            <p:cNvSpPr txBox="1"/>
            <p:nvPr/>
          </p:nvSpPr>
          <p:spPr>
            <a:xfrm rot="18404571">
              <a:off x="2764131" y="8111818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348789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EB1229D-DE97-6B51-6F52-4B6201CA417F}"/>
              </a:ext>
            </a:extLst>
          </p:cNvPr>
          <p:cNvSpPr txBox="1"/>
          <p:nvPr/>
        </p:nvSpPr>
        <p:spPr>
          <a:xfrm>
            <a:off x="541867" y="203200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DC5C607-2928-40A8-DA52-3884A6F7169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867" y="703448"/>
            <a:ext cx="2353339" cy="18288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4A4EABB-EFAD-35F5-0CE1-1F633C8C7ACC}"/>
              </a:ext>
            </a:extLst>
          </p:cNvPr>
          <p:cNvSpPr txBox="1"/>
          <p:nvPr/>
        </p:nvSpPr>
        <p:spPr>
          <a:xfrm rot="18404571">
            <a:off x="862135" y="2602923"/>
            <a:ext cx="4084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9C00CCA-0AAC-639E-C8FA-F9DFC6A02980}"/>
              </a:ext>
            </a:extLst>
          </p:cNvPr>
          <p:cNvSpPr txBox="1"/>
          <p:nvPr/>
        </p:nvSpPr>
        <p:spPr>
          <a:xfrm rot="18404571">
            <a:off x="969248" y="2694611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DE80017-1659-1B98-0269-15A6E1EB6E4A}"/>
              </a:ext>
            </a:extLst>
          </p:cNvPr>
          <p:cNvSpPr txBox="1"/>
          <p:nvPr/>
        </p:nvSpPr>
        <p:spPr>
          <a:xfrm rot="18404571">
            <a:off x="1375869" y="2693994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2148045-386F-4120-5E9F-92066BA24F8E}"/>
              </a:ext>
            </a:extLst>
          </p:cNvPr>
          <p:cNvSpPr txBox="1"/>
          <p:nvPr/>
        </p:nvSpPr>
        <p:spPr>
          <a:xfrm>
            <a:off x="287867" y="1199232"/>
            <a:ext cx="77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AP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B222587-1207-986D-CE15-3418413E3404}"/>
              </a:ext>
            </a:extLst>
          </p:cNvPr>
          <p:cNvSpPr txBox="1"/>
          <p:nvPr/>
        </p:nvSpPr>
        <p:spPr>
          <a:xfrm>
            <a:off x="891128" y="420850"/>
            <a:ext cx="152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an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3D31525-FC79-682D-5550-6ED1621E2DFF}"/>
              </a:ext>
            </a:extLst>
          </p:cNvPr>
          <p:cNvSpPr txBox="1"/>
          <p:nvPr/>
        </p:nvSpPr>
        <p:spPr>
          <a:xfrm>
            <a:off x="2259171" y="1344035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7FB2A0A6-152D-445E-DBEA-19E357864CF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9270" y="727220"/>
            <a:ext cx="1383230" cy="18288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BA8EECF-DF1B-469F-B99F-18B8FC310156}"/>
              </a:ext>
            </a:extLst>
          </p:cNvPr>
          <p:cNvSpPr txBox="1"/>
          <p:nvPr/>
        </p:nvSpPr>
        <p:spPr>
          <a:xfrm>
            <a:off x="3275507" y="403318"/>
            <a:ext cx="152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an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423A58A-F1E0-B2A5-9EC2-D6A542761B0A}"/>
              </a:ext>
            </a:extLst>
          </p:cNvPr>
          <p:cNvSpPr txBox="1"/>
          <p:nvPr/>
        </p:nvSpPr>
        <p:spPr>
          <a:xfrm>
            <a:off x="3300015" y="1266048"/>
            <a:ext cx="77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AP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5C5C99-4C47-5D7F-865F-7911870D539D}"/>
              </a:ext>
            </a:extLst>
          </p:cNvPr>
          <p:cNvSpPr txBox="1"/>
          <p:nvPr/>
        </p:nvSpPr>
        <p:spPr>
          <a:xfrm>
            <a:off x="3474117" y="1911034"/>
            <a:ext cx="77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5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F2C3CE3-734F-1E9E-8986-48EF6DE2B0C2}"/>
              </a:ext>
            </a:extLst>
          </p:cNvPr>
          <p:cNvSpPr txBox="1"/>
          <p:nvPr/>
        </p:nvSpPr>
        <p:spPr>
          <a:xfrm rot="18404571">
            <a:off x="3032646" y="2613644"/>
            <a:ext cx="4084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44FCDC0-9D59-6D62-D264-5941FAE9055A}"/>
              </a:ext>
            </a:extLst>
          </p:cNvPr>
          <p:cNvSpPr txBox="1"/>
          <p:nvPr/>
        </p:nvSpPr>
        <p:spPr>
          <a:xfrm rot="18404571">
            <a:off x="3139759" y="2705332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35C51DC-8764-67A3-8762-4D5FD24F6D67}"/>
              </a:ext>
            </a:extLst>
          </p:cNvPr>
          <p:cNvSpPr txBox="1"/>
          <p:nvPr/>
        </p:nvSpPr>
        <p:spPr>
          <a:xfrm rot="18404571">
            <a:off x="3546380" y="2704715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4BF3215-F779-0A3A-372E-DAFA207CF449}"/>
              </a:ext>
            </a:extLst>
          </p:cNvPr>
          <p:cNvSpPr txBox="1"/>
          <p:nvPr/>
        </p:nvSpPr>
        <p:spPr>
          <a:xfrm>
            <a:off x="4392095" y="1421985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DD7A36DC-2001-2A12-C472-384B82EB78DA}"/>
              </a:ext>
            </a:extLst>
          </p:cNvPr>
          <p:cNvGrpSpPr/>
          <p:nvPr/>
        </p:nvGrpSpPr>
        <p:grpSpPr>
          <a:xfrm>
            <a:off x="4964996" y="680159"/>
            <a:ext cx="2020763" cy="2481317"/>
            <a:chOff x="4677129" y="476959"/>
            <a:chExt cx="2020763" cy="2481317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4DB06070-8CB3-004F-86B7-9D0C70625DE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11207" y="476959"/>
              <a:ext cx="1298253" cy="182880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86766E0-2FF4-5210-DCB8-ACCEACAA5BCC}"/>
                </a:ext>
              </a:extLst>
            </p:cNvPr>
            <p:cNvSpPr txBox="1"/>
            <p:nvPr/>
          </p:nvSpPr>
          <p:spPr>
            <a:xfrm rot="18404571">
              <a:off x="4599874" y="2308015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53C8E02-0628-F5FA-FBAA-1EEF0E402C59}"/>
                </a:ext>
              </a:extLst>
            </p:cNvPr>
            <p:cNvSpPr txBox="1"/>
            <p:nvPr/>
          </p:nvSpPr>
          <p:spPr>
            <a:xfrm rot="18404571">
              <a:off x="4706987" y="2399703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11ADFCC-5442-E335-D005-60F4F206E709}"/>
                </a:ext>
              </a:extLst>
            </p:cNvPr>
            <p:cNvSpPr txBox="1"/>
            <p:nvPr/>
          </p:nvSpPr>
          <p:spPr>
            <a:xfrm rot="18404571">
              <a:off x="5113608" y="2399086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9B142EA-1B22-0C3E-8AC1-5D4A16D0F133}"/>
                </a:ext>
              </a:extLst>
            </p:cNvPr>
            <p:cNvSpPr txBox="1"/>
            <p:nvPr/>
          </p:nvSpPr>
          <p:spPr>
            <a:xfrm>
              <a:off x="4711207" y="1276846"/>
              <a:ext cx="9116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B112337-F6ED-0938-BE83-7A473924D594}"/>
                </a:ext>
              </a:extLst>
            </p:cNvPr>
            <p:cNvSpPr txBox="1"/>
            <p:nvPr/>
          </p:nvSpPr>
          <p:spPr>
            <a:xfrm>
              <a:off x="5905161" y="1153038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0kD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AA9B1A4-3D4E-C5D6-8F55-573929082928}"/>
                </a:ext>
              </a:extLst>
            </p:cNvPr>
            <p:cNvSpPr txBox="1"/>
            <p:nvPr/>
          </p:nvSpPr>
          <p:spPr>
            <a:xfrm>
              <a:off x="5905161" y="1577029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73C6EE8-7F95-BAED-7A62-44C51A2BFDA0}"/>
                </a:ext>
              </a:extLst>
            </p:cNvPr>
            <p:cNvSpPr txBox="1"/>
            <p:nvPr/>
          </p:nvSpPr>
          <p:spPr>
            <a:xfrm>
              <a:off x="5905161" y="1873388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3BC65675-19A1-096E-EE14-077FABCC4CB5}"/>
              </a:ext>
            </a:extLst>
          </p:cNvPr>
          <p:cNvSpPr txBox="1"/>
          <p:nvPr/>
        </p:nvSpPr>
        <p:spPr>
          <a:xfrm>
            <a:off x="5032396" y="385241"/>
            <a:ext cx="152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an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8B6E3479-673F-F7C6-2843-15F9F5921AC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5796" y="4306038"/>
            <a:ext cx="1755354" cy="18288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5616EEC2-4599-5322-BAE2-999AF27AFE6A}"/>
              </a:ext>
            </a:extLst>
          </p:cNvPr>
          <p:cNvSpPr txBox="1"/>
          <p:nvPr/>
        </p:nvSpPr>
        <p:spPr>
          <a:xfrm>
            <a:off x="545505" y="3833853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MS-CTR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2C6EF55-BB37-9C04-0641-334DC2592877}"/>
              </a:ext>
            </a:extLst>
          </p:cNvPr>
          <p:cNvSpPr txBox="1"/>
          <p:nvPr/>
        </p:nvSpPr>
        <p:spPr>
          <a:xfrm rot="18404571">
            <a:off x="3515862" y="6194320"/>
            <a:ext cx="4084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37AF349-2856-48D8-BFD2-ED92F25E8438}"/>
              </a:ext>
            </a:extLst>
          </p:cNvPr>
          <p:cNvSpPr txBox="1"/>
          <p:nvPr/>
        </p:nvSpPr>
        <p:spPr>
          <a:xfrm rot="18404571">
            <a:off x="3622975" y="6286008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0184458-6A85-F932-2E1A-EA29E2D5B11B}"/>
              </a:ext>
            </a:extLst>
          </p:cNvPr>
          <p:cNvSpPr txBox="1"/>
          <p:nvPr/>
        </p:nvSpPr>
        <p:spPr>
          <a:xfrm rot="18404571">
            <a:off x="4029596" y="6285391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E2B489C-CC5E-C5CA-C0DF-BDEEDE875138}"/>
              </a:ext>
            </a:extLst>
          </p:cNvPr>
          <p:cNvSpPr txBox="1"/>
          <p:nvPr/>
        </p:nvSpPr>
        <p:spPr>
          <a:xfrm>
            <a:off x="3065796" y="5436845"/>
            <a:ext cx="77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57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94A2E02E-D3EF-0E4D-7D62-DD366F4BA54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505" y="4306038"/>
            <a:ext cx="2244348" cy="1775648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273E4D9A-0B7A-C9EF-4894-F1628E4B3281}"/>
              </a:ext>
            </a:extLst>
          </p:cNvPr>
          <p:cNvSpPr txBox="1"/>
          <p:nvPr/>
        </p:nvSpPr>
        <p:spPr>
          <a:xfrm rot="18404571">
            <a:off x="1353888" y="6166697"/>
            <a:ext cx="4084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68D11D7-769D-A8B3-B735-EC6B15404555}"/>
              </a:ext>
            </a:extLst>
          </p:cNvPr>
          <p:cNvSpPr txBox="1"/>
          <p:nvPr/>
        </p:nvSpPr>
        <p:spPr>
          <a:xfrm rot="18404571">
            <a:off x="1461001" y="6258385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5F738D4-06E1-F6C5-73AA-29ECED18E2D3}"/>
              </a:ext>
            </a:extLst>
          </p:cNvPr>
          <p:cNvSpPr txBox="1"/>
          <p:nvPr/>
        </p:nvSpPr>
        <p:spPr>
          <a:xfrm rot="18404571">
            <a:off x="1867622" y="6257768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8AC49B0-BD9E-1E25-6DE2-0DE8752682C1}"/>
              </a:ext>
            </a:extLst>
          </p:cNvPr>
          <p:cNvSpPr txBox="1"/>
          <p:nvPr/>
        </p:nvSpPr>
        <p:spPr>
          <a:xfrm>
            <a:off x="1835423" y="5035772"/>
            <a:ext cx="77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AP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F0DC8E8-9F61-A81C-C0DA-8364DC6367E0}"/>
              </a:ext>
            </a:extLst>
          </p:cNvPr>
          <p:cNvSpPr txBox="1"/>
          <p:nvPr/>
        </p:nvSpPr>
        <p:spPr>
          <a:xfrm>
            <a:off x="4101273" y="4963312"/>
            <a:ext cx="77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AP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9037C37-B75B-4F87-4AA3-4FB678620C00}"/>
              </a:ext>
            </a:extLst>
          </p:cNvPr>
          <p:cNvSpPr txBox="1"/>
          <p:nvPr/>
        </p:nvSpPr>
        <p:spPr>
          <a:xfrm>
            <a:off x="894766" y="4310812"/>
            <a:ext cx="152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an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3F8324E-797B-0156-DCDE-9103D4C00015}"/>
              </a:ext>
            </a:extLst>
          </p:cNvPr>
          <p:cNvSpPr txBox="1"/>
          <p:nvPr/>
        </p:nvSpPr>
        <p:spPr>
          <a:xfrm>
            <a:off x="3199268" y="4271560"/>
            <a:ext cx="152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an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F30DDDB-956F-F01F-CC56-1A60F3BEA784}"/>
              </a:ext>
            </a:extLst>
          </p:cNvPr>
          <p:cNvSpPr txBox="1"/>
          <p:nvPr/>
        </p:nvSpPr>
        <p:spPr>
          <a:xfrm>
            <a:off x="380702" y="5124508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EFC810F-5D47-9907-05A7-983745DF1CF1}"/>
              </a:ext>
            </a:extLst>
          </p:cNvPr>
          <p:cNvSpPr txBox="1"/>
          <p:nvPr/>
        </p:nvSpPr>
        <p:spPr>
          <a:xfrm>
            <a:off x="2855745" y="4963312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38E6BED8-A108-1A5C-7210-9B531DDADD0D}"/>
              </a:ext>
            </a:extLst>
          </p:cNvPr>
          <p:cNvGrpSpPr/>
          <p:nvPr/>
        </p:nvGrpSpPr>
        <p:grpSpPr>
          <a:xfrm>
            <a:off x="5053813" y="4271560"/>
            <a:ext cx="2153579" cy="2469132"/>
            <a:chOff x="-23698" y="3014476"/>
            <a:chExt cx="2153579" cy="2469132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DA88499A-FBCE-F1C2-04F2-78A2EE38DAC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515" y="3014476"/>
              <a:ext cx="1395470" cy="1828800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9E042A8-77D3-2327-79F6-664B55A89FBF}"/>
                </a:ext>
              </a:extLst>
            </p:cNvPr>
            <p:cNvSpPr txBox="1"/>
            <p:nvPr/>
          </p:nvSpPr>
          <p:spPr>
            <a:xfrm rot="18404571">
              <a:off x="587799" y="4833347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87968E6-ECD7-3240-8654-222C4BD0E9A9}"/>
                </a:ext>
              </a:extLst>
            </p:cNvPr>
            <p:cNvSpPr txBox="1"/>
            <p:nvPr/>
          </p:nvSpPr>
          <p:spPr>
            <a:xfrm rot="18404571">
              <a:off x="618712" y="4925035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2DF4E89-B172-371E-2AA1-BC2C75F2835F}"/>
                </a:ext>
              </a:extLst>
            </p:cNvPr>
            <p:cNvSpPr txBox="1"/>
            <p:nvPr/>
          </p:nvSpPr>
          <p:spPr>
            <a:xfrm rot="18404571">
              <a:off x="936433" y="4924418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0CC6847-2E69-01A6-09EC-86C9B6E76050}"/>
                </a:ext>
              </a:extLst>
            </p:cNvPr>
            <p:cNvSpPr txBox="1"/>
            <p:nvPr/>
          </p:nvSpPr>
          <p:spPr>
            <a:xfrm>
              <a:off x="598274" y="3866832"/>
              <a:ext cx="11297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8FD7DFA-A163-A6F3-1C30-4D25CA3BFD65}"/>
                </a:ext>
              </a:extLst>
            </p:cNvPr>
            <p:cNvSpPr txBox="1"/>
            <p:nvPr/>
          </p:nvSpPr>
          <p:spPr>
            <a:xfrm>
              <a:off x="600307" y="3045897"/>
              <a:ext cx="15295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700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hannel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39F5132-65F1-CF7E-08B4-7A37569C6B4B}"/>
                </a:ext>
              </a:extLst>
            </p:cNvPr>
            <p:cNvSpPr txBox="1"/>
            <p:nvPr/>
          </p:nvSpPr>
          <p:spPr>
            <a:xfrm>
              <a:off x="3783" y="3665220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0kDa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F7D6709-FBAC-7835-1993-EC6905DF2D78}"/>
                </a:ext>
              </a:extLst>
            </p:cNvPr>
            <p:cNvSpPr txBox="1"/>
            <p:nvPr/>
          </p:nvSpPr>
          <p:spPr>
            <a:xfrm>
              <a:off x="3783" y="3999383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49E7E5D-CDEA-0F4F-84EA-0435AEEDFC7C}"/>
                </a:ext>
              </a:extLst>
            </p:cNvPr>
            <p:cNvSpPr txBox="1"/>
            <p:nvPr/>
          </p:nvSpPr>
          <p:spPr>
            <a:xfrm>
              <a:off x="-23698" y="4450094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48B1222C-A5C2-9736-8E27-FACA1B69BFC2}"/>
              </a:ext>
            </a:extLst>
          </p:cNvPr>
          <p:cNvSpPr txBox="1"/>
          <p:nvPr/>
        </p:nvSpPr>
        <p:spPr>
          <a:xfrm>
            <a:off x="154094" y="7179814"/>
            <a:ext cx="7772400" cy="33855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Fig S3. Full immunoblots corresponding to Figure 2A (top) and 2B (bottom).</a:t>
            </a:r>
          </a:p>
        </p:txBody>
      </p:sp>
    </p:spTree>
    <p:extLst>
      <p:ext uri="{BB962C8B-B14F-4D97-AF65-F5344CB8AC3E}">
        <p14:creationId xmlns:p14="http://schemas.microsoft.com/office/powerpoint/2010/main" val="22438288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 rot="16200000">
            <a:off x="301846" y="6161623"/>
            <a:ext cx="108824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SMS-CTR:</a:t>
            </a:r>
          </a:p>
          <a:p>
            <a:pPr algn="ctr"/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Growth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5380" y="5879108"/>
            <a:ext cx="1584960" cy="118872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8466" y="5879108"/>
            <a:ext cx="1584960" cy="118872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1552" y="5879108"/>
            <a:ext cx="1584960" cy="118872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544427" y="7616582"/>
            <a:ext cx="6645513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/>
              <a:t>Fig S4. HES1 knockdown inconsistently suppresses WWTR1 expression. HES1 suppression does not significantly induce differentiation of SMS-CTR cells under normal growth conditions.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64" r="17709" b="83121"/>
          <a:stretch/>
        </p:blipFill>
        <p:spPr>
          <a:xfrm>
            <a:off x="1947917" y="5658804"/>
            <a:ext cx="4281241" cy="280206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377785" y="5474138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3884743" y="2060589"/>
            <a:ext cx="1785204" cy="1162132"/>
            <a:chOff x="10174068" y="995119"/>
            <a:chExt cx="1785204" cy="1162132"/>
          </a:xfrm>
        </p:grpSpPr>
        <p:grpSp>
          <p:nvGrpSpPr>
            <p:cNvPr id="34" name="Group 33"/>
            <p:cNvGrpSpPr/>
            <p:nvPr/>
          </p:nvGrpSpPr>
          <p:grpSpPr>
            <a:xfrm>
              <a:off x="10174068" y="995119"/>
              <a:ext cx="1785204" cy="502580"/>
              <a:chOff x="10174068" y="995119"/>
              <a:chExt cx="1785204" cy="502580"/>
            </a:xfrm>
          </p:grpSpPr>
          <p:grpSp>
            <p:nvGrpSpPr>
              <p:cNvPr id="38" name="Group 37"/>
              <p:cNvGrpSpPr/>
              <p:nvPr/>
            </p:nvGrpSpPr>
            <p:grpSpPr>
              <a:xfrm>
                <a:off x="10174068" y="995119"/>
                <a:ext cx="831939" cy="500802"/>
                <a:chOff x="10372848" y="995119"/>
                <a:chExt cx="831939" cy="500802"/>
              </a:xfrm>
            </p:grpSpPr>
            <p:sp>
              <p:nvSpPr>
                <p:cNvPr id="41" name="TextBox 40"/>
                <p:cNvSpPr txBox="1"/>
                <p:nvPr/>
              </p:nvSpPr>
              <p:spPr>
                <a:xfrm>
                  <a:off x="10372848" y="995119"/>
                  <a:ext cx="83193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WTR1</a:t>
                  </a: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10486149" y="1249700"/>
                  <a:ext cx="59404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TB</a:t>
                  </a:r>
                </a:p>
              </p:txBody>
            </p:sp>
          </p:grpSp>
          <p:pic>
            <p:nvPicPr>
              <p:cNvPr id="39" name="Picture 38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962" t="61429" r="21730" b="28874"/>
              <a:stretch/>
            </p:blipFill>
            <p:spPr>
              <a:xfrm>
                <a:off x="10770552" y="1269099"/>
                <a:ext cx="1188720" cy="228600"/>
              </a:xfrm>
              <a:prstGeom prst="rect">
                <a:avLst/>
              </a:prstGeom>
            </p:spPr>
          </p:pic>
          <p:pic>
            <p:nvPicPr>
              <p:cNvPr id="40" name="Picture 39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169" t="50279" r="24871" b="40862"/>
              <a:stretch/>
            </p:blipFill>
            <p:spPr>
              <a:xfrm>
                <a:off x="10770552" y="1013968"/>
                <a:ext cx="1188720" cy="228600"/>
              </a:xfrm>
              <a:prstGeom prst="rect">
                <a:avLst/>
              </a:prstGeom>
            </p:spPr>
          </p:pic>
        </p:grpSp>
        <p:sp>
          <p:nvSpPr>
            <p:cNvPr id="35" name="TextBox 34"/>
            <p:cNvSpPr txBox="1"/>
            <p:nvPr/>
          </p:nvSpPr>
          <p:spPr>
            <a:xfrm rot="18404571">
              <a:off x="10736557" y="1510837"/>
              <a:ext cx="408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8404571">
              <a:off x="10843670" y="1602525"/>
              <a:ext cx="863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 rot="18404571">
              <a:off x="11250291" y="1601908"/>
              <a:ext cx="863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3771797" y="4169122"/>
            <a:ext cx="1778030" cy="1207567"/>
            <a:chOff x="10021571" y="4226592"/>
            <a:chExt cx="1778030" cy="1207567"/>
          </a:xfrm>
        </p:grpSpPr>
        <p:grpSp>
          <p:nvGrpSpPr>
            <p:cNvPr id="44" name="Group 43"/>
            <p:cNvGrpSpPr/>
            <p:nvPr/>
          </p:nvGrpSpPr>
          <p:grpSpPr>
            <a:xfrm>
              <a:off x="10021571" y="4226592"/>
              <a:ext cx="789068" cy="500802"/>
              <a:chOff x="10084998" y="5098289"/>
              <a:chExt cx="789068" cy="500802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10084998" y="5098289"/>
                <a:ext cx="7890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WTR1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10219905" y="5352870"/>
                <a:ext cx="5940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B</a:t>
                </a:r>
              </a:p>
            </p:txBody>
          </p:sp>
        </p:grpSp>
        <p:sp>
          <p:nvSpPr>
            <p:cNvPr id="45" name="TextBox 44"/>
            <p:cNvSpPr txBox="1"/>
            <p:nvPr/>
          </p:nvSpPr>
          <p:spPr>
            <a:xfrm rot="18404571">
              <a:off x="10731142" y="4787745"/>
              <a:ext cx="4084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 rot="18404571">
              <a:off x="10838255" y="4879433"/>
              <a:ext cx="863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 rot="18404571">
              <a:off x="11244876" y="4878816"/>
              <a:ext cx="863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1452246" y="3488601"/>
            <a:ext cx="2218407" cy="2081638"/>
            <a:chOff x="5409364" y="3453728"/>
            <a:chExt cx="2218407" cy="2081638"/>
          </a:xfrm>
        </p:grpSpPr>
        <p:grpSp>
          <p:nvGrpSpPr>
            <p:cNvPr id="54" name="Group 53"/>
            <p:cNvGrpSpPr/>
            <p:nvPr/>
          </p:nvGrpSpPr>
          <p:grpSpPr>
            <a:xfrm>
              <a:off x="5409364" y="3453728"/>
              <a:ext cx="2218407" cy="2081638"/>
              <a:chOff x="5409364" y="3453728"/>
              <a:chExt cx="2218407" cy="2081638"/>
            </a:xfrm>
          </p:grpSpPr>
          <p:pic>
            <p:nvPicPr>
              <p:cNvPr id="58" name="Picture 57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7302"/>
              <a:stretch/>
            </p:blipFill>
            <p:spPr>
              <a:xfrm>
                <a:off x="5579515" y="3619523"/>
                <a:ext cx="2048256" cy="1333093"/>
              </a:xfrm>
              <a:prstGeom prst="rect">
                <a:avLst/>
              </a:prstGeom>
            </p:spPr>
          </p:pic>
          <p:sp>
            <p:nvSpPr>
              <p:cNvPr id="59" name="TextBox 58"/>
              <p:cNvSpPr txBox="1"/>
              <p:nvPr/>
            </p:nvSpPr>
            <p:spPr>
              <a:xfrm>
                <a:off x="6522114" y="3453728"/>
                <a:ext cx="6737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WWTR1</a:t>
                </a:r>
                <a:endParaRPr lang="en-US" sz="105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rot="18404571">
                <a:off x="5971766" y="4888952"/>
                <a:ext cx="408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rot="18404571">
                <a:off x="6172491" y="4980640"/>
                <a:ext cx="8632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S1sh1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rot="18404571">
                <a:off x="6687714" y="4980023"/>
                <a:ext cx="8632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S1sh3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rot="16200000">
                <a:off x="4998476" y="4087035"/>
                <a:ext cx="1075691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6490493" y="4301154"/>
              <a:ext cx="982825" cy="372502"/>
              <a:chOff x="8275017" y="5386635"/>
              <a:chExt cx="982825" cy="372502"/>
            </a:xfrm>
          </p:grpSpPr>
          <p:sp>
            <p:nvSpPr>
              <p:cNvPr id="56" name="TextBox 55"/>
              <p:cNvSpPr txBox="1"/>
              <p:nvPr/>
            </p:nvSpPr>
            <p:spPr>
              <a:xfrm>
                <a:off x="8275017" y="5451360"/>
                <a:ext cx="88114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8791396" y="5386635"/>
                <a:ext cx="466446" cy="3063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</p:grpSp>
      <p:grpSp>
        <p:nvGrpSpPr>
          <p:cNvPr id="64" name="Group 63"/>
          <p:cNvGrpSpPr/>
          <p:nvPr/>
        </p:nvGrpSpPr>
        <p:grpSpPr>
          <a:xfrm>
            <a:off x="1449802" y="1286499"/>
            <a:ext cx="2222864" cy="2164779"/>
            <a:chOff x="5406920" y="1251626"/>
            <a:chExt cx="2222864" cy="2164779"/>
          </a:xfrm>
        </p:grpSpPr>
        <p:grpSp>
          <p:nvGrpSpPr>
            <p:cNvPr id="65" name="Group 64"/>
            <p:cNvGrpSpPr/>
            <p:nvPr/>
          </p:nvGrpSpPr>
          <p:grpSpPr>
            <a:xfrm>
              <a:off x="5406920" y="1251626"/>
              <a:ext cx="2222864" cy="1845689"/>
              <a:chOff x="5406920" y="1251626"/>
              <a:chExt cx="2222864" cy="1845689"/>
            </a:xfrm>
          </p:grpSpPr>
          <p:pic>
            <p:nvPicPr>
              <p:cNvPr id="68" name="Picture 67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7606"/>
              <a:stretch/>
            </p:blipFill>
            <p:spPr>
              <a:xfrm>
                <a:off x="5581528" y="1504128"/>
                <a:ext cx="2048256" cy="1328204"/>
              </a:xfrm>
              <a:prstGeom prst="rect">
                <a:avLst/>
              </a:prstGeom>
            </p:spPr>
          </p:pic>
          <p:grpSp>
            <p:nvGrpSpPr>
              <p:cNvPr id="69" name="Group 68"/>
              <p:cNvGrpSpPr/>
              <p:nvPr/>
            </p:nvGrpSpPr>
            <p:grpSpPr>
              <a:xfrm>
                <a:off x="6052781" y="2220260"/>
                <a:ext cx="1254388" cy="864574"/>
                <a:chOff x="4133618" y="2216745"/>
                <a:chExt cx="1254388" cy="864574"/>
              </a:xfrm>
            </p:grpSpPr>
            <p:sp>
              <p:nvSpPr>
                <p:cNvPr id="73" name="TextBox 72"/>
                <p:cNvSpPr txBox="1"/>
                <p:nvPr/>
              </p:nvSpPr>
              <p:spPr>
                <a:xfrm>
                  <a:off x="4634572" y="2216745"/>
                  <a:ext cx="39188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  <p:sp>
              <p:nvSpPr>
                <p:cNvPr id="74" name="Rectangle 73"/>
                <p:cNvSpPr/>
                <p:nvPr/>
              </p:nvSpPr>
              <p:spPr>
                <a:xfrm>
                  <a:off x="4133618" y="2770417"/>
                  <a:ext cx="1254388" cy="31090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70" name="TextBox 69"/>
              <p:cNvSpPr txBox="1"/>
              <p:nvPr/>
            </p:nvSpPr>
            <p:spPr>
              <a:xfrm>
                <a:off x="6478215" y="1251626"/>
                <a:ext cx="8225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WWTR1</a:t>
                </a:r>
                <a:endParaRPr lang="en-US" sz="105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 rot="18404571">
                <a:off x="5984944" y="2769991"/>
                <a:ext cx="4084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 rot="16200000">
                <a:off x="4996032" y="1941978"/>
                <a:ext cx="1075691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</a:p>
            </p:txBody>
          </p:sp>
        </p:grpSp>
        <p:sp>
          <p:nvSpPr>
            <p:cNvPr id="66" name="TextBox 65"/>
            <p:cNvSpPr txBox="1"/>
            <p:nvPr/>
          </p:nvSpPr>
          <p:spPr>
            <a:xfrm rot="18404571">
              <a:off x="6185669" y="2861679"/>
              <a:ext cx="863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 rot="18404571">
              <a:off x="6700892" y="2861062"/>
              <a:ext cx="863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</p:grpSp>
      <p:sp>
        <p:nvSpPr>
          <p:cNvPr id="75" name="TextBox 74"/>
          <p:cNvSpPr txBox="1"/>
          <p:nvPr/>
        </p:nvSpPr>
        <p:spPr>
          <a:xfrm rot="16200000">
            <a:off x="843968" y="1813901"/>
            <a:ext cx="593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</a:p>
        </p:txBody>
      </p:sp>
      <p:sp>
        <p:nvSpPr>
          <p:cNvPr id="76" name="TextBox 75"/>
          <p:cNvSpPr txBox="1"/>
          <p:nvPr/>
        </p:nvSpPr>
        <p:spPr>
          <a:xfrm rot="16200000">
            <a:off x="407945" y="3984456"/>
            <a:ext cx="14688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Arial" panose="020B0604020202020204" pitchFamily="34" charset="0"/>
                <a:cs typeface="Arial" panose="020B0604020202020204" pitchFamily="34" charset="0"/>
              </a:rPr>
              <a:t>SMS-CTR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378369" y="1324392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376747" y="3177419"/>
            <a:ext cx="233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1955C4B2-5889-6236-DC09-E0B9997F1A57}"/>
              </a:ext>
            </a:extLst>
          </p:cNvPr>
          <p:cNvCxnSpPr/>
          <p:nvPr/>
        </p:nvCxnSpPr>
        <p:spPr>
          <a:xfrm>
            <a:off x="5857502" y="7010384"/>
            <a:ext cx="237744" cy="0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2">
            <a:extLst>
              <a:ext uri="{FF2B5EF4-FFF2-40B4-BE49-F238E27FC236}">
                <a16:creationId xmlns:a16="http://schemas.microsoft.com/office/drawing/2014/main" id="{A0A3E0CE-E7BA-2026-58D9-54CB732620F2}"/>
              </a:ext>
            </a:extLst>
          </p:cNvPr>
          <p:cNvSpPr txBox="1"/>
          <p:nvPr/>
        </p:nvSpPr>
        <p:spPr>
          <a:xfrm>
            <a:off x="5823371" y="6943072"/>
            <a:ext cx="30600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300" dirty="0">
                <a:solidFill>
                  <a:schemeClr val="bg1"/>
                </a:solidFill>
              </a:rPr>
              <a:t>100</a:t>
            </a:r>
            <a:r>
              <a:rPr lang="en-US" sz="300" dirty="0">
                <a:solidFill>
                  <a:schemeClr val="bg1"/>
                </a:solidFill>
                <a:sym typeface="Symbol" pitchFamily="2" charset="2"/>
              </a:rPr>
              <a:t></a:t>
            </a:r>
            <a:r>
              <a:rPr lang="en-US" sz="300" dirty="0">
                <a:solidFill>
                  <a:schemeClr val="bg1"/>
                </a:solidFill>
              </a:rPr>
              <a:t>m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E1490271-4C24-C3EF-9AF9-0C4864195A93}"/>
              </a:ext>
            </a:extLst>
          </p:cNvPr>
          <p:cNvCxnSpPr>
            <a:cxnSpLocks/>
          </p:cNvCxnSpPr>
          <p:nvPr/>
        </p:nvCxnSpPr>
        <p:spPr>
          <a:xfrm>
            <a:off x="4221392" y="7015655"/>
            <a:ext cx="237744" cy="0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2">
            <a:extLst>
              <a:ext uri="{FF2B5EF4-FFF2-40B4-BE49-F238E27FC236}">
                <a16:creationId xmlns:a16="http://schemas.microsoft.com/office/drawing/2014/main" id="{4376C3AF-B250-C987-A757-9C2679507F5A}"/>
              </a:ext>
            </a:extLst>
          </p:cNvPr>
          <p:cNvSpPr txBox="1"/>
          <p:nvPr/>
        </p:nvSpPr>
        <p:spPr>
          <a:xfrm>
            <a:off x="4187269" y="6948343"/>
            <a:ext cx="30600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300" dirty="0">
                <a:solidFill>
                  <a:schemeClr val="bg1"/>
                </a:solidFill>
              </a:rPr>
              <a:t>100</a:t>
            </a:r>
            <a:r>
              <a:rPr lang="en-US" sz="300" dirty="0">
                <a:solidFill>
                  <a:schemeClr val="bg1"/>
                </a:solidFill>
                <a:sym typeface="Symbol" pitchFamily="2" charset="2"/>
              </a:rPr>
              <a:t></a:t>
            </a:r>
            <a:r>
              <a:rPr lang="en-US" sz="300" dirty="0">
                <a:solidFill>
                  <a:schemeClr val="bg1"/>
                </a:solidFill>
              </a:rPr>
              <a:t>m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681D504F-5808-A0AC-5FCB-5FFFF1971E68}"/>
              </a:ext>
            </a:extLst>
          </p:cNvPr>
          <p:cNvCxnSpPr>
            <a:cxnSpLocks/>
          </p:cNvCxnSpPr>
          <p:nvPr/>
        </p:nvCxnSpPr>
        <p:spPr>
          <a:xfrm>
            <a:off x="2585685" y="7010382"/>
            <a:ext cx="237744" cy="0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2">
            <a:extLst>
              <a:ext uri="{FF2B5EF4-FFF2-40B4-BE49-F238E27FC236}">
                <a16:creationId xmlns:a16="http://schemas.microsoft.com/office/drawing/2014/main" id="{25D7925A-A4E0-8CEB-22A5-096D6027DC70}"/>
              </a:ext>
            </a:extLst>
          </p:cNvPr>
          <p:cNvSpPr txBox="1"/>
          <p:nvPr/>
        </p:nvSpPr>
        <p:spPr>
          <a:xfrm>
            <a:off x="2551571" y="6943070"/>
            <a:ext cx="306006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300" dirty="0">
                <a:solidFill>
                  <a:schemeClr val="bg1"/>
                </a:solidFill>
              </a:rPr>
              <a:t>100</a:t>
            </a:r>
            <a:r>
              <a:rPr lang="en-US" sz="300" dirty="0">
                <a:solidFill>
                  <a:schemeClr val="bg1"/>
                </a:solidFill>
                <a:sym typeface="Symbol" pitchFamily="2" charset="2"/>
              </a:rPr>
              <a:t></a:t>
            </a:r>
            <a:r>
              <a:rPr lang="en-US" sz="300" dirty="0">
                <a:solidFill>
                  <a:schemeClr val="bg1"/>
                </a:solidFill>
              </a:rPr>
              <a:t>m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2585D276-9ED8-242D-B54D-E34F00FB1C59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17" t="46324" r="28582" b="42892"/>
          <a:stretch/>
        </p:blipFill>
        <p:spPr>
          <a:xfrm>
            <a:off x="4522896" y="4170153"/>
            <a:ext cx="1177741" cy="257891"/>
          </a:xfrm>
          <a:prstGeom prst="rect">
            <a:avLst/>
          </a:prstGeom>
        </p:spPr>
      </p:pic>
      <p:pic>
        <p:nvPicPr>
          <p:cNvPr id="5" name="Picture 4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1CDF0F93-BA39-6CBB-490A-612B44F2A620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89" t="58864" r="3618" b="32500"/>
          <a:stretch/>
        </p:blipFill>
        <p:spPr>
          <a:xfrm>
            <a:off x="4521101" y="4472007"/>
            <a:ext cx="1175390" cy="2002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2400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4A747C8-3022-4002-667E-1F242EB567DF}"/>
              </a:ext>
            </a:extLst>
          </p:cNvPr>
          <p:cNvSpPr txBox="1"/>
          <p:nvPr/>
        </p:nvSpPr>
        <p:spPr>
          <a:xfrm>
            <a:off x="608187" y="4724014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MS-CTR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F0BFE9B-6297-1439-69C9-27B7DE25EEA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689" y="5192482"/>
            <a:ext cx="1542361" cy="18288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5F23188-5A69-8A4E-519B-FE02C6E7D799}"/>
              </a:ext>
            </a:extLst>
          </p:cNvPr>
          <p:cNvSpPr txBox="1"/>
          <p:nvPr/>
        </p:nvSpPr>
        <p:spPr>
          <a:xfrm rot="18404571">
            <a:off x="772712" y="7058307"/>
            <a:ext cx="4084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4E9C12B-5C02-A24C-C7AD-7FCDE7540FFA}"/>
              </a:ext>
            </a:extLst>
          </p:cNvPr>
          <p:cNvSpPr txBox="1"/>
          <p:nvPr/>
        </p:nvSpPr>
        <p:spPr>
          <a:xfrm rot="18404571">
            <a:off x="803625" y="7149995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1852CA-ABF2-E596-A19E-6E70456F0151}"/>
              </a:ext>
            </a:extLst>
          </p:cNvPr>
          <p:cNvSpPr txBox="1"/>
          <p:nvPr/>
        </p:nvSpPr>
        <p:spPr>
          <a:xfrm rot="18404571">
            <a:off x="1121346" y="7149378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578384-0A47-B44F-CC61-2C35587E54CF}"/>
              </a:ext>
            </a:extLst>
          </p:cNvPr>
          <p:cNvSpPr txBox="1"/>
          <p:nvPr/>
        </p:nvSpPr>
        <p:spPr>
          <a:xfrm>
            <a:off x="1193023" y="6481167"/>
            <a:ext cx="1108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WTR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26FC9A8-82D6-6DCA-E980-607A2796DDA0}"/>
              </a:ext>
            </a:extLst>
          </p:cNvPr>
          <p:cNvSpPr txBox="1"/>
          <p:nvPr/>
        </p:nvSpPr>
        <p:spPr>
          <a:xfrm>
            <a:off x="815665" y="5058835"/>
            <a:ext cx="152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an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46114992-52B7-A195-7A9C-E9FFA03106E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647" y="5218851"/>
            <a:ext cx="1052723" cy="18288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C129BF8-C742-7F0A-78AA-B2F3BBAE0454}"/>
              </a:ext>
            </a:extLst>
          </p:cNvPr>
          <p:cNvSpPr txBox="1"/>
          <p:nvPr/>
        </p:nvSpPr>
        <p:spPr>
          <a:xfrm rot="18404571">
            <a:off x="2636411" y="7036382"/>
            <a:ext cx="4084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01BD6F-1EAF-F337-196A-2D08CD632BE0}"/>
              </a:ext>
            </a:extLst>
          </p:cNvPr>
          <p:cNvSpPr txBox="1"/>
          <p:nvPr/>
        </p:nvSpPr>
        <p:spPr>
          <a:xfrm rot="18404571">
            <a:off x="2667324" y="7128070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39A0979-8127-2BBB-ABD3-8816E2023DB8}"/>
              </a:ext>
            </a:extLst>
          </p:cNvPr>
          <p:cNvSpPr txBox="1"/>
          <p:nvPr/>
        </p:nvSpPr>
        <p:spPr>
          <a:xfrm rot="18404571">
            <a:off x="2985045" y="7127453"/>
            <a:ext cx="8632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ES1sh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2DAF94D-3B09-F28C-FA7E-6F5CB124D5CE}"/>
              </a:ext>
            </a:extLst>
          </p:cNvPr>
          <p:cNvSpPr txBox="1"/>
          <p:nvPr/>
        </p:nvSpPr>
        <p:spPr>
          <a:xfrm>
            <a:off x="2788033" y="6573405"/>
            <a:ext cx="9852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9BC6107-28F0-8F67-102F-986A0A19980F}"/>
              </a:ext>
            </a:extLst>
          </p:cNvPr>
          <p:cNvSpPr txBox="1"/>
          <p:nvPr/>
        </p:nvSpPr>
        <p:spPr>
          <a:xfrm>
            <a:off x="2648919" y="5248932"/>
            <a:ext cx="152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anne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E8DCFD1-E96E-9822-8250-E31EAAA784E5}"/>
              </a:ext>
            </a:extLst>
          </p:cNvPr>
          <p:cNvSpPr txBox="1"/>
          <p:nvPr/>
        </p:nvSpPr>
        <p:spPr>
          <a:xfrm>
            <a:off x="2172903" y="5700819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C5949A7-9594-C8ED-216A-EEF6461929B6}"/>
              </a:ext>
            </a:extLst>
          </p:cNvPr>
          <p:cNvSpPr txBox="1"/>
          <p:nvPr/>
        </p:nvSpPr>
        <p:spPr>
          <a:xfrm>
            <a:off x="2172903" y="6116870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65D2CF9-B0A3-24F5-63BA-830211C1FAB2}"/>
              </a:ext>
            </a:extLst>
          </p:cNvPr>
          <p:cNvSpPr txBox="1"/>
          <p:nvPr/>
        </p:nvSpPr>
        <p:spPr>
          <a:xfrm>
            <a:off x="2143613" y="6364894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7C348FC-1779-CA4F-D4E1-2513C962F0EF}"/>
              </a:ext>
            </a:extLst>
          </p:cNvPr>
          <p:cNvSpPr txBox="1"/>
          <p:nvPr/>
        </p:nvSpPr>
        <p:spPr>
          <a:xfrm>
            <a:off x="527325" y="5492793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D07921C1-D8E4-83EF-ADAA-C5952E43D0D1}"/>
              </a:ext>
            </a:extLst>
          </p:cNvPr>
          <p:cNvGrpSpPr/>
          <p:nvPr/>
        </p:nvGrpSpPr>
        <p:grpSpPr>
          <a:xfrm>
            <a:off x="2737616" y="1689327"/>
            <a:ext cx="2142976" cy="2817990"/>
            <a:chOff x="5420501" y="5447048"/>
            <a:chExt cx="2142976" cy="2817990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3920CF43-77F9-C340-6993-E2369C66456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20501" y="5764911"/>
              <a:ext cx="1456675" cy="1828800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5A7CC28-95C7-088F-6744-DE73086F3D65}"/>
                </a:ext>
              </a:extLst>
            </p:cNvPr>
            <p:cNvSpPr txBox="1"/>
            <p:nvPr/>
          </p:nvSpPr>
          <p:spPr>
            <a:xfrm>
              <a:off x="5693005" y="5905625"/>
              <a:ext cx="9116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0A467F2-FFAE-DA57-A3AE-5A13D40886A7}"/>
                </a:ext>
              </a:extLst>
            </p:cNvPr>
            <p:cNvSpPr txBox="1"/>
            <p:nvPr/>
          </p:nvSpPr>
          <p:spPr>
            <a:xfrm rot="18404571">
              <a:off x="5552631" y="7614777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D604589-E01E-515E-5F5E-2C7A3C8B5F01}"/>
                </a:ext>
              </a:extLst>
            </p:cNvPr>
            <p:cNvSpPr txBox="1"/>
            <p:nvPr/>
          </p:nvSpPr>
          <p:spPr>
            <a:xfrm rot="18404571">
              <a:off x="5536914" y="7706465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BC7E9C7-A544-71EF-BD59-6AC284B60020}"/>
                </a:ext>
              </a:extLst>
            </p:cNvPr>
            <p:cNvSpPr txBox="1"/>
            <p:nvPr/>
          </p:nvSpPr>
          <p:spPr>
            <a:xfrm rot="18404571">
              <a:off x="5888943" y="7705848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B7598D1-7BF5-EE53-5690-BBA42B26297B}"/>
                </a:ext>
              </a:extLst>
            </p:cNvPr>
            <p:cNvSpPr txBox="1"/>
            <p:nvPr/>
          </p:nvSpPr>
          <p:spPr>
            <a:xfrm>
              <a:off x="6770746" y="6704404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4E9FB7F-E41F-4F8D-991B-B5F0391E9EED}"/>
                </a:ext>
              </a:extLst>
            </p:cNvPr>
            <p:cNvSpPr txBox="1"/>
            <p:nvPr/>
          </p:nvSpPr>
          <p:spPr>
            <a:xfrm>
              <a:off x="6770746" y="7000763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93058C0-4759-588A-0635-3A7B9B48E221}"/>
                </a:ext>
              </a:extLst>
            </p:cNvPr>
            <p:cNvSpPr txBox="1"/>
            <p:nvPr/>
          </p:nvSpPr>
          <p:spPr>
            <a:xfrm>
              <a:off x="5420501" y="5447048"/>
              <a:ext cx="15295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700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hannel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419AA0BE-B34B-C4C9-D1BD-1CDAD37895EF}"/>
              </a:ext>
            </a:extLst>
          </p:cNvPr>
          <p:cNvGrpSpPr/>
          <p:nvPr/>
        </p:nvGrpSpPr>
        <p:grpSpPr>
          <a:xfrm>
            <a:off x="652413" y="1689327"/>
            <a:ext cx="1919075" cy="2765803"/>
            <a:chOff x="346590" y="5430267"/>
            <a:chExt cx="1919075" cy="2765803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9BDA79D8-EE27-7E57-2774-4B043918A1E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590" y="5703038"/>
              <a:ext cx="1532965" cy="182880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F0AB72C-E9E8-65E2-9CF9-92C680CC5F2A}"/>
                </a:ext>
              </a:extLst>
            </p:cNvPr>
            <p:cNvSpPr txBox="1"/>
            <p:nvPr/>
          </p:nvSpPr>
          <p:spPr>
            <a:xfrm>
              <a:off x="770891" y="7000763"/>
              <a:ext cx="11086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WWTR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1EE9848-9497-E3CB-B18A-C3B5A308AC89}"/>
                </a:ext>
              </a:extLst>
            </p:cNvPr>
            <p:cNvSpPr txBox="1"/>
            <p:nvPr/>
          </p:nvSpPr>
          <p:spPr>
            <a:xfrm>
              <a:off x="1472934" y="6090291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0kD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3EBB501-88DF-47DC-845C-852F26D92FA6}"/>
                </a:ext>
              </a:extLst>
            </p:cNvPr>
            <p:cNvSpPr txBox="1"/>
            <p:nvPr/>
          </p:nvSpPr>
          <p:spPr>
            <a:xfrm rot="18404571">
              <a:off x="493118" y="7545809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0798AE4-EADE-6375-6814-B07C9B4FCBA6}"/>
                </a:ext>
              </a:extLst>
            </p:cNvPr>
            <p:cNvSpPr txBox="1"/>
            <p:nvPr/>
          </p:nvSpPr>
          <p:spPr>
            <a:xfrm rot="18404571">
              <a:off x="477401" y="7637497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FDFF5DC-833E-B9AF-6A24-D63CF86CB955}"/>
                </a:ext>
              </a:extLst>
            </p:cNvPr>
            <p:cNvSpPr txBox="1"/>
            <p:nvPr/>
          </p:nvSpPr>
          <p:spPr>
            <a:xfrm rot="18404571">
              <a:off x="829430" y="7636880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3B9EA57-3C69-3F08-F4DF-51EA9B653690}"/>
                </a:ext>
              </a:extLst>
            </p:cNvPr>
            <p:cNvSpPr txBox="1"/>
            <p:nvPr/>
          </p:nvSpPr>
          <p:spPr>
            <a:xfrm>
              <a:off x="465641" y="5430267"/>
              <a:ext cx="15295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hannel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9CD1F104-91D1-B989-3C57-8A7985275518}"/>
              </a:ext>
            </a:extLst>
          </p:cNvPr>
          <p:cNvSpPr txBox="1"/>
          <p:nvPr/>
        </p:nvSpPr>
        <p:spPr>
          <a:xfrm>
            <a:off x="694995" y="1237162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BEE768D-0DF5-11B6-4208-9B9E0D4E4E91}"/>
              </a:ext>
            </a:extLst>
          </p:cNvPr>
          <p:cNvSpPr txBox="1"/>
          <p:nvPr/>
        </p:nvSpPr>
        <p:spPr>
          <a:xfrm>
            <a:off x="694995" y="8122017"/>
            <a:ext cx="6181794" cy="33855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Fig S5. Full immunoblots corresponding to Figure S4.</a:t>
            </a:r>
          </a:p>
        </p:txBody>
      </p:sp>
    </p:spTree>
    <p:extLst>
      <p:ext uri="{BB962C8B-B14F-4D97-AF65-F5344CB8AC3E}">
        <p14:creationId xmlns:p14="http://schemas.microsoft.com/office/powerpoint/2010/main" val="30401436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E88B667-89CD-D012-2EB9-7A3C35015829}"/>
              </a:ext>
            </a:extLst>
          </p:cNvPr>
          <p:cNvSpPr txBox="1"/>
          <p:nvPr/>
        </p:nvSpPr>
        <p:spPr>
          <a:xfrm>
            <a:off x="255321" y="8975456"/>
            <a:ext cx="6458630" cy="33855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Fig S6. Full immunoblots corresponding to Figure 3A,B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595E1AA-0765-2521-97EA-D33B7BE0BDC5}"/>
              </a:ext>
            </a:extLst>
          </p:cNvPr>
          <p:cNvGrpSpPr/>
          <p:nvPr/>
        </p:nvGrpSpPr>
        <p:grpSpPr>
          <a:xfrm>
            <a:off x="68613" y="5907465"/>
            <a:ext cx="2267437" cy="3043282"/>
            <a:chOff x="4874630" y="361638"/>
            <a:chExt cx="2267437" cy="304328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E25C89E-225D-4B60-974D-BE7EA537A0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10770" y="361638"/>
              <a:ext cx="1883976" cy="2337756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2F8C4D7-9934-0263-D580-6F85A4481D55}"/>
                </a:ext>
              </a:extLst>
            </p:cNvPr>
            <p:cNvSpPr txBox="1"/>
            <p:nvPr/>
          </p:nvSpPr>
          <p:spPr>
            <a:xfrm>
              <a:off x="5907318" y="1362945"/>
              <a:ext cx="12347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YOD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EF007B9-9FCA-249F-99E8-F25EA03BB0B1}"/>
                </a:ext>
              </a:extLst>
            </p:cNvPr>
            <p:cNvSpPr txBox="1"/>
            <p:nvPr/>
          </p:nvSpPr>
          <p:spPr>
            <a:xfrm rot="18404571">
              <a:off x="5612852" y="2754659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84A0E0A-0456-63B5-144F-7AE9012315A5}"/>
                </a:ext>
              </a:extLst>
            </p:cNvPr>
            <p:cNvSpPr txBox="1"/>
            <p:nvPr/>
          </p:nvSpPr>
          <p:spPr>
            <a:xfrm rot="18404571">
              <a:off x="5719965" y="2846347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E6C8FF5-F6EF-BCE5-D3D7-FAB4DDE3B7C3}"/>
                </a:ext>
              </a:extLst>
            </p:cNvPr>
            <p:cNvSpPr txBox="1"/>
            <p:nvPr/>
          </p:nvSpPr>
          <p:spPr>
            <a:xfrm rot="18404571">
              <a:off x="6126586" y="2845730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7F0497E-F165-FA24-264C-C22CEF3F8664}"/>
                </a:ext>
              </a:extLst>
            </p:cNvPr>
            <p:cNvSpPr txBox="1"/>
            <p:nvPr/>
          </p:nvSpPr>
          <p:spPr>
            <a:xfrm>
              <a:off x="4902111" y="1028309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0kD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6AA430A-907B-C9A7-C914-AE4BD5486D0E}"/>
                </a:ext>
              </a:extLst>
            </p:cNvPr>
            <p:cNvSpPr txBox="1"/>
            <p:nvPr/>
          </p:nvSpPr>
          <p:spPr>
            <a:xfrm>
              <a:off x="4902111" y="1444360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A000179-2AB1-EFBF-9A0D-959564A4131F}"/>
                </a:ext>
              </a:extLst>
            </p:cNvPr>
            <p:cNvSpPr txBox="1"/>
            <p:nvPr/>
          </p:nvSpPr>
          <p:spPr>
            <a:xfrm>
              <a:off x="4874630" y="1895071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41955B3-2156-FB9B-4157-6E241BE4D983}"/>
              </a:ext>
            </a:extLst>
          </p:cNvPr>
          <p:cNvGrpSpPr/>
          <p:nvPr/>
        </p:nvGrpSpPr>
        <p:grpSpPr>
          <a:xfrm>
            <a:off x="2188729" y="6223453"/>
            <a:ext cx="1751684" cy="2469132"/>
            <a:chOff x="-23698" y="3014476"/>
            <a:chExt cx="1751684" cy="2469132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95CC9D1-1AD9-F981-09E2-0608E9FF4AD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515" y="3014476"/>
              <a:ext cx="1395470" cy="182880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D81BB35-14ED-98CD-9839-442D9FC6C02E}"/>
                </a:ext>
              </a:extLst>
            </p:cNvPr>
            <p:cNvSpPr txBox="1"/>
            <p:nvPr/>
          </p:nvSpPr>
          <p:spPr>
            <a:xfrm rot="18404571">
              <a:off x="587799" y="4833347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7A02EDD-8CF9-097A-E94D-5963A0902C6C}"/>
                </a:ext>
              </a:extLst>
            </p:cNvPr>
            <p:cNvSpPr txBox="1"/>
            <p:nvPr/>
          </p:nvSpPr>
          <p:spPr>
            <a:xfrm rot="18404571">
              <a:off x="618712" y="4925035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BC1BF94-86AD-F2AA-08FE-D5AF5F8F6E34}"/>
                </a:ext>
              </a:extLst>
            </p:cNvPr>
            <p:cNvSpPr txBox="1"/>
            <p:nvPr/>
          </p:nvSpPr>
          <p:spPr>
            <a:xfrm rot="18404571">
              <a:off x="936433" y="4924418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2E1F58C-64A8-995A-13EC-623274845701}"/>
                </a:ext>
              </a:extLst>
            </p:cNvPr>
            <p:cNvSpPr txBox="1"/>
            <p:nvPr/>
          </p:nvSpPr>
          <p:spPr>
            <a:xfrm>
              <a:off x="598274" y="3866832"/>
              <a:ext cx="11297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AD6A4E0-E3C8-707D-CAAD-A981EA0D5CE2}"/>
                </a:ext>
              </a:extLst>
            </p:cNvPr>
            <p:cNvSpPr txBox="1"/>
            <p:nvPr/>
          </p:nvSpPr>
          <p:spPr>
            <a:xfrm>
              <a:off x="3783" y="3665220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0kD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1CB319A-D6F1-626F-B0B4-2E0C14120AD4}"/>
                </a:ext>
              </a:extLst>
            </p:cNvPr>
            <p:cNvSpPr txBox="1"/>
            <p:nvPr/>
          </p:nvSpPr>
          <p:spPr>
            <a:xfrm>
              <a:off x="3783" y="3999383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D488A7B-2CB9-4B61-1206-6052BC49E9C4}"/>
                </a:ext>
              </a:extLst>
            </p:cNvPr>
            <p:cNvSpPr txBox="1"/>
            <p:nvPr/>
          </p:nvSpPr>
          <p:spPr>
            <a:xfrm>
              <a:off x="-23698" y="4450094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F5E85DD7-7B7E-D074-254A-DAE05AD894FC}"/>
              </a:ext>
            </a:extLst>
          </p:cNvPr>
          <p:cNvGrpSpPr/>
          <p:nvPr/>
        </p:nvGrpSpPr>
        <p:grpSpPr>
          <a:xfrm>
            <a:off x="3238270" y="620415"/>
            <a:ext cx="2020763" cy="2481317"/>
            <a:chOff x="4677129" y="476959"/>
            <a:chExt cx="2020763" cy="2481317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2A669E4-7AAD-1B91-9322-6EC8BC25771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11207" y="476959"/>
              <a:ext cx="1298253" cy="182880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11EAE22-0065-A195-EE7F-AD3A8AFBBC48}"/>
                </a:ext>
              </a:extLst>
            </p:cNvPr>
            <p:cNvSpPr txBox="1"/>
            <p:nvPr/>
          </p:nvSpPr>
          <p:spPr>
            <a:xfrm rot="18404571">
              <a:off x="4599874" y="2308015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10BACE0-BEB4-CC6A-9169-98D82D491F6C}"/>
                </a:ext>
              </a:extLst>
            </p:cNvPr>
            <p:cNvSpPr txBox="1"/>
            <p:nvPr/>
          </p:nvSpPr>
          <p:spPr>
            <a:xfrm rot="18404571">
              <a:off x="4706987" y="2399703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EFEF8E6-8602-A067-BDF7-5035FFA9ADD8}"/>
                </a:ext>
              </a:extLst>
            </p:cNvPr>
            <p:cNvSpPr txBox="1"/>
            <p:nvPr/>
          </p:nvSpPr>
          <p:spPr>
            <a:xfrm rot="18404571">
              <a:off x="5113608" y="2399086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9DC33CE-4677-898A-004D-C2EC3C29872C}"/>
                </a:ext>
              </a:extLst>
            </p:cNvPr>
            <p:cNvSpPr txBox="1"/>
            <p:nvPr/>
          </p:nvSpPr>
          <p:spPr>
            <a:xfrm>
              <a:off x="4711207" y="1276846"/>
              <a:ext cx="9116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E6CD9B6-5CC4-FBF6-F8F8-7A55013F0095}"/>
                </a:ext>
              </a:extLst>
            </p:cNvPr>
            <p:cNvSpPr txBox="1"/>
            <p:nvPr/>
          </p:nvSpPr>
          <p:spPr>
            <a:xfrm>
              <a:off x="5905161" y="1153038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0kDa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F34BD25-1FA4-2C8B-561C-31D297C4750D}"/>
                </a:ext>
              </a:extLst>
            </p:cNvPr>
            <p:cNvSpPr txBox="1"/>
            <p:nvPr/>
          </p:nvSpPr>
          <p:spPr>
            <a:xfrm>
              <a:off x="5905161" y="1577029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F004825-F882-9F54-1C4E-B4AF96AAF3BC}"/>
                </a:ext>
              </a:extLst>
            </p:cNvPr>
            <p:cNvSpPr txBox="1"/>
            <p:nvPr/>
          </p:nvSpPr>
          <p:spPr>
            <a:xfrm>
              <a:off x="5905161" y="1873388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C6D8EA38-A3C6-A992-A9C4-E54F2C17C3F8}"/>
              </a:ext>
            </a:extLst>
          </p:cNvPr>
          <p:cNvGrpSpPr/>
          <p:nvPr/>
        </p:nvGrpSpPr>
        <p:grpSpPr>
          <a:xfrm>
            <a:off x="335071" y="715631"/>
            <a:ext cx="3065646" cy="2254956"/>
            <a:chOff x="196441" y="3139154"/>
            <a:chExt cx="3065646" cy="2254956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E376CA47-4BD1-9906-AA24-6CC2C7F7768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441" y="3139154"/>
              <a:ext cx="2634378" cy="1600200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EAA4784-095F-309E-0E74-FB7B0364626F}"/>
                </a:ext>
              </a:extLst>
            </p:cNvPr>
            <p:cNvSpPr txBox="1"/>
            <p:nvPr/>
          </p:nvSpPr>
          <p:spPr>
            <a:xfrm>
              <a:off x="308755" y="3207047"/>
              <a:ext cx="10287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YOD1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B63CB70-101F-C499-836B-570961D9235C}"/>
                </a:ext>
              </a:extLst>
            </p:cNvPr>
            <p:cNvSpPr txBox="1"/>
            <p:nvPr/>
          </p:nvSpPr>
          <p:spPr>
            <a:xfrm>
              <a:off x="2430276" y="3292439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E398839-84C4-E27D-EB1E-FB33B96DED42}"/>
                </a:ext>
              </a:extLst>
            </p:cNvPr>
            <p:cNvSpPr txBox="1"/>
            <p:nvPr/>
          </p:nvSpPr>
          <p:spPr>
            <a:xfrm>
              <a:off x="2469356" y="3972033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8E6A729-CB7F-3710-A5C5-A538B298F998}"/>
                </a:ext>
              </a:extLst>
            </p:cNvPr>
            <p:cNvSpPr txBox="1"/>
            <p:nvPr/>
          </p:nvSpPr>
          <p:spPr>
            <a:xfrm rot="18404571">
              <a:off x="416972" y="4743849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E5AF9E1-9DFA-5157-425A-05061F9752E5}"/>
                </a:ext>
              </a:extLst>
            </p:cNvPr>
            <p:cNvSpPr txBox="1"/>
            <p:nvPr/>
          </p:nvSpPr>
          <p:spPr>
            <a:xfrm rot="18404571">
              <a:off x="524085" y="4835537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611CCB2-1F30-88F6-7051-603410ACCBAD}"/>
                </a:ext>
              </a:extLst>
            </p:cNvPr>
            <p:cNvSpPr txBox="1"/>
            <p:nvPr/>
          </p:nvSpPr>
          <p:spPr>
            <a:xfrm rot="18404571">
              <a:off x="1203662" y="4834920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B31095E4-C1D5-1E12-B058-B1AFFE7C4637}"/>
              </a:ext>
            </a:extLst>
          </p:cNvPr>
          <p:cNvGrpSpPr/>
          <p:nvPr/>
        </p:nvGrpSpPr>
        <p:grpSpPr>
          <a:xfrm>
            <a:off x="1990172" y="3187936"/>
            <a:ext cx="2180652" cy="2057400"/>
            <a:chOff x="6491565" y="3003914"/>
            <a:chExt cx="2180652" cy="2057400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2C5635B3-6687-861A-0364-B1FD7648DCB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91565" y="3003914"/>
              <a:ext cx="1583675" cy="2057400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5F61D04-8281-BF26-655A-186F3F1EB30A}"/>
                </a:ext>
              </a:extLst>
            </p:cNvPr>
            <p:cNvSpPr txBox="1"/>
            <p:nvPr/>
          </p:nvSpPr>
          <p:spPr>
            <a:xfrm>
              <a:off x="6662874" y="3287573"/>
              <a:ext cx="9116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E93A0EA-ABF8-169B-DDE1-8DB570944338}"/>
                </a:ext>
              </a:extLst>
            </p:cNvPr>
            <p:cNvSpPr txBox="1"/>
            <p:nvPr/>
          </p:nvSpPr>
          <p:spPr>
            <a:xfrm>
              <a:off x="6704226" y="4293174"/>
              <a:ext cx="9116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YOG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0805E17-03A2-3AC8-3E64-E59868E31E83}"/>
                </a:ext>
              </a:extLst>
            </p:cNvPr>
            <p:cNvSpPr txBox="1"/>
            <p:nvPr/>
          </p:nvSpPr>
          <p:spPr>
            <a:xfrm>
              <a:off x="7850183" y="3557211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717863C8-5D96-FF25-376F-9248C1E67F46}"/>
                </a:ext>
              </a:extLst>
            </p:cNvPr>
            <p:cNvSpPr txBox="1"/>
            <p:nvPr/>
          </p:nvSpPr>
          <p:spPr>
            <a:xfrm>
              <a:off x="7850183" y="3853570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32C6911-01B7-6DFF-CBB2-C1E07719AA84}"/>
                </a:ext>
              </a:extLst>
            </p:cNvPr>
            <p:cNvSpPr txBox="1"/>
            <p:nvPr/>
          </p:nvSpPr>
          <p:spPr>
            <a:xfrm>
              <a:off x="7879486" y="3283029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0kDa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652EACE7-C747-297C-411A-710F22C53EAD}"/>
              </a:ext>
            </a:extLst>
          </p:cNvPr>
          <p:cNvGrpSpPr/>
          <p:nvPr/>
        </p:nvGrpSpPr>
        <p:grpSpPr>
          <a:xfrm>
            <a:off x="330514" y="3187936"/>
            <a:ext cx="1995117" cy="2057400"/>
            <a:chOff x="4831907" y="3003914"/>
            <a:chExt cx="1995117" cy="2057400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60892BE3-7BB7-6ADD-8EB4-5174D79381A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51905" y="3003914"/>
              <a:ext cx="1411024" cy="2057400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6216750-8682-1197-65AD-47FB8BE1AA5A}"/>
                </a:ext>
              </a:extLst>
            </p:cNvPr>
            <p:cNvSpPr txBox="1"/>
            <p:nvPr/>
          </p:nvSpPr>
          <p:spPr>
            <a:xfrm>
              <a:off x="4831907" y="3112011"/>
              <a:ext cx="9116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2743B9E-6AB9-DEA1-BE81-437C482F75D4}"/>
                </a:ext>
              </a:extLst>
            </p:cNvPr>
            <p:cNvSpPr txBox="1"/>
            <p:nvPr/>
          </p:nvSpPr>
          <p:spPr>
            <a:xfrm>
              <a:off x="5986489" y="3129231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0kDa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A4A6CD0-09D8-4C70-C8A2-04FDDC7A928E}"/>
                </a:ext>
              </a:extLst>
            </p:cNvPr>
            <p:cNvSpPr txBox="1"/>
            <p:nvPr/>
          </p:nvSpPr>
          <p:spPr>
            <a:xfrm>
              <a:off x="6034293" y="4032614"/>
              <a:ext cx="7927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kDa</a:t>
              </a: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9FF64386-3EA8-561E-94A4-0A8530FEE0E2}"/>
              </a:ext>
            </a:extLst>
          </p:cNvPr>
          <p:cNvGrpSpPr/>
          <p:nvPr/>
        </p:nvGrpSpPr>
        <p:grpSpPr>
          <a:xfrm>
            <a:off x="6036051" y="6320456"/>
            <a:ext cx="1345671" cy="2458669"/>
            <a:chOff x="4488579" y="7168300"/>
            <a:chExt cx="1345671" cy="2458669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2448DA76-725B-BFB0-9C47-F32BEC4594A6}"/>
                </a:ext>
              </a:extLst>
            </p:cNvPr>
            <p:cNvSpPr txBox="1"/>
            <p:nvPr/>
          </p:nvSpPr>
          <p:spPr>
            <a:xfrm rot="18404571">
              <a:off x="4525344" y="8976708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BAC92D8-D889-5EA5-5C6C-05C6C632B820}"/>
                </a:ext>
              </a:extLst>
            </p:cNvPr>
            <p:cNvSpPr txBox="1"/>
            <p:nvPr/>
          </p:nvSpPr>
          <p:spPr>
            <a:xfrm rot="18404571">
              <a:off x="4556257" y="9068396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43D1CFA-BA25-3F14-B7B4-CB62C4D8CFFC}"/>
                </a:ext>
              </a:extLst>
            </p:cNvPr>
            <p:cNvSpPr txBox="1"/>
            <p:nvPr/>
          </p:nvSpPr>
          <p:spPr>
            <a:xfrm rot="18404571">
              <a:off x="4873978" y="9067779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B645527F-8901-F820-E7CE-5FB959F44FE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88579" y="7168300"/>
              <a:ext cx="1345671" cy="1735721"/>
            </a:xfrm>
            <a:prstGeom prst="rect">
              <a:avLst/>
            </a:prstGeom>
          </p:spPr>
        </p:pic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4F441944-01A9-B54B-5643-864FC83F1F4C}"/>
              </a:ext>
            </a:extLst>
          </p:cNvPr>
          <p:cNvGrpSpPr/>
          <p:nvPr/>
        </p:nvGrpSpPr>
        <p:grpSpPr>
          <a:xfrm>
            <a:off x="4464586" y="6353863"/>
            <a:ext cx="1315676" cy="2435679"/>
            <a:chOff x="5983249" y="7159938"/>
            <a:chExt cx="1315676" cy="2435679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1F72DB6-09BA-CC25-AF4D-2B20E1EF904B}"/>
                </a:ext>
              </a:extLst>
            </p:cNvPr>
            <p:cNvSpPr txBox="1"/>
            <p:nvPr/>
          </p:nvSpPr>
          <p:spPr>
            <a:xfrm rot="18404571">
              <a:off x="6012933" y="8945356"/>
              <a:ext cx="40842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5BDE64C-F4B8-02F0-FABC-E30669CA6829}"/>
                </a:ext>
              </a:extLst>
            </p:cNvPr>
            <p:cNvSpPr txBox="1"/>
            <p:nvPr/>
          </p:nvSpPr>
          <p:spPr>
            <a:xfrm rot="18404571">
              <a:off x="6043846" y="9037044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1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994F29E6-C747-434A-963C-079B1D30667F}"/>
                </a:ext>
              </a:extLst>
            </p:cNvPr>
            <p:cNvSpPr txBox="1"/>
            <p:nvPr/>
          </p:nvSpPr>
          <p:spPr>
            <a:xfrm rot="18404571">
              <a:off x="6361567" y="9036427"/>
              <a:ext cx="86323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HES1sh3</a:t>
              </a:r>
            </a:p>
          </p:txBody>
        </p:sp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C296C407-1FB0-C35F-8E28-3222A827066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83249" y="7159938"/>
              <a:ext cx="1315676" cy="1697031"/>
            </a:xfrm>
            <a:prstGeom prst="rect">
              <a:avLst/>
            </a:prstGeom>
          </p:spPr>
        </p:pic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FA9DA629-F9BF-BD02-E70F-E69832653C2A}"/>
              </a:ext>
            </a:extLst>
          </p:cNvPr>
          <p:cNvSpPr txBox="1"/>
          <p:nvPr/>
        </p:nvSpPr>
        <p:spPr>
          <a:xfrm>
            <a:off x="4401684" y="6466414"/>
            <a:ext cx="911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F956A28-DF8A-C165-E699-F6851933F913}"/>
              </a:ext>
            </a:extLst>
          </p:cNvPr>
          <p:cNvSpPr txBox="1"/>
          <p:nvPr/>
        </p:nvSpPr>
        <p:spPr>
          <a:xfrm>
            <a:off x="5966289" y="6574136"/>
            <a:ext cx="911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0F77763-FB7F-C4D4-A5C5-95B6F289502F}"/>
              </a:ext>
            </a:extLst>
          </p:cNvPr>
          <p:cNvSpPr txBox="1"/>
          <p:nvPr/>
        </p:nvSpPr>
        <p:spPr>
          <a:xfrm>
            <a:off x="6027437" y="7471430"/>
            <a:ext cx="911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YOG</a:t>
            </a:r>
          </a:p>
        </p:txBody>
      </p:sp>
      <p:sp>
        <p:nvSpPr>
          <p:cNvPr id="71" name="Left Arrow 70">
            <a:extLst>
              <a:ext uri="{FF2B5EF4-FFF2-40B4-BE49-F238E27FC236}">
                <a16:creationId xmlns:a16="http://schemas.microsoft.com/office/drawing/2014/main" id="{936068B8-24E3-DCC6-D4EC-F86285A4D71E}"/>
              </a:ext>
            </a:extLst>
          </p:cNvPr>
          <p:cNvSpPr/>
          <p:nvPr/>
        </p:nvSpPr>
        <p:spPr>
          <a:xfrm rot="10800000">
            <a:off x="5814831" y="7075809"/>
            <a:ext cx="238006" cy="157112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6E85D2E-F5E4-1ABF-520E-DB0FD51E4F55}"/>
              </a:ext>
            </a:extLst>
          </p:cNvPr>
          <p:cNvSpPr txBox="1"/>
          <p:nvPr/>
        </p:nvSpPr>
        <p:spPr>
          <a:xfrm>
            <a:off x="5344706" y="6422641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7640B01-9F60-25C3-4DC2-BCBDFF64C187}"/>
              </a:ext>
            </a:extLst>
          </p:cNvPr>
          <p:cNvSpPr txBox="1"/>
          <p:nvPr/>
        </p:nvSpPr>
        <p:spPr>
          <a:xfrm>
            <a:off x="5367015" y="7400021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93947D8-E7B9-ACAC-D547-FF3F3AC567FD}"/>
              </a:ext>
            </a:extLst>
          </p:cNvPr>
          <p:cNvSpPr txBox="1"/>
          <p:nvPr/>
        </p:nvSpPr>
        <p:spPr>
          <a:xfrm>
            <a:off x="7242794" y="6777967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5391A98-0D41-A8BA-D203-B78D7673A4A3}"/>
              </a:ext>
            </a:extLst>
          </p:cNvPr>
          <p:cNvSpPr txBox="1"/>
          <p:nvPr/>
        </p:nvSpPr>
        <p:spPr>
          <a:xfrm>
            <a:off x="7259580" y="6998865"/>
            <a:ext cx="792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DA52741-4249-BE6D-C088-FF33E61005A1}"/>
              </a:ext>
            </a:extLst>
          </p:cNvPr>
          <p:cNvSpPr txBox="1"/>
          <p:nvPr/>
        </p:nvSpPr>
        <p:spPr>
          <a:xfrm>
            <a:off x="461760" y="257173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</a:p>
        </p:txBody>
      </p:sp>
    </p:spTree>
    <p:extLst>
      <p:ext uri="{BB962C8B-B14F-4D97-AF65-F5344CB8AC3E}">
        <p14:creationId xmlns:p14="http://schemas.microsoft.com/office/powerpoint/2010/main" val="12840142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39799" y="8142668"/>
            <a:ext cx="648751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/>
              <a:t>Fig S7. </a:t>
            </a:r>
            <a:r>
              <a:rPr lang="en-US" b="1" i="1" dirty="0"/>
              <a:t>In vitro </a:t>
            </a:r>
            <a:r>
              <a:rPr lang="en-US" b="1" dirty="0"/>
              <a:t>validation of doxycycline inducible HES1shRNA.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270467" y="443568"/>
            <a:ext cx="6599565" cy="3345701"/>
            <a:chOff x="496700" y="170612"/>
            <a:chExt cx="6599565" cy="3345701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338" r="31194" b="21497"/>
            <a:stretch/>
          </p:blipFill>
          <p:spPr>
            <a:xfrm>
              <a:off x="941008" y="2151538"/>
              <a:ext cx="1547162" cy="1351127"/>
            </a:xfrm>
            <a:prstGeom prst="rect">
              <a:avLst/>
            </a:prstGeom>
          </p:spPr>
        </p:pic>
        <p:grpSp>
          <p:nvGrpSpPr>
            <p:cNvPr id="8" name="Group 7"/>
            <p:cNvGrpSpPr/>
            <p:nvPr/>
          </p:nvGrpSpPr>
          <p:grpSpPr>
            <a:xfrm>
              <a:off x="926528" y="409433"/>
              <a:ext cx="1608020" cy="1351128"/>
              <a:chOff x="4022153" y="758683"/>
              <a:chExt cx="1608020" cy="1351128"/>
            </a:xfrm>
          </p:grpSpPr>
          <p:pic>
            <p:nvPicPr>
              <p:cNvPr id="25" name="Picture 2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134" r="29480" b="20702"/>
              <a:stretch/>
            </p:blipFill>
            <p:spPr>
              <a:xfrm>
                <a:off x="4022153" y="758683"/>
                <a:ext cx="1585705" cy="1351128"/>
              </a:xfrm>
              <a:prstGeom prst="rect">
                <a:avLst/>
              </a:prstGeom>
            </p:spPr>
          </p:pic>
          <p:sp>
            <p:nvSpPr>
              <p:cNvPr id="27" name="TextBox 26"/>
              <p:cNvSpPr txBox="1"/>
              <p:nvPr/>
            </p:nvSpPr>
            <p:spPr>
              <a:xfrm>
                <a:off x="5139848" y="1623728"/>
                <a:ext cx="49032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3216659" y="368490"/>
              <a:ext cx="1992055" cy="1364776"/>
              <a:chOff x="7693409" y="733615"/>
              <a:chExt cx="1992055" cy="1364776"/>
            </a:xfrm>
          </p:grpSpPr>
          <p:pic>
            <p:nvPicPr>
              <p:cNvPr id="22" name="Picture 21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888" r="29664" b="21269"/>
              <a:stretch/>
            </p:blipFill>
            <p:spPr>
              <a:xfrm>
                <a:off x="7693409" y="733615"/>
                <a:ext cx="1581574" cy="1364776"/>
              </a:xfrm>
              <a:prstGeom prst="rect">
                <a:avLst/>
              </a:prstGeom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8804315" y="1471117"/>
                <a:ext cx="88114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338" r="29914" b="20140"/>
            <a:stretch/>
          </p:blipFill>
          <p:spPr>
            <a:xfrm>
              <a:off x="5520324" y="354842"/>
              <a:ext cx="1575941" cy="1378423"/>
            </a:xfrm>
            <a:prstGeom prst="rect">
              <a:avLst/>
            </a:prstGeom>
          </p:spPr>
        </p:pic>
        <p:grpSp>
          <p:nvGrpSpPr>
            <p:cNvPr id="11" name="Group 10"/>
            <p:cNvGrpSpPr/>
            <p:nvPr/>
          </p:nvGrpSpPr>
          <p:grpSpPr>
            <a:xfrm>
              <a:off x="3211091" y="2151538"/>
              <a:ext cx="1977550" cy="1364775"/>
              <a:chOff x="1290216" y="5802788"/>
              <a:chExt cx="1977550" cy="1364775"/>
            </a:xfrm>
          </p:grpSpPr>
          <p:pic>
            <p:nvPicPr>
              <p:cNvPr id="18" name="Picture 17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338" r="30281" b="20819"/>
              <a:stretch/>
            </p:blipFill>
            <p:spPr>
              <a:xfrm>
                <a:off x="1290216" y="5802788"/>
                <a:ext cx="1551047" cy="1364775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2386617" y="5870331"/>
                <a:ext cx="8811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 rot="16200000">
              <a:off x="323645" y="1721978"/>
              <a:ext cx="7154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RD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744881" y="227110"/>
              <a:ext cx="7074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ES1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147112" y="170612"/>
              <a:ext cx="74141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KN1C</a:t>
              </a:r>
              <a:endParaRPr 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007446" y="170612"/>
              <a:ext cx="74141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YAP1</a:t>
              </a:r>
              <a:endParaRPr 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594372" y="1984744"/>
              <a:ext cx="74141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YOD1</a:t>
              </a:r>
              <a:endParaRPr 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835590" y="1984743"/>
              <a:ext cx="74141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YOG</a:t>
              </a:r>
              <a:endParaRPr 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 rot="16200000">
            <a:off x="267044" y="1190051"/>
            <a:ext cx="1052380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2550078" y="1190051"/>
            <a:ext cx="1052380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30" name="TextBox 29"/>
          <p:cNvSpPr txBox="1"/>
          <p:nvPr/>
        </p:nvSpPr>
        <p:spPr>
          <a:xfrm rot="16200000">
            <a:off x="272023" y="2936553"/>
            <a:ext cx="1052380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2551628" y="2942965"/>
            <a:ext cx="1052380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32" name="TextBox 31"/>
          <p:cNvSpPr txBox="1"/>
          <p:nvPr/>
        </p:nvSpPr>
        <p:spPr>
          <a:xfrm rot="16200000">
            <a:off x="4852315" y="1154268"/>
            <a:ext cx="1052380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45044" y="438511"/>
            <a:ext cx="1196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686052" y="4413275"/>
            <a:ext cx="504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833760" y="2527020"/>
            <a:ext cx="881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1501" y="5167477"/>
            <a:ext cx="4937760" cy="269748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61B7DBD-2429-16AF-C9B3-794305787B69}"/>
              </a:ext>
            </a:extLst>
          </p:cNvPr>
          <p:cNvSpPr txBox="1"/>
          <p:nvPr/>
        </p:nvSpPr>
        <p:spPr>
          <a:xfrm>
            <a:off x="1078682" y="1996361"/>
            <a:ext cx="1662967" cy="25391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50" dirty="0" err="1">
                <a:latin typeface="Arial"/>
                <a:cs typeface="Calibri"/>
              </a:rPr>
              <a:t>shNTtet</a:t>
            </a:r>
            <a:r>
              <a:rPr lang="en-US" sz="1050" dirty="0">
                <a:latin typeface="Arial"/>
                <a:cs typeface="Calibri"/>
              </a:rPr>
              <a:t>  HES1shte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E07C4AA-A682-EA41-045D-9431212A7ABC}"/>
              </a:ext>
            </a:extLst>
          </p:cNvPr>
          <p:cNvSpPr txBox="1"/>
          <p:nvPr/>
        </p:nvSpPr>
        <p:spPr>
          <a:xfrm>
            <a:off x="3356913" y="1996360"/>
            <a:ext cx="1662967" cy="25391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50" dirty="0" err="1">
                <a:latin typeface="Arial"/>
                <a:cs typeface="Calibri"/>
              </a:rPr>
              <a:t>shNTtet</a:t>
            </a:r>
            <a:r>
              <a:rPr lang="en-US" sz="1050" dirty="0">
                <a:latin typeface="Arial"/>
                <a:cs typeface="Calibri"/>
              </a:rPr>
              <a:t>  HES1shte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21D09AB-94CE-F817-AD74-0631138DD7DF}"/>
              </a:ext>
            </a:extLst>
          </p:cNvPr>
          <p:cNvSpPr txBox="1"/>
          <p:nvPr/>
        </p:nvSpPr>
        <p:spPr>
          <a:xfrm>
            <a:off x="5675411" y="1996360"/>
            <a:ext cx="1662967" cy="25391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50" dirty="0" err="1">
                <a:latin typeface="Arial"/>
                <a:cs typeface="Calibri"/>
              </a:rPr>
              <a:t>shNTtet</a:t>
            </a:r>
            <a:r>
              <a:rPr lang="en-US" sz="1050" dirty="0">
                <a:latin typeface="Arial"/>
                <a:cs typeface="Calibri"/>
              </a:rPr>
              <a:t>  HES1shte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FF3E56F-E74D-B098-A465-003E1E1F59AD}"/>
              </a:ext>
            </a:extLst>
          </p:cNvPr>
          <p:cNvSpPr txBox="1"/>
          <p:nvPr/>
        </p:nvSpPr>
        <p:spPr>
          <a:xfrm>
            <a:off x="1090923" y="3786861"/>
            <a:ext cx="1662967" cy="25391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50" dirty="0" err="1">
                <a:latin typeface="Arial"/>
                <a:cs typeface="Calibri"/>
              </a:rPr>
              <a:t>shNTtet</a:t>
            </a:r>
            <a:r>
              <a:rPr lang="en-US" sz="1050" dirty="0">
                <a:latin typeface="Arial"/>
                <a:cs typeface="Calibri"/>
              </a:rPr>
              <a:t>  HES1shte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172E8DB-275C-CBED-8085-76C96C4D56AF}"/>
              </a:ext>
            </a:extLst>
          </p:cNvPr>
          <p:cNvSpPr txBox="1"/>
          <p:nvPr/>
        </p:nvSpPr>
        <p:spPr>
          <a:xfrm>
            <a:off x="3330339" y="3786861"/>
            <a:ext cx="1662967" cy="25391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50" dirty="0" err="1">
                <a:latin typeface="Arial"/>
                <a:cs typeface="Calibri"/>
              </a:rPr>
              <a:t>shNTtet</a:t>
            </a:r>
            <a:r>
              <a:rPr lang="en-US" sz="1050" dirty="0">
                <a:latin typeface="Arial"/>
                <a:cs typeface="Calibri"/>
              </a:rPr>
              <a:t>  HES1shtet</a:t>
            </a:r>
          </a:p>
        </p:txBody>
      </p:sp>
    </p:spTree>
    <p:extLst>
      <p:ext uri="{BB962C8B-B14F-4D97-AF65-F5344CB8AC3E}">
        <p14:creationId xmlns:p14="http://schemas.microsoft.com/office/powerpoint/2010/main" val="39119203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31644" y="1253713"/>
            <a:ext cx="4456256" cy="1644555"/>
            <a:chOff x="433244" y="434559"/>
            <a:chExt cx="6063333" cy="246371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131" t="21815" r="11111" b="33215"/>
            <a:stretch/>
          </p:blipFill>
          <p:spPr>
            <a:xfrm rot="16200000">
              <a:off x="2317578" y="-1280730"/>
              <a:ext cx="2371865" cy="5986133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33244" y="434559"/>
              <a:ext cx="1618726" cy="5071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crose</a:t>
              </a:r>
              <a:endPara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63975" y="2071429"/>
              <a:ext cx="1816269" cy="5071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xycycline</a:t>
              </a:r>
              <a:endPara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510443" y="3922542"/>
            <a:ext cx="7028416" cy="1867581"/>
            <a:chOff x="242385" y="742614"/>
            <a:chExt cx="7028416" cy="1867581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48" t="18696" r="11980" b="54606"/>
            <a:stretch/>
          </p:blipFill>
          <p:spPr>
            <a:xfrm>
              <a:off x="242385" y="742614"/>
              <a:ext cx="7020657" cy="1867581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6452405" y="757698"/>
              <a:ext cx="8106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460164" y="1597611"/>
              <a:ext cx="8106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I130</a:t>
              </a:r>
              <a:endPara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89054" y="331894"/>
            <a:ext cx="452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5136" y="3472933"/>
            <a:ext cx="452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70468" y="8830692"/>
            <a:ext cx="7274170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/>
              <a:t>Fig S8. Tumor xenograft resections and changes in mouse weight during </a:t>
            </a:r>
            <a:r>
              <a:rPr lang="en-US" b="1" i="1" dirty="0"/>
              <a:t>in vivo </a:t>
            </a:r>
            <a:r>
              <a:rPr lang="en-US" b="1" dirty="0"/>
              <a:t>genetic and pharmacologic HES1 inhibition.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973"/>
          <a:stretch/>
        </p:blipFill>
        <p:spPr>
          <a:xfrm>
            <a:off x="4882737" y="944354"/>
            <a:ext cx="2800763" cy="2307016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4787900" y="327975"/>
            <a:ext cx="452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392" t="40635" b="37345"/>
          <a:stretch/>
        </p:blipFill>
        <p:spPr>
          <a:xfrm>
            <a:off x="6934200" y="1761066"/>
            <a:ext cx="749300" cy="508000"/>
          </a:xfrm>
          <a:prstGeom prst="rect">
            <a:avLst/>
          </a:prstGeom>
        </p:spPr>
      </p:pic>
      <p:grpSp>
        <p:nvGrpSpPr>
          <p:cNvPr id="18" name="Group 17"/>
          <p:cNvGrpSpPr>
            <a:grpSpLocks noChangeAspect="1"/>
          </p:cNvGrpSpPr>
          <p:nvPr/>
        </p:nvGrpSpPr>
        <p:grpSpPr>
          <a:xfrm>
            <a:off x="4882737" y="6723437"/>
            <a:ext cx="1647262" cy="1828800"/>
            <a:chOff x="446311" y="357977"/>
            <a:chExt cx="1844381" cy="2047643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865"/>
            <a:stretch/>
          </p:blipFill>
          <p:spPr>
            <a:xfrm>
              <a:off x="446311" y="357977"/>
              <a:ext cx="1844381" cy="2047643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1734138" y="539657"/>
              <a:ext cx="32419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89054" y="6211362"/>
            <a:ext cx="452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656297" y="6211362"/>
            <a:ext cx="452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554"/>
          <a:stretch/>
        </p:blipFill>
        <p:spPr>
          <a:xfrm>
            <a:off x="897886" y="5965167"/>
            <a:ext cx="3643920" cy="269748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866" b="62924"/>
          <a:stretch/>
        </p:blipFill>
        <p:spPr>
          <a:xfrm>
            <a:off x="3242663" y="5884957"/>
            <a:ext cx="935270" cy="10001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5926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636</TotalTime>
  <Words>1015</Words>
  <Application>Microsoft Office PowerPoint</Application>
  <PresentationFormat>Custom</PresentationFormat>
  <Paragraphs>398</Paragraphs>
  <Slides>1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0" baseType="lpstr">
      <vt:lpstr>Arial</vt:lpstr>
      <vt:lpstr>Calibri</vt:lpstr>
      <vt:lpstr>Calibri Light</vt:lpstr>
      <vt:lpstr>Symbol</vt:lpstr>
      <vt:lpstr>Office Theme</vt:lpstr>
      <vt:lpstr>Acrobat 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uke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 Kovach</dc:creator>
  <cp:lastModifiedBy>Corinne Linardic, M.D.</cp:lastModifiedBy>
  <cp:revision>183</cp:revision>
  <cp:lastPrinted>2021-10-20T17:30:44Z</cp:lastPrinted>
  <dcterms:created xsi:type="dcterms:W3CDTF">2021-06-25T20:49:07Z</dcterms:created>
  <dcterms:modified xsi:type="dcterms:W3CDTF">2022-07-15T20:02:48Z</dcterms:modified>
</cp:coreProperties>
</file>